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5759450" cy="3600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00" d="100"/>
          <a:sy n="200" d="100"/>
        </p:scale>
        <p:origin x="121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19931" y="589241"/>
            <a:ext cx="4319588" cy="1253490"/>
          </a:xfrm>
        </p:spPr>
        <p:txBody>
          <a:bodyPr anchor="b"/>
          <a:lstStyle>
            <a:lvl1pPr algn="ctr">
              <a:defRPr sz="283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1891070"/>
            <a:ext cx="4319588" cy="869275"/>
          </a:xfrm>
        </p:spPr>
        <p:txBody>
          <a:bodyPr/>
          <a:lstStyle>
            <a:lvl1pPr marL="0" indent="0" algn="ctr">
              <a:buNone/>
              <a:defRPr sz="1134"/>
            </a:lvl1pPr>
            <a:lvl2pPr marL="215981" indent="0" algn="ctr">
              <a:buNone/>
              <a:defRPr sz="945"/>
            </a:lvl2pPr>
            <a:lvl3pPr marL="431963" indent="0" algn="ctr">
              <a:buNone/>
              <a:defRPr sz="850"/>
            </a:lvl3pPr>
            <a:lvl4pPr marL="647944" indent="0" algn="ctr">
              <a:buNone/>
              <a:defRPr sz="756"/>
            </a:lvl4pPr>
            <a:lvl5pPr marL="863925" indent="0" algn="ctr">
              <a:buNone/>
              <a:defRPr sz="756"/>
            </a:lvl5pPr>
            <a:lvl6pPr marL="1079906" indent="0" algn="ctr">
              <a:buNone/>
              <a:defRPr sz="756"/>
            </a:lvl6pPr>
            <a:lvl7pPr marL="1295888" indent="0" algn="ctr">
              <a:buNone/>
              <a:defRPr sz="756"/>
            </a:lvl7pPr>
            <a:lvl8pPr marL="1511869" indent="0" algn="ctr">
              <a:buNone/>
              <a:defRPr sz="756"/>
            </a:lvl8pPr>
            <a:lvl9pPr marL="1727850" indent="0" algn="ctr">
              <a:buNone/>
              <a:defRPr sz="75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1340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2645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191691"/>
            <a:ext cx="1241881" cy="30512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2" y="191691"/>
            <a:ext cx="3653651" cy="30512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6040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1590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2" y="897613"/>
            <a:ext cx="4967526" cy="1497687"/>
          </a:xfrm>
        </p:spPr>
        <p:txBody>
          <a:bodyPr anchor="b"/>
          <a:lstStyle>
            <a:lvl1pPr>
              <a:defRPr sz="283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2" y="2409468"/>
            <a:ext cx="4967526" cy="787598"/>
          </a:xfrm>
        </p:spPr>
        <p:txBody>
          <a:bodyPr/>
          <a:lstStyle>
            <a:lvl1pPr marL="0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1pPr>
            <a:lvl2pPr marL="215981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2pPr>
            <a:lvl3pPr marL="431963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3pPr>
            <a:lvl4pPr marL="647944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4pPr>
            <a:lvl5pPr marL="863925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5pPr>
            <a:lvl6pPr marL="1079906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6pPr>
            <a:lvl7pPr marL="1295888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7pPr>
            <a:lvl8pPr marL="1511869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8pPr>
            <a:lvl9pPr marL="1727850" indent="0">
              <a:buNone/>
              <a:defRPr sz="75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8915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958453"/>
            <a:ext cx="2447766" cy="22844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958453"/>
            <a:ext cx="2447766" cy="228445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7942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191691"/>
            <a:ext cx="4967526" cy="69592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882610"/>
            <a:ext cx="2436517" cy="432554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1315164"/>
            <a:ext cx="2436517" cy="19344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882610"/>
            <a:ext cx="2448516" cy="432554"/>
          </a:xfrm>
        </p:spPr>
        <p:txBody>
          <a:bodyPr anchor="b"/>
          <a:lstStyle>
            <a:lvl1pPr marL="0" indent="0">
              <a:buNone/>
              <a:defRPr sz="1134" b="1"/>
            </a:lvl1pPr>
            <a:lvl2pPr marL="215981" indent="0">
              <a:buNone/>
              <a:defRPr sz="945" b="1"/>
            </a:lvl2pPr>
            <a:lvl3pPr marL="431963" indent="0">
              <a:buNone/>
              <a:defRPr sz="850" b="1"/>
            </a:lvl3pPr>
            <a:lvl4pPr marL="647944" indent="0">
              <a:buNone/>
              <a:defRPr sz="756" b="1"/>
            </a:lvl4pPr>
            <a:lvl5pPr marL="863925" indent="0">
              <a:buNone/>
              <a:defRPr sz="756" b="1"/>
            </a:lvl5pPr>
            <a:lvl6pPr marL="1079906" indent="0">
              <a:buNone/>
              <a:defRPr sz="756" b="1"/>
            </a:lvl6pPr>
            <a:lvl7pPr marL="1295888" indent="0">
              <a:buNone/>
              <a:defRPr sz="756" b="1"/>
            </a:lvl7pPr>
            <a:lvl8pPr marL="1511869" indent="0">
              <a:buNone/>
              <a:defRPr sz="756" b="1"/>
            </a:lvl8pPr>
            <a:lvl9pPr marL="1727850" indent="0">
              <a:buNone/>
              <a:defRPr sz="75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1315164"/>
            <a:ext cx="2448516" cy="19344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7990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5065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4677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3" y="240030"/>
            <a:ext cx="1857572" cy="840105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518398"/>
            <a:ext cx="2915722" cy="2558653"/>
          </a:xfrm>
        </p:spPr>
        <p:txBody>
          <a:bodyPr/>
          <a:lstStyle>
            <a:lvl1pPr>
              <a:defRPr sz="1512"/>
            </a:lvl1pPr>
            <a:lvl2pPr>
              <a:defRPr sz="1323"/>
            </a:lvl2pPr>
            <a:lvl3pPr>
              <a:defRPr sz="1134"/>
            </a:lvl3pPr>
            <a:lvl4pPr>
              <a:defRPr sz="945"/>
            </a:lvl4pPr>
            <a:lvl5pPr>
              <a:defRPr sz="945"/>
            </a:lvl5pPr>
            <a:lvl6pPr>
              <a:defRPr sz="945"/>
            </a:lvl6pPr>
            <a:lvl7pPr>
              <a:defRPr sz="945"/>
            </a:lvl7pPr>
            <a:lvl8pPr>
              <a:defRPr sz="945"/>
            </a:lvl8pPr>
            <a:lvl9pPr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3" y="1080135"/>
            <a:ext cx="1857572" cy="2001084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614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3" y="240030"/>
            <a:ext cx="1857572" cy="840105"/>
          </a:xfrm>
        </p:spPr>
        <p:txBody>
          <a:bodyPr anchor="b"/>
          <a:lstStyle>
            <a:lvl1pPr>
              <a:defRPr sz="15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518398"/>
            <a:ext cx="2915722" cy="2558653"/>
          </a:xfrm>
        </p:spPr>
        <p:txBody>
          <a:bodyPr anchor="t"/>
          <a:lstStyle>
            <a:lvl1pPr marL="0" indent="0">
              <a:buNone/>
              <a:defRPr sz="1512"/>
            </a:lvl1pPr>
            <a:lvl2pPr marL="215981" indent="0">
              <a:buNone/>
              <a:defRPr sz="1323"/>
            </a:lvl2pPr>
            <a:lvl3pPr marL="431963" indent="0">
              <a:buNone/>
              <a:defRPr sz="1134"/>
            </a:lvl3pPr>
            <a:lvl4pPr marL="647944" indent="0">
              <a:buNone/>
              <a:defRPr sz="945"/>
            </a:lvl4pPr>
            <a:lvl5pPr marL="863925" indent="0">
              <a:buNone/>
              <a:defRPr sz="945"/>
            </a:lvl5pPr>
            <a:lvl6pPr marL="1079906" indent="0">
              <a:buNone/>
              <a:defRPr sz="945"/>
            </a:lvl6pPr>
            <a:lvl7pPr marL="1295888" indent="0">
              <a:buNone/>
              <a:defRPr sz="945"/>
            </a:lvl7pPr>
            <a:lvl8pPr marL="1511869" indent="0">
              <a:buNone/>
              <a:defRPr sz="945"/>
            </a:lvl8pPr>
            <a:lvl9pPr marL="1727850" indent="0">
              <a:buNone/>
              <a:defRPr sz="94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3" y="1080135"/>
            <a:ext cx="1857572" cy="2001084"/>
          </a:xfrm>
        </p:spPr>
        <p:txBody>
          <a:bodyPr/>
          <a:lstStyle>
            <a:lvl1pPr marL="0" indent="0">
              <a:buNone/>
              <a:defRPr sz="756"/>
            </a:lvl1pPr>
            <a:lvl2pPr marL="215981" indent="0">
              <a:buNone/>
              <a:defRPr sz="661"/>
            </a:lvl2pPr>
            <a:lvl3pPr marL="431963" indent="0">
              <a:buNone/>
              <a:defRPr sz="567"/>
            </a:lvl3pPr>
            <a:lvl4pPr marL="647944" indent="0">
              <a:buNone/>
              <a:defRPr sz="472"/>
            </a:lvl4pPr>
            <a:lvl5pPr marL="863925" indent="0">
              <a:buNone/>
              <a:defRPr sz="472"/>
            </a:lvl5pPr>
            <a:lvl6pPr marL="1079906" indent="0">
              <a:buNone/>
              <a:defRPr sz="472"/>
            </a:lvl6pPr>
            <a:lvl7pPr marL="1295888" indent="0">
              <a:buNone/>
              <a:defRPr sz="472"/>
            </a:lvl7pPr>
            <a:lvl8pPr marL="1511869" indent="0">
              <a:buNone/>
              <a:defRPr sz="472"/>
            </a:lvl8pPr>
            <a:lvl9pPr marL="1727850" indent="0">
              <a:buNone/>
              <a:defRPr sz="47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7155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191691"/>
            <a:ext cx="4967526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958453"/>
            <a:ext cx="4967526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3337084"/>
            <a:ext cx="1295876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3D0F03-134D-419C-85DA-52EA026AACE6}" type="datetimeFigureOut">
              <a:rPr lang="zh-CN" altLang="en-US" smtClean="0"/>
              <a:t>2023/12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3337084"/>
            <a:ext cx="1943814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3337084"/>
            <a:ext cx="1295876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13F4A6-B3E5-4209-976B-14EC9B7D1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02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31963" rtl="0" eaLnBrk="1" latinLnBrk="0" hangingPunct="1">
        <a:lnSpc>
          <a:spcPct val="90000"/>
        </a:lnSpc>
        <a:spcBef>
          <a:spcPct val="0"/>
        </a:spcBef>
        <a:buNone/>
        <a:defRPr sz="20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1" indent="-107991" algn="l" defTabSz="431963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23972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39953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55934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971916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187897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403878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619860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835841" indent="-107991" algn="l" defTabSz="431963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1pPr>
      <a:lvl2pPr marL="215981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2pPr>
      <a:lvl3pPr marL="431963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3pPr>
      <a:lvl4pPr marL="647944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863925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079906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295888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511869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727850" algn="l" defTabSz="431963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2">
            <a:extLst>
              <a:ext uri="{FF2B5EF4-FFF2-40B4-BE49-F238E27FC236}">
                <a16:creationId xmlns:a16="http://schemas.microsoft.com/office/drawing/2014/main" id="{2F8651A2-E033-4E5C-A91D-64B050B51FB1}"/>
              </a:ext>
            </a:extLst>
          </p:cNvPr>
          <p:cNvSpPr txBox="1"/>
          <p:nvPr/>
        </p:nvSpPr>
        <p:spPr>
          <a:xfrm>
            <a:off x="1379470" y="1862233"/>
            <a:ext cx="1179556" cy="181140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1125" spc="-3" dirty="0">
                <a:latin typeface="Arial"/>
                <a:cs typeface="Arial"/>
              </a:rPr>
              <a:t>log</a:t>
            </a:r>
            <a:r>
              <a:rPr sz="1125" spc="-19" dirty="0">
                <a:latin typeface="Arial"/>
                <a:cs typeface="Arial"/>
              </a:rPr>
              <a:t> </a:t>
            </a:r>
            <a:r>
              <a:rPr sz="1125" dirty="0">
                <a:latin typeface="Arial"/>
                <a:cs typeface="Arial"/>
              </a:rPr>
              <a:t>rank</a:t>
            </a:r>
            <a:r>
              <a:rPr sz="1125" spc="-13" dirty="0">
                <a:latin typeface="Arial"/>
                <a:cs typeface="Arial"/>
              </a:rPr>
              <a:t> </a:t>
            </a:r>
            <a:r>
              <a:rPr sz="1125" i="1" dirty="0">
                <a:latin typeface="Arial"/>
                <a:cs typeface="Arial"/>
              </a:rPr>
              <a:t>P</a:t>
            </a:r>
            <a:r>
              <a:rPr sz="1125" i="1" spc="-16" dirty="0">
                <a:latin typeface="Arial"/>
                <a:cs typeface="Arial"/>
              </a:rPr>
              <a:t> </a:t>
            </a:r>
            <a:r>
              <a:rPr sz="1125" dirty="0">
                <a:latin typeface="Arial"/>
                <a:cs typeface="Arial"/>
              </a:rPr>
              <a:t>=</a:t>
            </a:r>
            <a:r>
              <a:rPr sz="1125" spc="-13" dirty="0">
                <a:latin typeface="Arial"/>
                <a:cs typeface="Arial"/>
              </a:rPr>
              <a:t> </a:t>
            </a:r>
            <a:r>
              <a:rPr sz="1125" spc="-3" dirty="0">
                <a:latin typeface="Arial"/>
                <a:cs typeface="Arial"/>
              </a:rPr>
              <a:t>0.474</a:t>
            </a:r>
            <a:endParaRPr sz="1125" dirty="0">
              <a:latin typeface="Arial"/>
              <a:cs typeface="Arial"/>
            </a:endParaRPr>
          </a:p>
        </p:txBody>
      </p:sp>
      <p:grpSp>
        <p:nvGrpSpPr>
          <p:cNvPr id="5" name="object 3">
            <a:extLst>
              <a:ext uri="{FF2B5EF4-FFF2-40B4-BE49-F238E27FC236}">
                <a16:creationId xmlns:a16="http://schemas.microsoft.com/office/drawing/2014/main" id="{5FCAED42-647C-47ED-9854-7B9D099F2BCB}"/>
              </a:ext>
            </a:extLst>
          </p:cNvPr>
          <p:cNvGrpSpPr/>
          <p:nvPr/>
        </p:nvGrpSpPr>
        <p:grpSpPr>
          <a:xfrm>
            <a:off x="801592" y="519164"/>
            <a:ext cx="4647974" cy="2332917"/>
            <a:chOff x="617727" y="212852"/>
            <a:chExt cx="7436484" cy="3732529"/>
          </a:xfrm>
        </p:grpSpPr>
        <p:sp>
          <p:nvSpPr>
            <p:cNvPr id="6" name="object 4">
              <a:extLst>
                <a:ext uri="{FF2B5EF4-FFF2-40B4-BE49-F238E27FC236}">
                  <a16:creationId xmlns:a16="http://schemas.microsoft.com/office/drawing/2014/main" id="{2F9BBA9C-0C67-4F3B-AE20-E9FE742CAD7D}"/>
                </a:ext>
              </a:extLst>
            </p:cNvPr>
            <p:cNvSpPr/>
            <p:nvPr/>
          </p:nvSpPr>
          <p:spPr>
            <a:xfrm>
              <a:off x="659510" y="219837"/>
              <a:ext cx="0" cy="3684270"/>
            </a:xfrm>
            <a:custGeom>
              <a:avLst/>
              <a:gdLst/>
              <a:ahLst/>
              <a:cxnLst/>
              <a:rect l="l" t="t" r="r" b="b"/>
              <a:pathLst>
                <a:path h="3684270">
                  <a:moveTo>
                    <a:pt x="0" y="3683762"/>
                  </a:moveTo>
                  <a:lnTo>
                    <a:pt x="0" y="0"/>
                  </a:lnTo>
                </a:path>
              </a:pathLst>
            </a:custGeom>
            <a:ln w="1358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7" name="object 5">
              <a:extLst>
                <a:ext uri="{FF2B5EF4-FFF2-40B4-BE49-F238E27FC236}">
                  <a16:creationId xmlns:a16="http://schemas.microsoft.com/office/drawing/2014/main" id="{3C16A830-63C6-4823-8973-7214B33D067E}"/>
                </a:ext>
              </a:extLst>
            </p:cNvPr>
            <p:cNvSpPr/>
            <p:nvPr/>
          </p:nvSpPr>
          <p:spPr>
            <a:xfrm>
              <a:off x="624712" y="3736212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0" y="0"/>
                  </a:moveTo>
                  <a:lnTo>
                    <a:pt x="34798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8" name="object 6">
              <a:extLst>
                <a:ext uri="{FF2B5EF4-FFF2-40B4-BE49-F238E27FC236}">
                  <a16:creationId xmlns:a16="http://schemas.microsoft.com/office/drawing/2014/main" id="{9D6A27C9-431F-4194-B019-275C8D4C725D}"/>
                </a:ext>
              </a:extLst>
            </p:cNvPr>
            <p:cNvSpPr/>
            <p:nvPr/>
          </p:nvSpPr>
          <p:spPr>
            <a:xfrm>
              <a:off x="624712" y="3066415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0" y="0"/>
                  </a:moveTo>
                  <a:lnTo>
                    <a:pt x="34798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9" name="object 7">
              <a:extLst>
                <a:ext uri="{FF2B5EF4-FFF2-40B4-BE49-F238E27FC236}">
                  <a16:creationId xmlns:a16="http://schemas.microsoft.com/office/drawing/2014/main" id="{D89056F7-308C-400C-97D0-6E3BD72BF2EA}"/>
                </a:ext>
              </a:extLst>
            </p:cNvPr>
            <p:cNvSpPr/>
            <p:nvPr/>
          </p:nvSpPr>
          <p:spPr>
            <a:xfrm>
              <a:off x="624712" y="2396616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0" y="0"/>
                  </a:moveTo>
                  <a:lnTo>
                    <a:pt x="34798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0" name="object 8">
              <a:extLst>
                <a:ext uri="{FF2B5EF4-FFF2-40B4-BE49-F238E27FC236}">
                  <a16:creationId xmlns:a16="http://schemas.microsoft.com/office/drawing/2014/main" id="{73EBCA95-64A5-4231-A929-60FAC891264D}"/>
                </a:ext>
              </a:extLst>
            </p:cNvPr>
            <p:cNvSpPr/>
            <p:nvPr/>
          </p:nvSpPr>
          <p:spPr>
            <a:xfrm>
              <a:off x="624712" y="172681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0" y="0"/>
                  </a:moveTo>
                  <a:lnTo>
                    <a:pt x="34798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1" name="object 9">
              <a:extLst>
                <a:ext uri="{FF2B5EF4-FFF2-40B4-BE49-F238E27FC236}">
                  <a16:creationId xmlns:a16="http://schemas.microsoft.com/office/drawing/2014/main" id="{630B7B24-BDFE-470A-8455-C92966ECB542}"/>
                </a:ext>
              </a:extLst>
            </p:cNvPr>
            <p:cNvSpPr/>
            <p:nvPr/>
          </p:nvSpPr>
          <p:spPr>
            <a:xfrm>
              <a:off x="624712" y="1057148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0" y="0"/>
                  </a:moveTo>
                  <a:lnTo>
                    <a:pt x="34798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2" name="object 10">
              <a:extLst>
                <a:ext uri="{FF2B5EF4-FFF2-40B4-BE49-F238E27FC236}">
                  <a16:creationId xmlns:a16="http://schemas.microsoft.com/office/drawing/2014/main" id="{6703F60E-9C84-47C3-B0CE-1D78DD27DC7D}"/>
                </a:ext>
              </a:extLst>
            </p:cNvPr>
            <p:cNvSpPr/>
            <p:nvPr/>
          </p:nvSpPr>
          <p:spPr>
            <a:xfrm>
              <a:off x="624712" y="387350"/>
              <a:ext cx="34925" cy="0"/>
            </a:xfrm>
            <a:custGeom>
              <a:avLst/>
              <a:gdLst/>
              <a:ahLst/>
              <a:cxnLst/>
              <a:rect l="l" t="t" r="r" b="b"/>
              <a:pathLst>
                <a:path w="34925">
                  <a:moveTo>
                    <a:pt x="0" y="0"/>
                  </a:moveTo>
                  <a:lnTo>
                    <a:pt x="34798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3" name="object 11">
              <a:extLst>
                <a:ext uri="{FF2B5EF4-FFF2-40B4-BE49-F238E27FC236}">
                  <a16:creationId xmlns:a16="http://schemas.microsoft.com/office/drawing/2014/main" id="{2EBA6518-3BD1-4EF5-8A80-A5B4FE4D8FE5}"/>
                </a:ext>
              </a:extLst>
            </p:cNvPr>
            <p:cNvSpPr/>
            <p:nvPr/>
          </p:nvSpPr>
          <p:spPr>
            <a:xfrm>
              <a:off x="659510" y="3903598"/>
              <a:ext cx="7387590" cy="0"/>
            </a:xfrm>
            <a:custGeom>
              <a:avLst/>
              <a:gdLst/>
              <a:ahLst/>
              <a:cxnLst/>
              <a:rect l="l" t="t" r="r" b="b"/>
              <a:pathLst>
                <a:path w="7387590">
                  <a:moveTo>
                    <a:pt x="0" y="0"/>
                  </a:moveTo>
                  <a:lnTo>
                    <a:pt x="7387208" y="0"/>
                  </a:lnTo>
                </a:path>
              </a:pathLst>
            </a:custGeom>
            <a:ln w="13589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4" name="object 12">
              <a:extLst>
                <a:ext uri="{FF2B5EF4-FFF2-40B4-BE49-F238E27FC236}">
                  <a16:creationId xmlns:a16="http://schemas.microsoft.com/office/drawing/2014/main" id="{17DD3DE3-514B-4A31-A01B-7BB610D19BEC}"/>
                </a:ext>
              </a:extLst>
            </p:cNvPr>
            <p:cNvSpPr/>
            <p:nvPr/>
          </p:nvSpPr>
          <p:spPr>
            <a:xfrm>
              <a:off x="995298" y="3903598"/>
              <a:ext cx="0" cy="34925"/>
            </a:xfrm>
            <a:custGeom>
              <a:avLst/>
              <a:gdLst/>
              <a:ahLst/>
              <a:cxnLst/>
              <a:rect l="l" t="t" r="r" b="b"/>
              <a:pathLst>
                <a:path h="34925">
                  <a:moveTo>
                    <a:pt x="0" y="34797"/>
                  </a:moveTo>
                  <a:lnTo>
                    <a:pt x="0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5" name="object 13">
              <a:extLst>
                <a:ext uri="{FF2B5EF4-FFF2-40B4-BE49-F238E27FC236}">
                  <a16:creationId xmlns:a16="http://schemas.microsoft.com/office/drawing/2014/main" id="{1C8C022C-3708-4881-8139-A7CB0DA02372}"/>
                </a:ext>
              </a:extLst>
            </p:cNvPr>
            <p:cNvSpPr/>
            <p:nvPr/>
          </p:nvSpPr>
          <p:spPr>
            <a:xfrm>
              <a:off x="2020569" y="3903598"/>
              <a:ext cx="0" cy="34925"/>
            </a:xfrm>
            <a:custGeom>
              <a:avLst/>
              <a:gdLst/>
              <a:ahLst/>
              <a:cxnLst/>
              <a:rect l="l" t="t" r="r" b="b"/>
              <a:pathLst>
                <a:path h="34925">
                  <a:moveTo>
                    <a:pt x="0" y="34797"/>
                  </a:moveTo>
                  <a:lnTo>
                    <a:pt x="0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6" name="object 14">
              <a:extLst>
                <a:ext uri="{FF2B5EF4-FFF2-40B4-BE49-F238E27FC236}">
                  <a16:creationId xmlns:a16="http://schemas.microsoft.com/office/drawing/2014/main" id="{6823285D-92F6-4D1B-9D09-0EC6B0E94D84}"/>
                </a:ext>
              </a:extLst>
            </p:cNvPr>
            <p:cNvSpPr/>
            <p:nvPr/>
          </p:nvSpPr>
          <p:spPr>
            <a:xfrm>
              <a:off x="3045841" y="3903598"/>
              <a:ext cx="0" cy="34925"/>
            </a:xfrm>
            <a:custGeom>
              <a:avLst/>
              <a:gdLst/>
              <a:ahLst/>
              <a:cxnLst/>
              <a:rect l="l" t="t" r="r" b="b"/>
              <a:pathLst>
                <a:path h="34925">
                  <a:moveTo>
                    <a:pt x="0" y="34797"/>
                  </a:moveTo>
                  <a:lnTo>
                    <a:pt x="0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7" name="object 15">
              <a:extLst>
                <a:ext uri="{FF2B5EF4-FFF2-40B4-BE49-F238E27FC236}">
                  <a16:creationId xmlns:a16="http://schemas.microsoft.com/office/drawing/2014/main" id="{924D6018-FD2D-4D33-9814-478360069AE5}"/>
                </a:ext>
              </a:extLst>
            </p:cNvPr>
            <p:cNvSpPr/>
            <p:nvPr/>
          </p:nvSpPr>
          <p:spPr>
            <a:xfrm>
              <a:off x="4071112" y="3903598"/>
              <a:ext cx="0" cy="34925"/>
            </a:xfrm>
            <a:custGeom>
              <a:avLst/>
              <a:gdLst/>
              <a:ahLst/>
              <a:cxnLst/>
              <a:rect l="l" t="t" r="r" b="b"/>
              <a:pathLst>
                <a:path h="34925">
                  <a:moveTo>
                    <a:pt x="0" y="34797"/>
                  </a:moveTo>
                  <a:lnTo>
                    <a:pt x="0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8" name="object 16">
              <a:extLst>
                <a:ext uri="{FF2B5EF4-FFF2-40B4-BE49-F238E27FC236}">
                  <a16:creationId xmlns:a16="http://schemas.microsoft.com/office/drawing/2014/main" id="{35564275-1F91-4A9C-A345-39523B1CF167}"/>
                </a:ext>
              </a:extLst>
            </p:cNvPr>
            <p:cNvSpPr/>
            <p:nvPr/>
          </p:nvSpPr>
          <p:spPr>
            <a:xfrm>
              <a:off x="5096382" y="3903598"/>
              <a:ext cx="0" cy="34925"/>
            </a:xfrm>
            <a:custGeom>
              <a:avLst/>
              <a:gdLst/>
              <a:ahLst/>
              <a:cxnLst/>
              <a:rect l="l" t="t" r="r" b="b"/>
              <a:pathLst>
                <a:path h="34925">
                  <a:moveTo>
                    <a:pt x="0" y="34797"/>
                  </a:moveTo>
                  <a:lnTo>
                    <a:pt x="0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19" name="object 17">
              <a:extLst>
                <a:ext uri="{FF2B5EF4-FFF2-40B4-BE49-F238E27FC236}">
                  <a16:creationId xmlns:a16="http://schemas.microsoft.com/office/drawing/2014/main" id="{1D02291C-E24C-4582-B286-1D43F52ED0C1}"/>
                </a:ext>
              </a:extLst>
            </p:cNvPr>
            <p:cNvSpPr/>
            <p:nvPr/>
          </p:nvSpPr>
          <p:spPr>
            <a:xfrm>
              <a:off x="6121781" y="3903598"/>
              <a:ext cx="0" cy="34925"/>
            </a:xfrm>
            <a:custGeom>
              <a:avLst/>
              <a:gdLst/>
              <a:ahLst/>
              <a:cxnLst/>
              <a:rect l="l" t="t" r="r" b="b"/>
              <a:pathLst>
                <a:path h="34925">
                  <a:moveTo>
                    <a:pt x="0" y="34797"/>
                  </a:moveTo>
                  <a:lnTo>
                    <a:pt x="0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20" name="object 18">
              <a:extLst>
                <a:ext uri="{FF2B5EF4-FFF2-40B4-BE49-F238E27FC236}">
                  <a16:creationId xmlns:a16="http://schemas.microsoft.com/office/drawing/2014/main" id="{6E6EA05C-73D9-43F6-A98B-584D163B8AF0}"/>
                </a:ext>
              </a:extLst>
            </p:cNvPr>
            <p:cNvSpPr/>
            <p:nvPr/>
          </p:nvSpPr>
          <p:spPr>
            <a:xfrm>
              <a:off x="7147051" y="3903598"/>
              <a:ext cx="0" cy="34925"/>
            </a:xfrm>
            <a:custGeom>
              <a:avLst/>
              <a:gdLst/>
              <a:ahLst/>
              <a:cxnLst/>
              <a:rect l="l" t="t" r="r" b="b"/>
              <a:pathLst>
                <a:path h="34925">
                  <a:moveTo>
                    <a:pt x="0" y="34797"/>
                  </a:moveTo>
                  <a:lnTo>
                    <a:pt x="0" y="0"/>
                  </a:lnTo>
                </a:path>
              </a:pathLst>
            </a:custGeom>
            <a:ln w="13589">
              <a:solidFill>
                <a:srgbClr val="333333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</p:grpSp>
      <p:sp>
        <p:nvSpPr>
          <p:cNvPr id="21" name="object 19">
            <a:extLst>
              <a:ext uri="{FF2B5EF4-FFF2-40B4-BE49-F238E27FC236}">
                <a16:creationId xmlns:a16="http://schemas.microsoft.com/office/drawing/2014/main" id="{BE8AFB36-E565-4734-B630-AD2DD848B1EF}"/>
              </a:ext>
            </a:extLst>
          </p:cNvPr>
          <p:cNvSpPr txBox="1"/>
          <p:nvPr/>
        </p:nvSpPr>
        <p:spPr>
          <a:xfrm>
            <a:off x="633708" y="2224740"/>
            <a:ext cx="170663" cy="575543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0.6</a:t>
            </a:r>
            <a:endParaRPr sz="875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938">
              <a:latin typeface="Arial"/>
              <a:cs typeface="Arial"/>
            </a:endParaRPr>
          </a:p>
          <a:p>
            <a:pPr>
              <a:spcBef>
                <a:spcPts val="16"/>
              </a:spcBef>
            </a:pPr>
            <a:endParaRPr sz="1000">
              <a:latin typeface="Arial"/>
              <a:cs typeface="Arial"/>
            </a:endParaRPr>
          </a:p>
          <a:p>
            <a:pPr marL="7937">
              <a:spcBef>
                <a:spcPts val="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0.5</a:t>
            </a:r>
            <a:endParaRPr sz="875">
              <a:latin typeface="Arial"/>
              <a:cs typeface="Arial"/>
            </a:endParaRPr>
          </a:p>
        </p:txBody>
      </p:sp>
      <p:sp>
        <p:nvSpPr>
          <p:cNvPr id="22" name="object 20">
            <a:extLst>
              <a:ext uri="{FF2B5EF4-FFF2-40B4-BE49-F238E27FC236}">
                <a16:creationId xmlns:a16="http://schemas.microsoft.com/office/drawing/2014/main" id="{859AD863-D99C-41C8-905A-65F3E355C744}"/>
              </a:ext>
            </a:extLst>
          </p:cNvPr>
          <p:cNvSpPr txBox="1"/>
          <p:nvPr/>
        </p:nvSpPr>
        <p:spPr>
          <a:xfrm>
            <a:off x="633708" y="1806101"/>
            <a:ext cx="170663" cy="142668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0.7</a:t>
            </a:r>
            <a:endParaRPr sz="875">
              <a:latin typeface="Arial"/>
              <a:cs typeface="Arial"/>
            </a:endParaRPr>
          </a:p>
        </p:txBody>
      </p:sp>
      <p:sp>
        <p:nvSpPr>
          <p:cNvPr id="23" name="object 21">
            <a:extLst>
              <a:ext uri="{FF2B5EF4-FFF2-40B4-BE49-F238E27FC236}">
                <a16:creationId xmlns:a16="http://schemas.microsoft.com/office/drawing/2014/main" id="{3D81CDA5-5BC7-423B-A102-7578EF16855D}"/>
              </a:ext>
            </a:extLst>
          </p:cNvPr>
          <p:cNvSpPr txBox="1"/>
          <p:nvPr/>
        </p:nvSpPr>
        <p:spPr>
          <a:xfrm>
            <a:off x="633708" y="968902"/>
            <a:ext cx="170663" cy="575543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0.9</a:t>
            </a:r>
            <a:endParaRPr sz="875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938">
              <a:latin typeface="Arial"/>
              <a:cs typeface="Arial"/>
            </a:endParaRPr>
          </a:p>
          <a:p>
            <a:pPr>
              <a:spcBef>
                <a:spcPts val="16"/>
              </a:spcBef>
            </a:pPr>
            <a:endParaRPr sz="1000">
              <a:latin typeface="Arial"/>
              <a:cs typeface="Arial"/>
            </a:endParaRPr>
          </a:p>
          <a:p>
            <a:pPr marL="7937"/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0.8</a:t>
            </a:r>
            <a:endParaRPr sz="875">
              <a:latin typeface="Arial"/>
              <a:cs typeface="Arial"/>
            </a:endParaRPr>
          </a:p>
        </p:txBody>
      </p:sp>
      <p:sp>
        <p:nvSpPr>
          <p:cNvPr id="24" name="object 22">
            <a:extLst>
              <a:ext uri="{FF2B5EF4-FFF2-40B4-BE49-F238E27FC236}">
                <a16:creationId xmlns:a16="http://schemas.microsoft.com/office/drawing/2014/main" id="{5809BA74-3D0A-4DE3-B00D-615F43343ABA}"/>
              </a:ext>
            </a:extLst>
          </p:cNvPr>
          <p:cNvSpPr txBox="1"/>
          <p:nvPr/>
        </p:nvSpPr>
        <p:spPr>
          <a:xfrm>
            <a:off x="633708" y="550262"/>
            <a:ext cx="170663" cy="142668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1.0</a:t>
            </a:r>
            <a:endParaRPr sz="875">
              <a:latin typeface="Arial"/>
              <a:cs typeface="Arial"/>
            </a:endParaRPr>
          </a:p>
        </p:txBody>
      </p:sp>
      <p:sp>
        <p:nvSpPr>
          <p:cNvPr id="25" name="object 23">
            <a:extLst>
              <a:ext uri="{FF2B5EF4-FFF2-40B4-BE49-F238E27FC236}">
                <a16:creationId xmlns:a16="http://schemas.microsoft.com/office/drawing/2014/main" id="{26ABEFB6-8FE0-415E-B175-76F28ABFEC93}"/>
              </a:ext>
            </a:extLst>
          </p:cNvPr>
          <p:cNvSpPr txBox="1"/>
          <p:nvPr/>
        </p:nvSpPr>
        <p:spPr>
          <a:xfrm>
            <a:off x="993926" y="2828646"/>
            <a:ext cx="77790" cy="142668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dirty="0">
                <a:solidFill>
                  <a:srgbClr val="4D4D4D"/>
                </a:solidFill>
                <a:latin typeface="Arial"/>
                <a:cs typeface="Arial"/>
              </a:rPr>
              <a:t>0</a:t>
            </a:r>
            <a:endParaRPr sz="875">
              <a:latin typeface="Arial"/>
              <a:cs typeface="Arial"/>
            </a:endParaRPr>
          </a:p>
        </p:txBody>
      </p:sp>
      <p:sp>
        <p:nvSpPr>
          <p:cNvPr id="26" name="object 24">
            <a:extLst>
              <a:ext uri="{FF2B5EF4-FFF2-40B4-BE49-F238E27FC236}">
                <a16:creationId xmlns:a16="http://schemas.microsoft.com/office/drawing/2014/main" id="{EAECFE26-183C-4163-BB53-D5EE6BAB3DCA}"/>
              </a:ext>
            </a:extLst>
          </p:cNvPr>
          <p:cNvSpPr txBox="1"/>
          <p:nvPr/>
        </p:nvSpPr>
        <p:spPr>
          <a:xfrm>
            <a:off x="1579100" y="2828646"/>
            <a:ext cx="201620" cy="142668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300</a:t>
            </a:r>
            <a:endParaRPr sz="875">
              <a:latin typeface="Arial"/>
              <a:cs typeface="Arial"/>
            </a:endParaRPr>
          </a:p>
        </p:txBody>
      </p:sp>
      <p:sp>
        <p:nvSpPr>
          <p:cNvPr id="27" name="object 25">
            <a:extLst>
              <a:ext uri="{FF2B5EF4-FFF2-40B4-BE49-F238E27FC236}">
                <a16:creationId xmlns:a16="http://schemas.microsoft.com/office/drawing/2014/main" id="{F3EF8764-3CBD-484F-BCE5-CEB0FF58C6C3}"/>
              </a:ext>
            </a:extLst>
          </p:cNvPr>
          <p:cNvSpPr txBox="1"/>
          <p:nvPr/>
        </p:nvSpPr>
        <p:spPr>
          <a:xfrm>
            <a:off x="2219996" y="2828646"/>
            <a:ext cx="201620" cy="142668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600</a:t>
            </a:r>
            <a:endParaRPr sz="875">
              <a:latin typeface="Arial"/>
              <a:cs typeface="Arial"/>
            </a:endParaRPr>
          </a:p>
        </p:txBody>
      </p:sp>
      <p:sp>
        <p:nvSpPr>
          <p:cNvPr id="28" name="object 26">
            <a:extLst>
              <a:ext uri="{FF2B5EF4-FFF2-40B4-BE49-F238E27FC236}">
                <a16:creationId xmlns:a16="http://schemas.microsoft.com/office/drawing/2014/main" id="{EC980E33-FCDA-485C-A45B-4557AFB5739C}"/>
              </a:ext>
            </a:extLst>
          </p:cNvPr>
          <p:cNvSpPr txBox="1"/>
          <p:nvPr/>
        </p:nvSpPr>
        <p:spPr>
          <a:xfrm>
            <a:off x="4114666" y="2828646"/>
            <a:ext cx="263138" cy="142668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1500</a:t>
            </a:r>
            <a:endParaRPr sz="875">
              <a:latin typeface="Arial"/>
              <a:cs typeface="Arial"/>
            </a:endParaRPr>
          </a:p>
        </p:txBody>
      </p:sp>
      <p:sp>
        <p:nvSpPr>
          <p:cNvPr id="29" name="object 27">
            <a:extLst>
              <a:ext uri="{FF2B5EF4-FFF2-40B4-BE49-F238E27FC236}">
                <a16:creationId xmlns:a16="http://schemas.microsoft.com/office/drawing/2014/main" id="{BEB0F0DA-9EF2-41E6-A78B-B8B4708CD794}"/>
              </a:ext>
            </a:extLst>
          </p:cNvPr>
          <p:cNvSpPr txBox="1"/>
          <p:nvPr/>
        </p:nvSpPr>
        <p:spPr>
          <a:xfrm>
            <a:off x="4755485" y="2828646"/>
            <a:ext cx="263138" cy="142668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spcBef>
                <a:spcPts val="63"/>
              </a:spcBef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1800</a:t>
            </a:r>
            <a:endParaRPr sz="875" dirty="0">
              <a:latin typeface="Arial"/>
              <a:cs typeface="Arial"/>
            </a:endParaRPr>
          </a:p>
        </p:txBody>
      </p:sp>
      <p:grpSp>
        <p:nvGrpSpPr>
          <p:cNvPr id="30" name="object 28">
            <a:extLst>
              <a:ext uri="{FF2B5EF4-FFF2-40B4-BE49-F238E27FC236}">
                <a16:creationId xmlns:a16="http://schemas.microsoft.com/office/drawing/2014/main" id="{0CD80EF8-18AA-41A4-B13A-5F3ED723BB2A}"/>
              </a:ext>
            </a:extLst>
          </p:cNvPr>
          <p:cNvGrpSpPr/>
          <p:nvPr/>
        </p:nvGrpSpPr>
        <p:grpSpPr>
          <a:xfrm>
            <a:off x="4402080" y="467014"/>
            <a:ext cx="960869" cy="494127"/>
            <a:chOff x="6378292" y="129412"/>
            <a:chExt cx="1537335" cy="790575"/>
          </a:xfrm>
        </p:grpSpPr>
        <p:sp>
          <p:nvSpPr>
            <p:cNvPr id="31" name="object 29">
              <a:extLst>
                <a:ext uri="{FF2B5EF4-FFF2-40B4-BE49-F238E27FC236}">
                  <a16:creationId xmlns:a16="http://schemas.microsoft.com/office/drawing/2014/main" id="{D50A18D7-EE50-4160-B760-D6758D822DC6}"/>
                </a:ext>
              </a:extLst>
            </p:cNvPr>
            <p:cNvSpPr/>
            <p:nvPr/>
          </p:nvSpPr>
          <p:spPr>
            <a:xfrm>
              <a:off x="6378292" y="129412"/>
              <a:ext cx="1537335" cy="790575"/>
            </a:xfrm>
            <a:custGeom>
              <a:avLst/>
              <a:gdLst/>
              <a:ahLst/>
              <a:cxnLst/>
              <a:rect l="l" t="t" r="r" b="b"/>
              <a:pathLst>
                <a:path w="1537334" h="790575">
                  <a:moveTo>
                    <a:pt x="1537259" y="0"/>
                  </a:moveTo>
                  <a:lnTo>
                    <a:pt x="0" y="0"/>
                  </a:lnTo>
                  <a:lnTo>
                    <a:pt x="0" y="790575"/>
                  </a:lnTo>
                  <a:lnTo>
                    <a:pt x="1537259" y="790575"/>
                  </a:lnTo>
                  <a:lnTo>
                    <a:pt x="1537259" y="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32" name="object 30">
              <a:extLst>
                <a:ext uri="{FF2B5EF4-FFF2-40B4-BE49-F238E27FC236}">
                  <a16:creationId xmlns:a16="http://schemas.microsoft.com/office/drawing/2014/main" id="{B5FA412B-A1BC-4A96-A1FF-87EC0096F315}"/>
                </a:ext>
              </a:extLst>
            </p:cNvPr>
            <p:cNvSpPr/>
            <p:nvPr/>
          </p:nvSpPr>
          <p:spPr>
            <a:xfrm>
              <a:off x="6502883" y="597407"/>
              <a:ext cx="239395" cy="0"/>
            </a:xfrm>
            <a:custGeom>
              <a:avLst/>
              <a:gdLst/>
              <a:ahLst/>
              <a:cxnLst/>
              <a:rect l="l" t="t" r="r" b="b"/>
              <a:pathLst>
                <a:path w="239395">
                  <a:moveTo>
                    <a:pt x="0" y="0"/>
                  </a:moveTo>
                  <a:lnTo>
                    <a:pt x="238814" y="0"/>
                  </a:lnTo>
                </a:path>
              </a:pathLst>
            </a:custGeom>
            <a:ln w="20320">
              <a:solidFill>
                <a:srgbClr val="E41A1C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  <p:sp>
          <p:nvSpPr>
            <p:cNvPr id="33" name="object 31">
              <a:extLst>
                <a:ext uri="{FF2B5EF4-FFF2-40B4-BE49-F238E27FC236}">
                  <a16:creationId xmlns:a16="http://schemas.microsoft.com/office/drawing/2014/main" id="{E27D693D-A25A-4377-B3F1-65FFDD917435}"/>
                </a:ext>
              </a:extLst>
            </p:cNvPr>
            <p:cNvSpPr/>
            <p:nvPr/>
          </p:nvSpPr>
          <p:spPr>
            <a:xfrm>
              <a:off x="6502883" y="893064"/>
              <a:ext cx="239395" cy="0"/>
            </a:xfrm>
            <a:custGeom>
              <a:avLst/>
              <a:gdLst/>
              <a:ahLst/>
              <a:cxnLst/>
              <a:rect l="l" t="t" r="r" b="b"/>
              <a:pathLst>
                <a:path w="239395">
                  <a:moveTo>
                    <a:pt x="0" y="0"/>
                  </a:moveTo>
                  <a:lnTo>
                    <a:pt x="238814" y="0"/>
                  </a:lnTo>
                </a:path>
              </a:pathLst>
            </a:custGeom>
            <a:ln w="20320">
              <a:solidFill>
                <a:srgbClr val="377EB8"/>
              </a:solidFill>
            </a:ln>
          </p:spPr>
          <p:txBody>
            <a:bodyPr wrap="square" lIns="0" tIns="0" rIns="0" bIns="0" rtlCol="0"/>
            <a:lstStyle/>
            <a:p>
              <a:endParaRPr sz="1125"/>
            </a:p>
          </p:txBody>
        </p:sp>
      </p:grpSp>
      <p:sp>
        <p:nvSpPr>
          <p:cNvPr id="34" name="object 32">
            <a:extLst>
              <a:ext uri="{FF2B5EF4-FFF2-40B4-BE49-F238E27FC236}">
                <a16:creationId xmlns:a16="http://schemas.microsoft.com/office/drawing/2014/main" id="{B4193168-AC87-46A1-8514-815B204FF76A}"/>
              </a:ext>
            </a:extLst>
          </p:cNvPr>
          <p:cNvSpPr txBox="1">
            <a:spLocks/>
          </p:cNvSpPr>
          <p:nvPr/>
        </p:nvSpPr>
        <p:spPr>
          <a:xfrm>
            <a:off x="714882" y="440400"/>
            <a:ext cx="4544925" cy="559337"/>
          </a:xfrm>
          <a:prstGeom prst="rect">
            <a:avLst/>
          </a:prstGeom>
        </p:spPr>
        <p:txBody>
          <a:bodyPr vert="horz" wrap="square" lIns="0" tIns="11511" rIns="0" bIns="0" rtlCol="0" anchor="ctr">
            <a:sp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4034759" marR="3176" indent="-288934">
              <a:lnSpc>
                <a:spcPct val="141300"/>
              </a:lnSpc>
              <a:spcBef>
                <a:spcPts val="91"/>
              </a:spcBef>
            </a:pPr>
            <a:r>
              <a:rPr lang="en-US" sz="875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r>
              <a:rPr lang="en-US" sz="875" spc="-28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75" spc="-3">
                <a:latin typeface="Arial" panose="020B0604020202020204" pitchFamily="34" charset="0"/>
                <a:cs typeface="Arial" panose="020B0604020202020204" pitchFamily="34" charset="0"/>
              </a:rPr>
              <a:t>Hcy</a:t>
            </a:r>
            <a:r>
              <a:rPr lang="en-US" sz="875" spc="-32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75" spc="-3">
                <a:latin typeface="Arial" panose="020B0604020202020204" pitchFamily="34" charset="0"/>
                <a:cs typeface="Arial" panose="020B0604020202020204" pitchFamily="34" charset="0"/>
              </a:rPr>
              <a:t>level </a:t>
            </a:r>
            <a:r>
              <a:rPr lang="en-US" sz="875" spc="-233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75" spc="-3">
                <a:latin typeface="Arial" panose="020B0604020202020204" pitchFamily="34" charset="0"/>
                <a:cs typeface="Arial" panose="020B0604020202020204" pitchFamily="34" charset="0"/>
              </a:rPr>
              <a:t>NHcy </a:t>
            </a:r>
            <a:r>
              <a:rPr lang="en-US" sz="875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75" spc="-3">
                <a:latin typeface="Arial" panose="020B0604020202020204" pitchFamily="34" charset="0"/>
                <a:cs typeface="Arial" panose="020B0604020202020204" pitchFamily="34" charset="0"/>
              </a:rPr>
              <a:t>HHcy</a:t>
            </a:r>
            <a:endParaRPr lang="en-US" sz="875" spc="-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object 33">
            <a:extLst>
              <a:ext uri="{FF2B5EF4-FFF2-40B4-BE49-F238E27FC236}">
                <a16:creationId xmlns:a16="http://schemas.microsoft.com/office/drawing/2014/main" id="{29C9BB4A-4711-44C4-9962-A08042137395}"/>
              </a:ext>
            </a:extLst>
          </p:cNvPr>
          <p:cNvSpPr txBox="1"/>
          <p:nvPr/>
        </p:nvSpPr>
        <p:spPr>
          <a:xfrm>
            <a:off x="2860813" y="2828645"/>
            <a:ext cx="876332" cy="399148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>
              <a:lnSpc>
                <a:spcPts val="923"/>
              </a:lnSpc>
              <a:spcBef>
                <a:spcPts val="63"/>
              </a:spcBef>
              <a:tabLst>
                <a:tab pos="620731" algn="l"/>
              </a:tabLst>
            </a:pP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90</a:t>
            </a:r>
            <a:r>
              <a:rPr sz="875" dirty="0">
                <a:solidFill>
                  <a:srgbClr val="4D4D4D"/>
                </a:solidFill>
                <a:latin typeface="Arial"/>
                <a:cs typeface="Arial"/>
              </a:rPr>
              <a:t>0	</a:t>
            </a:r>
            <a:r>
              <a:rPr sz="875" spc="-3" dirty="0">
                <a:solidFill>
                  <a:srgbClr val="4D4D4D"/>
                </a:solidFill>
                <a:latin typeface="Arial"/>
                <a:cs typeface="Arial"/>
              </a:rPr>
              <a:t>1200</a:t>
            </a:r>
            <a:endParaRPr sz="875">
              <a:latin typeface="Arial"/>
              <a:cs typeface="Arial"/>
            </a:endParaRPr>
          </a:p>
          <a:p>
            <a:pPr marL="17860">
              <a:lnSpc>
                <a:spcPts val="923"/>
              </a:lnSpc>
            </a:pPr>
            <a:r>
              <a:rPr sz="875" dirty="0">
                <a:latin typeface="Arial"/>
                <a:cs typeface="Arial"/>
              </a:rPr>
              <a:t>time</a:t>
            </a:r>
            <a:r>
              <a:rPr sz="875" spc="-13" dirty="0">
                <a:latin typeface="Arial"/>
                <a:cs typeface="Arial"/>
              </a:rPr>
              <a:t> </a:t>
            </a:r>
            <a:r>
              <a:rPr sz="875" dirty="0">
                <a:latin typeface="Arial"/>
                <a:cs typeface="Arial"/>
              </a:rPr>
              <a:t>to</a:t>
            </a:r>
            <a:r>
              <a:rPr sz="875" spc="-13" dirty="0">
                <a:latin typeface="Arial"/>
                <a:cs typeface="Arial"/>
              </a:rPr>
              <a:t> </a:t>
            </a:r>
            <a:r>
              <a:rPr sz="875" spc="-3" dirty="0">
                <a:latin typeface="Arial"/>
                <a:cs typeface="Arial"/>
              </a:rPr>
              <a:t>events</a:t>
            </a:r>
            <a:endParaRPr sz="875">
              <a:latin typeface="Arial"/>
              <a:cs typeface="Arial"/>
            </a:endParaRPr>
          </a:p>
          <a:p>
            <a:pPr marL="13495">
              <a:spcBef>
                <a:spcPts val="247"/>
              </a:spcBef>
              <a:tabLst>
                <a:tab pos="655659" algn="l"/>
              </a:tabLst>
            </a:pPr>
            <a:r>
              <a:rPr sz="875" spc="-3" dirty="0">
                <a:latin typeface="Arial"/>
                <a:cs typeface="Arial"/>
              </a:rPr>
              <a:t>451	226</a:t>
            </a:r>
            <a:endParaRPr sz="875">
              <a:latin typeface="Arial"/>
              <a:cs typeface="Arial"/>
            </a:endParaRPr>
          </a:p>
        </p:txBody>
      </p:sp>
      <p:sp>
        <p:nvSpPr>
          <p:cNvPr id="36" name="object 34">
            <a:extLst>
              <a:ext uri="{FF2B5EF4-FFF2-40B4-BE49-F238E27FC236}">
                <a16:creationId xmlns:a16="http://schemas.microsoft.com/office/drawing/2014/main" id="{BBF118C6-889D-4990-8582-71AB257BA868}"/>
              </a:ext>
            </a:extLst>
          </p:cNvPr>
          <p:cNvSpPr txBox="1"/>
          <p:nvPr/>
        </p:nvSpPr>
        <p:spPr>
          <a:xfrm>
            <a:off x="932964" y="3047172"/>
            <a:ext cx="201620" cy="376306"/>
          </a:xfrm>
          <a:prstGeom prst="rect">
            <a:avLst/>
          </a:prstGeom>
        </p:spPr>
        <p:txBody>
          <a:bodyPr vert="horz" wrap="square" lIns="0" tIns="55167" rIns="0" bIns="0" rtlCol="0">
            <a:spAutoFit/>
          </a:bodyPr>
          <a:lstStyle/>
          <a:p>
            <a:pPr marL="7937">
              <a:spcBef>
                <a:spcPts val="434"/>
              </a:spcBef>
            </a:pPr>
            <a:r>
              <a:rPr sz="875" spc="-3" dirty="0">
                <a:latin typeface="Arial"/>
                <a:cs typeface="Arial"/>
              </a:rPr>
              <a:t>988</a:t>
            </a:r>
            <a:endParaRPr sz="875">
              <a:latin typeface="Arial"/>
              <a:cs typeface="Arial"/>
            </a:endParaRPr>
          </a:p>
          <a:p>
            <a:pPr marL="7937">
              <a:spcBef>
                <a:spcPts val="372"/>
              </a:spcBef>
            </a:pPr>
            <a:r>
              <a:rPr sz="875" spc="-3" dirty="0">
                <a:latin typeface="Arial"/>
                <a:cs typeface="Arial"/>
              </a:rPr>
              <a:t>565</a:t>
            </a:r>
            <a:endParaRPr sz="875">
              <a:latin typeface="Arial"/>
              <a:cs typeface="Arial"/>
            </a:endParaRPr>
          </a:p>
        </p:txBody>
      </p:sp>
      <p:sp>
        <p:nvSpPr>
          <p:cNvPr id="37" name="object 35">
            <a:extLst>
              <a:ext uri="{FF2B5EF4-FFF2-40B4-BE49-F238E27FC236}">
                <a16:creationId xmlns:a16="http://schemas.microsoft.com/office/drawing/2014/main" id="{84985CAE-1860-4B58-BCDC-17A706457F9F}"/>
              </a:ext>
            </a:extLst>
          </p:cNvPr>
          <p:cNvSpPr txBox="1"/>
          <p:nvPr/>
        </p:nvSpPr>
        <p:spPr>
          <a:xfrm>
            <a:off x="1582828" y="3047172"/>
            <a:ext cx="201620" cy="376306"/>
          </a:xfrm>
          <a:prstGeom prst="rect">
            <a:avLst/>
          </a:prstGeom>
        </p:spPr>
        <p:txBody>
          <a:bodyPr vert="horz" wrap="square" lIns="0" tIns="55167" rIns="0" bIns="0" rtlCol="0">
            <a:spAutoFit/>
          </a:bodyPr>
          <a:lstStyle/>
          <a:p>
            <a:pPr marL="7937">
              <a:spcBef>
                <a:spcPts val="434"/>
              </a:spcBef>
            </a:pPr>
            <a:r>
              <a:rPr sz="875" spc="-3" dirty="0">
                <a:latin typeface="Arial"/>
                <a:cs typeface="Arial"/>
              </a:rPr>
              <a:t>834</a:t>
            </a:r>
            <a:endParaRPr sz="875" dirty="0">
              <a:latin typeface="Arial"/>
              <a:cs typeface="Arial"/>
            </a:endParaRPr>
          </a:p>
          <a:p>
            <a:pPr marL="7937">
              <a:spcBef>
                <a:spcPts val="372"/>
              </a:spcBef>
            </a:pPr>
            <a:r>
              <a:rPr sz="875" spc="-3" dirty="0">
                <a:latin typeface="Arial"/>
                <a:cs typeface="Arial"/>
              </a:rPr>
              <a:t>477</a:t>
            </a:r>
            <a:endParaRPr sz="875" dirty="0">
              <a:latin typeface="Arial"/>
              <a:cs typeface="Arial"/>
            </a:endParaRPr>
          </a:p>
        </p:txBody>
      </p:sp>
      <p:sp>
        <p:nvSpPr>
          <p:cNvPr id="38" name="object 36">
            <a:extLst>
              <a:ext uri="{FF2B5EF4-FFF2-40B4-BE49-F238E27FC236}">
                <a16:creationId xmlns:a16="http://schemas.microsoft.com/office/drawing/2014/main" id="{F94F0C68-32A2-4FD7-87BE-9F1F26FD56B3}"/>
              </a:ext>
            </a:extLst>
          </p:cNvPr>
          <p:cNvSpPr txBox="1"/>
          <p:nvPr/>
        </p:nvSpPr>
        <p:spPr>
          <a:xfrm>
            <a:off x="2224757" y="3047172"/>
            <a:ext cx="201620" cy="376306"/>
          </a:xfrm>
          <a:prstGeom prst="rect">
            <a:avLst/>
          </a:prstGeom>
        </p:spPr>
        <p:txBody>
          <a:bodyPr vert="horz" wrap="square" lIns="0" tIns="55167" rIns="0" bIns="0" rtlCol="0">
            <a:spAutoFit/>
          </a:bodyPr>
          <a:lstStyle/>
          <a:p>
            <a:pPr marL="7937">
              <a:spcBef>
                <a:spcPts val="434"/>
              </a:spcBef>
            </a:pPr>
            <a:r>
              <a:rPr sz="875" spc="-3" dirty="0">
                <a:latin typeface="Arial"/>
                <a:cs typeface="Arial"/>
              </a:rPr>
              <a:t>608</a:t>
            </a:r>
            <a:endParaRPr sz="875">
              <a:latin typeface="Arial"/>
              <a:cs typeface="Arial"/>
            </a:endParaRPr>
          </a:p>
          <a:p>
            <a:pPr marL="7937">
              <a:spcBef>
                <a:spcPts val="372"/>
              </a:spcBef>
            </a:pPr>
            <a:r>
              <a:rPr sz="875" spc="-3" dirty="0">
                <a:latin typeface="Arial"/>
                <a:cs typeface="Arial"/>
              </a:rPr>
              <a:t>379</a:t>
            </a:r>
            <a:endParaRPr sz="875">
              <a:latin typeface="Arial"/>
              <a:cs typeface="Arial"/>
            </a:endParaRPr>
          </a:p>
        </p:txBody>
      </p:sp>
      <p:sp>
        <p:nvSpPr>
          <p:cNvPr id="39" name="object 37">
            <a:extLst>
              <a:ext uri="{FF2B5EF4-FFF2-40B4-BE49-F238E27FC236}">
                <a16:creationId xmlns:a16="http://schemas.microsoft.com/office/drawing/2014/main" id="{77EDBFDA-B447-4B39-BFAE-0CF2A420143B}"/>
              </a:ext>
            </a:extLst>
          </p:cNvPr>
          <p:cNvSpPr txBox="1"/>
          <p:nvPr/>
        </p:nvSpPr>
        <p:spPr>
          <a:xfrm>
            <a:off x="4186363" y="3047172"/>
            <a:ext cx="139705" cy="376306"/>
          </a:xfrm>
          <a:prstGeom prst="rect">
            <a:avLst/>
          </a:prstGeom>
        </p:spPr>
        <p:txBody>
          <a:bodyPr vert="horz" wrap="square" lIns="0" tIns="55167" rIns="0" bIns="0" rtlCol="0">
            <a:spAutoFit/>
          </a:bodyPr>
          <a:lstStyle/>
          <a:p>
            <a:pPr marL="7937">
              <a:spcBef>
                <a:spcPts val="434"/>
              </a:spcBef>
            </a:pPr>
            <a:r>
              <a:rPr sz="875" spc="-3" dirty="0">
                <a:latin typeface="Arial"/>
                <a:cs typeface="Arial"/>
              </a:rPr>
              <a:t>72</a:t>
            </a:r>
            <a:endParaRPr sz="875">
              <a:latin typeface="Arial"/>
              <a:cs typeface="Arial"/>
            </a:endParaRPr>
          </a:p>
          <a:p>
            <a:pPr marL="7937">
              <a:spcBef>
                <a:spcPts val="372"/>
              </a:spcBef>
            </a:pPr>
            <a:r>
              <a:rPr sz="875" spc="-3" dirty="0">
                <a:latin typeface="Arial"/>
                <a:cs typeface="Arial"/>
              </a:rPr>
              <a:t>61</a:t>
            </a:r>
            <a:endParaRPr sz="875">
              <a:latin typeface="Arial"/>
              <a:cs typeface="Arial"/>
            </a:endParaRPr>
          </a:p>
        </p:txBody>
      </p:sp>
      <p:sp>
        <p:nvSpPr>
          <p:cNvPr id="40" name="object 38">
            <a:extLst>
              <a:ext uri="{FF2B5EF4-FFF2-40B4-BE49-F238E27FC236}">
                <a16:creationId xmlns:a16="http://schemas.microsoft.com/office/drawing/2014/main" id="{F8C63C3C-8F14-454D-9C58-0021C19129D0}"/>
              </a:ext>
            </a:extLst>
          </p:cNvPr>
          <p:cNvSpPr txBox="1"/>
          <p:nvPr/>
        </p:nvSpPr>
        <p:spPr>
          <a:xfrm>
            <a:off x="4871965" y="3047173"/>
            <a:ext cx="77790" cy="376306"/>
          </a:xfrm>
          <a:prstGeom prst="rect">
            <a:avLst/>
          </a:prstGeom>
        </p:spPr>
        <p:txBody>
          <a:bodyPr vert="horz" wrap="square" lIns="0" tIns="55167" rIns="0" bIns="0" rtlCol="0">
            <a:spAutoFit/>
          </a:bodyPr>
          <a:lstStyle/>
          <a:p>
            <a:pPr marL="7937">
              <a:spcBef>
                <a:spcPts val="434"/>
              </a:spcBef>
            </a:pPr>
            <a:r>
              <a:rPr sz="875" dirty="0">
                <a:latin typeface="Arial"/>
                <a:cs typeface="Arial"/>
              </a:rPr>
              <a:t>3</a:t>
            </a:r>
            <a:endParaRPr sz="875">
              <a:latin typeface="Arial"/>
              <a:cs typeface="Arial"/>
            </a:endParaRPr>
          </a:p>
          <a:p>
            <a:pPr marL="7937">
              <a:spcBef>
                <a:spcPts val="372"/>
              </a:spcBef>
            </a:pPr>
            <a:r>
              <a:rPr sz="875" dirty="0">
                <a:latin typeface="Arial"/>
                <a:cs typeface="Arial"/>
              </a:rPr>
              <a:t>1</a:t>
            </a:r>
            <a:endParaRPr sz="875">
              <a:latin typeface="Arial"/>
              <a:cs typeface="Arial"/>
            </a:endParaRPr>
          </a:p>
        </p:txBody>
      </p:sp>
      <p:sp>
        <p:nvSpPr>
          <p:cNvPr id="41" name="object 39">
            <a:extLst>
              <a:ext uri="{FF2B5EF4-FFF2-40B4-BE49-F238E27FC236}">
                <a16:creationId xmlns:a16="http://schemas.microsoft.com/office/drawing/2014/main" id="{0582A5C6-A1AC-46AA-ABD4-86A96D5F4CB5}"/>
              </a:ext>
            </a:extLst>
          </p:cNvPr>
          <p:cNvSpPr txBox="1"/>
          <p:nvPr/>
        </p:nvSpPr>
        <p:spPr>
          <a:xfrm>
            <a:off x="2866688" y="3274987"/>
            <a:ext cx="843390" cy="264496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algn="ctr">
              <a:lnSpc>
                <a:spcPts val="975"/>
              </a:lnSpc>
              <a:spcBef>
                <a:spcPts val="63"/>
              </a:spcBef>
              <a:tabLst>
                <a:tab pos="641766" algn="l"/>
              </a:tabLst>
            </a:pPr>
            <a:r>
              <a:rPr sz="875" spc="-3" dirty="0">
                <a:latin typeface="Arial"/>
                <a:cs typeface="Arial"/>
              </a:rPr>
              <a:t>281	164</a:t>
            </a:r>
            <a:endParaRPr sz="875">
              <a:latin typeface="Arial"/>
              <a:cs typeface="Arial"/>
            </a:endParaRPr>
          </a:p>
          <a:p>
            <a:pPr marR="14288" algn="ctr">
              <a:lnSpc>
                <a:spcPts val="975"/>
              </a:lnSpc>
            </a:pPr>
            <a:r>
              <a:rPr sz="875" spc="-3" dirty="0">
                <a:latin typeface="Arial"/>
                <a:cs typeface="Arial"/>
              </a:rPr>
              <a:t>No.</a:t>
            </a:r>
            <a:r>
              <a:rPr sz="875" spc="-16" dirty="0">
                <a:latin typeface="Arial"/>
                <a:cs typeface="Arial"/>
              </a:rPr>
              <a:t> </a:t>
            </a:r>
            <a:r>
              <a:rPr sz="875" spc="-3" dirty="0">
                <a:latin typeface="Arial"/>
                <a:cs typeface="Arial"/>
              </a:rPr>
              <a:t>at</a:t>
            </a:r>
            <a:r>
              <a:rPr sz="875" spc="-13" dirty="0">
                <a:latin typeface="Arial"/>
                <a:cs typeface="Arial"/>
              </a:rPr>
              <a:t> </a:t>
            </a:r>
            <a:r>
              <a:rPr sz="875" dirty="0">
                <a:latin typeface="Arial"/>
                <a:cs typeface="Arial"/>
              </a:rPr>
              <a:t>risk</a:t>
            </a:r>
            <a:endParaRPr sz="875">
              <a:latin typeface="Arial"/>
              <a:cs typeface="Arial"/>
            </a:endParaRPr>
          </a:p>
        </p:txBody>
      </p:sp>
      <p:sp>
        <p:nvSpPr>
          <p:cNvPr id="42" name="object 40">
            <a:extLst>
              <a:ext uri="{FF2B5EF4-FFF2-40B4-BE49-F238E27FC236}">
                <a16:creationId xmlns:a16="http://schemas.microsoft.com/office/drawing/2014/main" id="{B88921B7-23C8-45FE-95E7-CEEBCCF82967}"/>
              </a:ext>
            </a:extLst>
          </p:cNvPr>
          <p:cNvSpPr txBox="1"/>
          <p:nvPr/>
        </p:nvSpPr>
        <p:spPr>
          <a:xfrm>
            <a:off x="414383" y="3034879"/>
            <a:ext cx="418322" cy="349071"/>
          </a:xfrm>
          <a:prstGeom prst="rect">
            <a:avLst/>
          </a:prstGeom>
        </p:spPr>
        <p:txBody>
          <a:bodyPr vert="horz" wrap="square" lIns="0" tIns="7938" rIns="0" bIns="0" rtlCol="0">
            <a:spAutoFit/>
          </a:bodyPr>
          <a:lstStyle/>
          <a:p>
            <a:pPr marL="7937" marR="3176" indent="32545">
              <a:lnSpc>
                <a:spcPct val="158000"/>
              </a:lnSpc>
              <a:spcBef>
                <a:spcPts val="63"/>
              </a:spcBef>
            </a:pPr>
            <a:r>
              <a:rPr sz="750" b="1" dirty="0">
                <a:solidFill>
                  <a:srgbClr val="4D4D4D"/>
                </a:solidFill>
                <a:latin typeface="Arial"/>
                <a:cs typeface="Arial"/>
              </a:rPr>
              <a:t>low Hcy </a:t>
            </a:r>
            <a:r>
              <a:rPr sz="750" b="1" spc="-200" dirty="0">
                <a:solidFill>
                  <a:srgbClr val="4D4D4D"/>
                </a:solidFill>
                <a:latin typeface="Arial"/>
                <a:cs typeface="Arial"/>
              </a:rPr>
              <a:t> </a:t>
            </a:r>
            <a:r>
              <a:rPr sz="750" b="1" dirty="0">
                <a:solidFill>
                  <a:srgbClr val="4D4D4D"/>
                </a:solidFill>
                <a:latin typeface="Arial"/>
                <a:cs typeface="Arial"/>
              </a:rPr>
              <a:t>high Hcy</a:t>
            </a:r>
            <a:endParaRPr sz="750">
              <a:latin typeface="Arial"/>
              <a:cs typeface="Arial"/>
            </a:endParaRPr>
          </a:p>
        </p:txBody>
      </p:sp>
      <p:sp>
        <p:nvSpPr>
          <p:cNvPr id="43" name="object 41">
            <a:extLst>
              <a:ext uri="{FF2B5EF4-FFF2-40B4-BE49-F238E27FC236}">
                <a16:creationId xmlns:a16="http://schemas.microsoft.com/office/drawing/2014/main" id="{4880C4DC-3C64-4BCD-87BC-502F1246B1F1}"/>
              </a:ext>
            </a:extLst>
          </p:cNvPr>
          <p:cNvSpPr txBox="1"/>
          <p:nvPr/>
        </p:nvSpPr>
        <p:spPr>
          <a:xfrm>
            <a:off x="427408" y="563892"/>
            <a:ext cx="179536" cy="1939203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7937">
              <a:lnSpc>
                <a:spcPts val="1444"/>
              </a:lnSpc>
            </a:pPr>
            <a:r>
              <a:rPr sz="1250" spc="-3" dirty="0">
                <a:latin typeface="Arial"/>
                <a:cs typeface="Arial"/>
              </a:rPr>
              <a:t>Survival</a:t>
            </a:r>
            <a:r>
              <a:rPr sz="1250" spc="-22" dirty="0">
                <a:latin typeface="Arial"/>
                <a:cs typeface="Arial"/>
              </a:rPr>
              <a:t> </a:t>
            </a:r>
            <a:r>
              <a:rPr sz="1250" dirty="0">
                <a:latin typeface="Arial"/>
                <a:cs typeface="Arial"/>
              </a:rPr>
              <a:t>free</a:t>
            </a:r>
            <a:r>
              <a:rPr sz="1250" spc="-16" dirty="0">
                <a:latin typeface="Arial"/>
                <a:cs typeface="Arial"/>
              </a:rPr>
              <a:t> </a:t>
            </a:r>
            <a:r>
              <a:rPr sz="1250" spc="-3" dirty="0">
                <a:latin typeface="Arial"/>
                <a:cs typeface="Arial"/>
              </a:rPr>
              <a:t>of</a:t>
            </a:r>
            <a:r>
              <a:rPr sz="1250" spc="-19" dirty="0">
                <a:latin typeface="Arial"/>
                <a:cs typeface="Arial"/>
              </a:rPr>
              <a:t> </a:t>
            </a:r>
            <a:r>
              <a:rPr sz="1250" dirty="0">
                <a:latin typeface="Arial"/>
                <a:cs typeface="Arial"/>
              </a:rPr>
              <a:t>MACCE(%)</a:t>
            </a:r>
          </a:p>
        </p:txBody>
      </p:sp>
      <p:sp>
        <p:nvSpPr>
          <p:cNvPr id="44" name="bg object 16">
            <a:extLst>
              <a:ext uri="{FF2B5EF4-FFF2-40B4-BE49-F238E27FC236}">
                <a16:creationId xmlns:a16="http://schemas.microsoft.com/office/drawing/2014/main" id="{965E2B8B-B008-4C26-A5C8-E47832474181}"/>
              </a:ext>
            </a:extLst>
          </p:cNvPr>
          <p:cNvSpPr/>
          <p:nvPr/>
        </p:nvSpPr>
        <p:spPr>
          <a:xfrm>
            <a:off x="1037584" y="628225"/>
            <a:ext cx="4197503" cy="1335933"/>
          </a:xfrm>
          <a:custGeom>
            <a:avLst/>
            <a:gdLst/>
            <a:ahLst/>
            <a:cxnLst/>
            <a:rect l="l" t="t" r="r" b="b"/>
            <a:pathLst>
              <a:path w="6715759" h="2137410">
                <a:moveTo>
                  <a:pt x="0" y="0"/>
                </a:moveTo>
                <a:lnTo>
                  <a:pt x="30734" y="0"/>
                </a:lnTo>
                <a:lnTo>
                  <a:pt x="30734" y="6731"/>
                </a:lnTo>
                <a:lnTo>
                  <a:pt x="34163" y="6731"/>
                </a:lnTo>
                <a:lnTo>
                  <a:pt x="34163" y="13589"/>
                </a:lnTo>
                <a:lnTo>
                  <a:pt x="37592" y="13589"/>
                </a:lnTo>
                <a:lnTo>
                  <a:pt x="37592" y="27051"/>
                </a:lnTo>
                <a:lnTo>
                  <a:pt x="41021" y="27051"/>
                </a:lnTo>
                <a:lnTo>
                  <a:pt x="41021" y="33909"/>
                </a:lnTo>
                <a:lnTo>
                  <a:pt x="44450" y="33909"/>
                </a:lnTo>
                <a:lnTo>
                  <a:pt x="44450" y="40640"/>
                </a:lnTo>
                <a:lnTo>
                  <a:pt x="47879" y="40640"/>
                </a:lnTo>
                <a:lnTo>
                  <a:pt x="47879" y="47371"/>
                </a:lnTo>
                <a:lnTo>
                  <a:pt x="51308" y="47371"/>
                </a:lnTo>
                <a:lnTo>
                  <a:pt x="51308" y="60960"/>
                </a:lnTo>
                <a:lnTo>
                  <a:pt x="58039" y="60960"/>
                </a:lnTo>
                <a:lnTo>
                  <a:pt x="58039" y="67818"/>
                </a:lnTo>
                <a:lnTo>
                  <a:pt x="61468" y="67818"/>
                </a:lnTo>
                <a:lnTo>
                  <a:pt x="61468" y="74549"/>
                </a:lnTo>
                <a:lnTo>
                  <a:pt x="88900" y="74549"/>
                </a:lnTo>
                <a:lnTo>
                  <a:pt x="88900" y="81280"/>
                </a:lnTo>
                <a:lnTo>
                  <a:pt x="92202" y="81280"/>
                </a:lnTo>
                <a:lnTo>
                  <a:pt x="92202" y="94869"/>
                </a:lnTo>
                <a:lnTo>
                  <a:pt x="95631" y="94869"/>
                </a:lnTo>
                <a:lnTo>
                  <a:pt x="95631" y="101600"/>
                </a:lnTo>
                <a:lnTo>
                  <a:pt x="102489" y="101600"/>
                </a:lnTo>
                <a:lnTo>
                  <a:pt x="102489" y="108457"/>
                </a:lnTo>
                <a:lnTo>
                  <a:pt x="105918" y="108457"/>
                </a:lnTo>
                <a:lnTo>
                  <a:pt x="105918" y="115189"/>
                </a:lnTo>
                <a:lnTo>
                  <a:pt x="116205" y="115189"/>
                </a:lnTo>
                <a:lnTo>
                  <a:pt x="116205" y="128778"/>
                </a:lnTo>
                <a:lnTo>
                  <a:pt x="119634" y="128778"/>
                </a:lnTo>
                <a:lnTo>
                  <a:pt x="119634" y="135509"/>
                </a:lnTo>
                <a:lnTo>
                  <a:pt x="133223" y="135509"/>
                </a:lnTo>
                <a:lnTo>
                  <a:pt x="133223" y="142367"/>
                </a:lnTo>
                <a:lnTo>
                  <a:pt x="140081" y="142367"/>
                </a:lnTo>
                <a:lnTo>
                  <a:pt x="140081" y="149098"/>
                </a:lnTo>
                <a:lnTo>
                  <a:pt x="143510" y="149098"/>
                </a:lnTo>
                <a:lnTo>
                  <a:pt x="143510" y="155829"/>
                </a:lnTo>
                <a:lnTo>
                  <a:pt x="146939" y="155829"/>
                </a:lnTo>
                <a:lnTo>
                  <a:pt x="146939" y="162687"/>
                </a:lnTo>
                <a:lnTo>
                  <a:pt x="170815" y="162687"/>
                </a:lnTo>
                <a:lnTo>
                  <a:pt x="170815" y="169418"/>
                </a:lnTo>
                <a:lnTo>
                  <a:pt x="174244" y="169418"/>
                </a:lnTo>
                <a:lnTo>
                  <a:pt x="174244" y="176276"/>
                </a:lnTo>
                <a:lnTo>
                  <a:pt x="177673" y="176276"/>
                </a:lnTo>
                <a:lnTo>
                  <a:pt x="177673" y="183007"/>
                </a:lnTo>
                <a:lnTo>
                  <a:pt x="208407" y="183007"/>
                </a:lnTo>
                <a:lnTo>
                  <a:pt x="208407" y="189738"/>
                </a:lnTo>
                <a:lnTo>
                  <a:pt x="211836" y="189738"/>
                </a:lnTo>
                <a:lnTo>
                  <a:pt x="211836" y="196596"/>
                </a:lnTo>
                <a:lnTo>
                  <a:pt x="218694" y="196596"/>
                </a:lnTo>
                <a:lnTo>
                  <a:pt x="218694" y="203327"/>
                </a:lnTo>
                <a:lnTo>
                  <a:pt x="252857" y="203327"/>
                </a:lnTo>
                <a:lnTo>
                  <a:pt x="252857" y="210185"/>
                </a:lnTo>
                <a:lnTo>
                  <a:pt x="263144" y="210185"/>
                </a:lnTo>
                <a:lnTo>
                  <a:pt x="263144" y="216915"/>
                </a:lnTo>
                <a:lnTo>
                  <a:pt x="314452" y="216915"/>
                </a:lnTo>
                <a:lnTo>
                  <a:pt x="314452" y="230504"/>
                </a:lnTo>
                <a:lnTo>
                  <a:pt x="362204" y="230504"/>
                </a:lnTo>
                <a:lnTo>
                  <a:pt x="362204" y="237236"/>
                </a:lnTo>
                <a:lnTo>
                  <a:pt x="382778" y="237236"/>
                </a:lnTo>
                <a:lnTo>
                  <a:pt x="382778" y="243967"/>
                </a:lnTo>
                <a:lnTo>
                  <a:pt x="386207" y="243967"/>
                </a:lnTo>
                <a:lnTo>
                  <a:pt x="386207" y="257556"/>
                </a:lnTo>
                <a:lnTo>
                  <a:pt x="396494" y="257556"/>
                </a:lnTo>
                <a:lnTo>
                  <a:pt x="396494" y="264414"/>
                </a:lnTo>
                <a:lnTo>
                  <a:pt x="399796" y="264414"/>
                </a:lnTo>
                <a:lnTo>
                  <a:pt x="423798" y="264414"/>
                </a:lnTo>
                <a:lnTo>
                  <a:pt x="423798" y="271145"/>
                </a:lnTo>
                <a:lnTo>
                  <a:pt x="437388" y="271145"/>
                </a:lnTo>
                <a:lnTo>
                  <a:pt x="437388" y="278003"/>
                </a:lnTo>
                <a:lnTo>
                  <a:pt x="447675" y="278003"/>
                </a:lnTo>
                <a:lnTo>
                  <a:pt x="454533" y="278003"/>
                </a:lnTo>
                <a:lnTo>
                  <a:pt x="454533" y="291592"/>
                </a:lnTo>
                <a:lnTo>
                  <a:pt x="457962" y="291592"/>
                </a:lnTo>
                <a:lnTo>
                  <a:pt x="464820" y="291592"/>
                </a:lnTo>
                <a:lnTo>
                  <a:pt x="471678" y="291592"/>
                </a:lnTo>
                <a:lnTo>
                  <a:pt x="474980" y="291592"/>
                </a:lnTo>
                <a:lnTo>
                  <a:pt x="474980" y="298323"/>
                </a:lnTo>
                <a:lnTo>
                  <a:pt x="481838" y="298323"/>
                </a:lnTo>
                <a:lnTo>
                  <a:pt x="485267" y="298323"/>
                </a:lnTo>
                <a:lnTo>
                  <a:pt x="492125" y="298323"/>
                </a:lnTo>
                <a:lnTo>
                  <a:pt x="492125" y="305181"/>
                </a:lnTo>
                <a:lnTo>
                  <a:pt x="502412" y="305181"/>
                </a:lnTo>
                <a:lnTo>
                  <a:pt x="512572" y="305181"/>
                </a:lnTo>
                <a:lnTo>
                  <a:pt x="512572" y="312166"/>
                </a:lnTo>
                <a:lnTo>
                  <a:pt x="522859" y="312166"/>
                </a:lnTo>
                <a:lnTo>
                  <a:pt x="526288" y="312166"/>
                </a:lnTo>
                <a:lnTo>
                  <a:pt x="529717" y="312166"/>
                </a:lnTo>
                <a:lnTo>
                  <a:pt x="533146" y="312166"/>
                </a:lnTo>
                <a:lnTo>
                  <a:pt x="533146" y="319024"/>
                </a:lnTo>
                <a:lnTo>
                  <a:pt x="540004" y="319024"/>
                </a:lnTo>
                <a:lnTo>
                  <a:pt x="546862" y="319024"/>
                </a:lnTo>
                <a:lnTo>
                  <a:pt x="550164" y="319024"/>
                </a:lnTo>
                <a:lnTo>
                  <a:pt x="560451" y="319024"/>
                </a:lnTo>
                <a:lnTo>
                  <a:pt x="577596" y="319024"/>
                </a:lnTo>
                <a:lnTo>
                  <a:pt x="594614" y="319024"/>
                </a:lnTo>
                <a:lnTo>
                  <a:pt x="598043" y="319024"/>
                </a:lnTo>
                <a:lnTo>
                  <a:pt x="598043" y="326009"/>
                </a:lnTo>
                <a:lnTo>
                  <a:pt x="601472" y="326009"/>
                </a:lnTo>
                <a:lnTo>
                  <a:pt x="615188" y="326009"/>
                </a:lnTo>
                <a:lnTo>
                  <a:pt x="618617" y="326009"/>
                </a:lnTo>
                <a:lnTo>
                  <a:pt x="625475" y="326009"/>
                </a:lnTo>
                <a:lnTo>
                  <a:pt x="625475" y="332994"/>
                </a:lnTo>
                <a:lnTo>
                  <a:pt x="632206" y="332994"/>
                </a:lnTo>
                <a:lnTo>
                  <a:pt x="632206" y="339979"/>
                </a:lnTo>
                <a:lnTo>
                  <a:pt x="645922" y="339979"/>
                </a:lnTo>
                <a:lnTo>
                  <a:pt x="659638" y="339979"/>
                </a:lnTo>
                <a:lnTo>
                  <a:pt x="659638" y="346964"/>
                </a:lnTo>
                <a:lnTo>
                  <a:pt x="669798" y="346964"/>
                </a:lnTo>
                <a:lnTo>
                  <a:pt x="669798" y="353949"/>
                </a:lnTo>
                <a:lnTo>
                  <a:pt x="673227" y="353949"/>
                </a:lnTo>
                <a:lnTo>
                  <a:pt x="686943" y="353949"/>
                </a:lnTo>
                <a:lnTo>
                  <a:pt x="693801" y="353949"/>
                </a:lnTo>
                <a:lnTo>
                  <a:pt x="697230" y="353949"/>
                </a:lnTo>
                <a:lnTo>
                  <a:pt x="697230" y="368173"/>
                </a:lnTo>
                <a:lnTo>
                  <a:pt x="700659" y="368173"/>
                </a:lnTo>
                <a:lnTo>
                  <a:pt x="707390" y="368173"/>
                </a:lnTo>
                <a:lnTo>
                  <a:pt x="714248" y="368173"/>
                </a:lnTo>
                <a:lnTo>
                  <a:pt x="717677" y="368173"/>
                </a:lnTo>
                <a:lnTo>
                  <a:pt x="721106" y="368173"/>
                </a:lnTo>
                <a:lnTo>
                  <a:pt x="741553" y="368173"/>
                </a:lnTo>
                <a:lnTo>
                  <a:pt x="741553" y="375285"/>
                </a:lnTo>
                <a:lnTo>
                  <a:pt x="748411" y="375285"/>
                </a:lnTo>
                <a:lnTo>
                  <a:pt x="751840" y="375285"/>
                </a:lnTo>
                <a:lnTo>
                  <a:pt x="755269" y="375285"/>
                </a:lnTo>
                <a:lnTo>
                  <a:pt x="758698" y="375285"/>
                </a:lnTo>
                <a:lnTo>
                  <a:pt x="758698" y="389636"/>
                </a:lnTo>
                <a:lnTo>
                  <a:pt x="768985" y="389636"/>
                </a:lnTo>
                <a:lnTo>
                  <a:pt x="775843" y="389636"/>
                </a:lnTo>
                <a:lnTo>
                  <a:pt x="779145" y="389636"/>
                </a:lnTo>
                <a:lnTo>
                  <a:pt x="782574" y="389636"/>
                </a:lnTo>
                <a:lnTo>
                  <a:pt x="806577" y="389636"/>
                </a:lnTo>
                <a:lnTo>
                  <a:pt x="816737" y="389636"/>
                </a:lnTo>
                <a:lnTo>
                  <a:pt x="816737" y="396875"/>
                </a:lnTo>
                <a:lnTo>
                  <a:pt x="823594" y="396875"/>
                </a:lnTo>
                <a:lnTo>
                  <a:pt x="827024" y="396875"/>
                </a:lnTo>
                <a:lnTo>
                  <a:pt x="844169" y="396875"/>
                </a:lnTo>
                <a:lnTo>
                  <a:pt x="847597" y="396875"/>
                </a:lnTo>
                <a:lnTo>
                  <a:pt x="847597" y="404114"/>
                </a:lnTo>
                <a:lnTo>
                  <a:pt x="854456" y="404114"/>
                </a:lnTo>
                <a:lnTo>
                  <a:pt x="857758" y="404114"/>
                </a:lnTo>
                <a:lnTo>
                  <a:pt x="857758" y="411353"/>
                </a:lnTo>
                <a:lnTo>
                  <a:pt x="861187" y="411353"/>
                </a:lnTo>
                <a:lnTo>
                  <a:pt x="864616" y="411353"/>
                </a:lnTo>
                <a:lnTo>
                  <a:pt x="864616" y="425958"/>
                </a:lnTo>
                <a:lnTo>
                  <a:pt x="868044" y="425958"/>
                </a:lnTo>
                <a:lnTo>
                  <a:pt x="868044" y="433323"/>
                </a:lnTo>
                <a:lnTo>
                  <a:pt x="871474" y="433323"/>
                </a:lnTo>
                <a:lnTo>
                  <a:pt x="874903" y="433323"/>
                </a:lnTo>
                <a:lnTo>
                  <a:pt x="874903" y="440690"/>
                </a:lnTo>
                <a:lnTo>
                  <a:pt x="881761" y="440690"/>
                </a:lnTo>
                <a:lnTo>
                  <a:pt x="881761" y="447929"/>
                </a:lnTo>
                <a:lnTo>
                  <a:pt x="888619" y="447929"/>
                </a:lnTo>
                <a:lnTo>
                  <a:pt x="892047" y="447929"/>
                </a:lnTo>
                <a:lnTo>
                  <a:pt x="912494" y="447929"/>
                </a:lnTo>
                <a:lnTo>
                  <a:pt x="926211" y="447929"/>
                </a:lnTo>
                <a:lnTo>
                  <a:pt x="926211" y="455295"/>
                </a:lnTo>
                <a:lnTo>
                  <a:pt x="932941" y="455295"/>
                </a:lnTo>
                <a:lnTo>
                  <a:pt x="932941" y="462661"/>
                </a:lnTo>
                <a:lnTo>
                  <a:pt x="946658" y="462661"/>
                </a:lnTo>
                <a:lnTo>
                  <a:pt x="953516" y="462661"/>
                </a:lnTo>
                <a:lnTo>
                  <a:pt x="956944" y="462661"/>
                </a:lnTo>
                <a:lnTo>
                  <a:pt x="956944" y="477520"/>
                </a:lnTo>
                <a:lnTo>
                  <a:pt x="963803" y="477520"/>
                </a:lnTo>
                <a:lnTo>
                  <a:pt x="963803" y="484886"/>
                </a:lnTo>
                <a:lnTo>
                  <a:pt x="967232" y="484886"/>
                </a:lnTo>
                <a:lnTo>
                  <a:pt x="980821" y="484886"/>
                </a:lnTo>
                <a:lnTo>
                  <a:pt x="984250" y="484886"/>
                </a:lnTo>
                <a:lnTo>
                  <a:pt x="987679" y="484886"/>
                </a:lnTo>
                <a:lnTo>
                  <a:pt x="991108" y="484886"/>
                </a:lnTo>
                <a:lnTo>
                  <a:pt x="991108" y="492252"/>
                </a:lnTo>
                <a:lnTo>
                  <a:pt x="1032129" y="492252"/>
                </a:lnTo>
                <a:lnTo>
                  <a:pt x="1032129" y="499745"/>
                </a:lnTo>
                <a:lnTo>
                  <a:pt x="1042416" y="499745"/>
                </a:lnTo>
                <a:lnTo>
                  <a:pt x="1045718" y="499745"/>
                </a:lnTo>
                <a:lnTo>
                  <a:pt x="1045718" y="507238"/>
                </a:lnTo>
                <a:lnTo>
                  <a:pt x="1056005" y="507238"/>
                </a:lnTo>
                <a:lnTo>
                  <a:pt x="1059434" y="507238"/>
                </a:lnTo>
                <a:lnTo>
                  <a:pt x="1062863" y="507238"/>
                </a:lnTo>
                <a:lnTo>
                  <a:pt x="1069721" y="507238"/>
                </a:lnTo>
                <a:lnTo>
                  <a:pt x="1069721" y="514731"/>
                </a:lnTo>
                <a:lnTo>
                  <a:pt x="1073150" y="514731"/>
                </a:lnTo>
                <a:lnTo>
                  <a:pt x="1073150" y="522223"/>
                </a:lnTo>
                <a:lnTo>
                  <a:pt x="1080008" y="522223"/>
                </a:lnTo>
                <a:lnTo>
                  <a:pt x="1090168" y="522223"/>
                </a:lnTo>
                <a:lnTo>
                  <a:pt x="1090168" y="537210"/>
                </a:lnTo>
                <a:lnTo>
                  <a:pt x="1100455" y="537210"/>
                </a:lnTo>
                <a:lnTo>
                  <a:pt x="1103884" y="537210"/>
                </a:lnTo>
                <a:lnTo>
                  <a:pt x="1103884" y="544703"/>
                </a:lnTo>
                <a:lnTo>
                  <a:pt x="1107313" y="544703"/>
                </a:lnTo>
                <a:lnTo>
                  <a:pt x="1110742" y="544703"/>
                </a:lnTo>
                <a:lnTo>
                  <a:pt x="1110742" y="552196"/>
                </a:lnTo>
                <a:lnTo>
                  <a:pt x="1127760" y="552196"/>
                </a:lnTo>
                <a:lnTo>
                  <a:pt x="1131189" y="552196"/>
                </a:lnTo>
                <a:lnTo>
                  <a:pt x="1131189" y="559816"/>
                </a:lnTo>
                <a:lnTo>
                  <a:pt x="1141476" y="559816"/>
                </a:lnTo>
                <a:lnTo>
                  <a:pt x="1148334" y="559816"/>
                </a:lnTo>
                <a:lnTo>
                  <a:pt x="1148334" y="567309"/>
                </a:lnTo>
                <a:lnTo>
                  <a:pt x="1168781" y="567309"/>
                </a:lnTo>
                <a:lnTo>
                  <a:pt x="1172210" y="567309"/>
                </a:lnTo>
                <a:lnTo>
                  <a:pt x="1182497" y="567309"/>
                </a:lnTo>
                <a:lnTo>
                  <a:pt x="1182497" y="574929"/>
                </a:lnTo>
                <a:lnTo>
                  <a:pt x="1185926" y="574929"/>
                </a:lnTo>
                <a:lnTo>
                  <a:pt x="1189355" y="574929"/>
                </a:lnTo>
                <a:lnTo>
                  <a:pt x="1189355" y="582422"/>
                </a:lnTo>
                <a:lnTo>
                  <a:pt x="1196213" y="582422"/>
                </a:lnTo>
                <a:lnTo>
                  <a:pt x="1196213" y="590042"/>
                </a:lnTo>
                <a:lnTo>
                  <a:pt x="1220089" y="590042"/>
                </a:lnTo>
                <a:lnTo>
                  <a:pt x="1220089" y="597662"/>
                </a:lnTo>
                <a:lnTo>
                  <a:pt x="1223518" y="597662"/>
                </a:lnTo>
                <a:lnTo>
                  <a:pt x="1223518" y="612775"/>
                </a:lnTo>
                <a:lnTo>
                  <a:pt x="1226947" y="612775"/>
                </a:lnTo>
                <a:lnTo>
                  <a:pt x="1226947" y="628015"/>
                </a:lnTo>
                <a:lnTo>
                  <a:pt x="1243965" y="628015"/>
                </a:lnTo>
                <a:lnTo>
                  <a:pt x="1243965" y="635635"/>
                </a:lnTo>
                <a:lnTo>
                  <a:pt x="1247394" y="635635"/>
                </a:lnTo>
                <a:lnTo>
                  <a:pt x="1247394" y="643128"/>
                </a:lnTo>
                <a:lnTo>
                  <a:pt x="1250823" y="643128"/>
                </a:lnTo>
                <a:lnTo>
                  <a:pt x="1250823" y="665988"/>
                </a:lnTo>
                <a:lnTo>
                  <a:pt x="1254252" y="665988"/>
                </a:lnTo>
                <a:lnTo>
                  <a:pt x="1257681" y="665988"/>
                </a:lnTo>
                <a:lnTo>
                  <a:pt x="1261110" y="665988"/>
                </a:lnTo>
                <a:lnTo>
                  <a:pt x="1261110" y="673608"/>
                </a:lnTo>
                <a:lnTo>
                  <a:pt x="1264539" y="673608"/>
                </a:lnTo>
                <a:lnTo>
                  <a:pt x="1264539" y="681228"/>
                </a:lnTo>
                <a:lnTo>
                  <a:pt x="1267968" y="681228"/>
                </a:lnTo>
                <a:lnTo>
                  <a:pt x="1267968" y="696468"/>
                </a:lnTo>
                <a:lnTo>
                  <a:pt x="1271397" y="696468"/>
                </a:lnTo>
                <a:lnTo>
                  <a:pt x="1271397" y="711708"/>
                </a:lnTo>
                <a:lnTo>
                  <a:pt x="1274826" y="711708"/>
                </a:lnTo>
                <a:lnTo>
                  <a:pt x="1278128" y="711708"/>
                </a:lnTo>
                <a:lnTo>
                  <a:pt x="1284986" y="711708"/>
                </a:lnTo>
                <a:lnTo>
                  <a:pt x="1288415" y="711708"/>
                </a:lnTo>
                <a:lnTo>
                  <a:pt x="1288415" y="719455"/>
                </a:lnTo>
                <a:lnTo>
                  <a:pt x="1291844" y="719455"/>
                </a:lnTo>
                <a:lnTo>
                  <a:pt x="1298702" y="719455"/>
                </a:lnTo>
                <a:lnTo>
                  <a:pt x="1298702" y="727075"/>
                </a:lnTo>
                <a:lnTo>
                  <a:pt x="1312418" y="727075"/>
                </a:lnTo>
                <a:lnTo>
                  <a:pt x="1315720" y="727075"/>
                </a:lnTo>
                <a:lnTo>
                  <a:pt x="1326007" y="727075"/>
                </a:lnTo>
                <a:lnTo>
                  <a:pt x="1326007" y="734949"/>
                </a:lnTo>
                <a:lnTo>
                  <a:pt x="1336294" y="734949"/>
                </a:lnTo>
                <a:lnTo>
                  <a:pt x="1339723" y="734949"/>
                </a:lnTo>
                <a:lnTo>
                  <a:pt x="1339723" y="742823"/>
                </a:lnTo>
                <a:lnTo>
                  <a:pt x="1343152" y="742823"/>
                </a:lnTo>
                <a:lnTo>
                  <a:pt x="1346581" y="742823"/>
                </a:lnTo>
                <a:lnTo>
                  <a:pt x="1346581" y="750697"/>
                </a:lnTo>
                <a:lnTo>
                  <a:pt x="1350010" y="750697"/>
                </a:lnTo>
                <a:lnTo>
                  <a:pt x="1353312" y="750697"/>
                </a:lnTo>
                <a:lnTo>
                  <a:pt x="1356741" y="750697"/>
                </a:lnTo>
                <a:lnTo>
                  <a:pt x="1370457" y="750697"/>
                </a:lnTo>
                <a:lnTo>
                  <a:pt x="1373886" y="750697"/>
                </a:lnTo>
                <a:lnTo>
                  <a:pt x="1380744" y="750697"/>
                </a:lnTo>
                <a:lnTo>
                  <a:pt x="1380744" y="758698"/>
                </a:lnTo>
                <a:lnTo>
                  <a:pt x="1384173" y="758698"/>
                </a:lnTo>
                <a:lnTo>
                  <a:pt x="1384173" y="766826"/>
                </a:lnTo>
                <a:lnTo>
                  <a:pt x="1387602" y="766826"/>
                </a:lnTo>
                <a:lnTo>
                  <a:pt x="1387602" y="774827"/>
                </a:lnTo>
                <a:lnTo>
                  <a:pt x="1394333" y="774827"/>
                </a:lnTo>
                <a:lnTo>
                  <a:pt x="1394333" y="782828"/>
                </a:lnTo>
                <a:lnTo>
                  <a:pt x="1397762" y="782828"/>
                </a:lnTo>
                <a:lnTo>
                  <a:pt x="1401191" y="782828"/>
                </a:lnTo>
                <a:lnTo>
                  <a:pt x="1408049" y="782828"/>
                </a:lnTo>
                <a:lnTo>
                  <a:pt x="1408049" y="790956"/>
                </a:lnTo>
                <a:lnTo>
                  <a:pt x="1411478" y="790956"/>
                </a:lnTo>
                <a:lnTo>
                  <a:pt x="1418336" y="790956"/>
                </a:lnTo>
                <a:lnTo>
                  <a:pt x="1425194" y="790956"/>
                </a:lnTo>
                <a:lnTo>
                  <a:pt x="1425194" y="799084"/>
                </a:lnTo>
                <a:lnTo>
                  <a:pt x="1442212" y="799084"/>
                </a:lnTo>
                <a:lnTo>
                  <a:pt x="1449070" y="799084"/>
                </a:lnTo>
                <a:lnTo>
                  <a:pt x="1452499" y="799084"/>
                </a:lnTo>
                <a:lnTo>
                  <a:pt x="1452499" y="807339"/>
                </a:lnTo>
                <a:lnTo>
                  <a:pt x="1459357" y="807339"/>
                </a:lnTo>
                <a:lnTo>
                  <a:pt x="1462786" y="807339"/>
                </a:lnTo>
                <a:lnTo>
                  <a:pt x="1466088" y="807339"/>
                </a:lnTo>
                <a:lnTo>
                  <a:pt x="1472946" y="807339"/>
                </a:lnTo>
                <a:lnTo>
                  <a:pt x="1479804" y="807339"/>
                </a:lnTo>
                <a:lnTo>
                  <a:pt x="1479804" y="815721"/>
                </a:lnTo>
                <a:lnTo>
                  <a:pt x="1483233" y="815721"/>
                </a:lnTo>
                <a:lnTo>
                  <a:pt x="1493520" y="815721"/>
                </a:lnTo>
                <a:lnTo>
                  <a:pt x="1496949" y="815721"/>
                </a:lnTo>
                <a:lnTo>
                  <a:pt x="1503807" y="815721"/>
                </a:lnTo>
                <a:lnTo>
                  <a:pt x="1507109" y="815721"/>
                </a:lnTo>
                <a:lnTo>
                  <a:pt x="1513967" y="815721"/>
                </a:lnTo>
                <a:lnTo>
                  <a:pt x="1513967" y="824230"/>
                </a:lnTo>
                <a:lnTo>
                  <a:pt x="1517396" y="824230"/>
                </a:lnTo>
                <a:lnTo>
                  <a:pt x="1527683" y="824230"/>
                </a:lnTo>
                <a:lnTo>
                  <a:pt x="1531112" y="824230"/>
                </a:lnTo>
                <a:lnTo>
                  <a:pt x="1534541" y="824230"/>
                </a:lnTo>
                <a:lnTo>
                  <a:pt x="1544701" y="824230"/>
                </a:lnTo>
                <a:lnTo>
                  <a:pt x="1544701" y="832866"/>
                </a:lnTo>
                <a:lnTo>
                  <a:pt x="1554988" y="832866"/>
                </a:lnTo>
                <a:lnTo>
                  <a:pt x="1554988" y="841629"/>
                </a:lnTo>
                <a:lnTo>
                  <a:pt x="1572133" y="841629"/>
                </a:lnTo>
                <a:lnTo>
                  <a:pt x="1572133" y="850265"/>
                </a:lnTo>
                <a:lnTo>
                  <a:pt x="1578991" y="850265"/>
                </a:lnTo>
                <a:lnTo>
                  <a:pt x="1578991" y="858901"/>
                </a:lnTo>
                <a:lnTo>
                  <a:pt x="1592580" y="858901"/>
                </a:lnTo>
                <a:lnTo>
                  <a:pt x="1592580" y="867537"/>
                </a:lnTo>
                <a:lnTo>
                  <a:pt x="1613154" y="867537"/>
                </a:lnTo>
                <a:lnTo>
                  <a:pt x="1616583" y="867537"/>
                </a:lnTo>
                <a:lnTo>
                  <a:pt x="1626743" y="867537"/>
                </a:lnTo>
                <a:lnTo>
                  <a:pt x="1633601" y="867537"/>
                </a:lnTo>
                <a:lnTo>
                  <a:pt x="1637030" y="867537"/>
                </a:lnTo>
                <a:lnTo>
                  <a:pt x="1640458" y="867537"/>
                </a:lnTo>
                <a:lnTo>
                  <a:pt x="1650745" y="867537"/>
                </a:lnTo>
                <a:lnTo>
                  <a:pt x="1654175" y="867537"/>
                </a:lnTo>
                <a:lnTo>
                  <a:pt x="1657477" y="867537"/>
                </a:lnTo>
                <a:lnTo>
                  <a:pt x="1674622" y="867537"/>
                </a:lnTo>
                <a:lnTo>
                  <a:pt x="1678051" y="867537"/>
                </a:lnTo>
                <a:lnTo>
                  <a:pt x="1678051" y="876427"/>
                </a:lnTo>
                <a:lnTo>
                  <a:pt x="1688338" y="876427"/>
                </a:lnTo>
                <a:lnTo>
                  <a:pt x="1688338" y="894334"/>
                </a:lnTo>
                <a:lnTo>
                  <a:pt x="1708785" y="894334"/>
                </a:lnTo>
                <a:lnTo>
                  <a:pt x="1708785" y="903224"/>
                </a:lnTo>
                <a:lnTo>
                  <a:pt x="1719072" y="903224"/>
                </a:lnTo>
                <a:lnTo>
                  <a:pt x="1719072" y="912113"/>
                </a:lnTo>
                <a:lnTo>
                  <a:pt x="1722501" y="912113"/>
                </a:lnTo>
                <a:lnTo>
                  <a:pt x="1732788" y="912113"/>
                </a:lnTo>
                <a:lnTo>
                  <a:pt x="1739519" y="912113"/>
                </a:lnTo>
                <a:lnTo>
                  <a:pt x="1749806" y="912113"/>
                </a:lnTo>
                <a:lnTo>
                  <a:pt x="1760093" y="912113"/>
                </a:lnTo>
                <a:lnTo>
                  <a:pt x="1760093" y="921131"/>
                </a:lnTo>
                <a:lnTo>
                  <a:pt x="1770380" y="921131"/>
                </a:lnTo>
                <a:lnTo>
                  <a:pt x="1773682" y="921131"/>
                </a:lnTo>
                <a:lnTo>
                  <a:pt x="1773682" y="930147"/>
                </a:lnTo>
                <a:lnTo>
                  <a:pt x="1777111" y="930147"/>
                </a:lnTo>
                <a:lnTo>
                  <a:pt x="1801114" y="930147"/>
                </a:lnTo>
                <a:lnTo>
                  <a:pt x="1804543" y="930147"/>
                </a:lnTo>
                <a:lnTo>
                  <a:pt x="1811274" y="930147"/>
                </a:lnTo>
                <a:lnTo>
                  <a:pt x="1818132" y="930147"/>
                </a:lnTo>
                <a:lnTo>
                  <a:pt x="1818132" y="939291"/>
                </a:lnTo>
                <a:lnTo>
                  <a:pt x="1821561" y="939291"/>
                </a:lnTo>
                <a:lnTo>
                  <a:pt x="1821561" y="948309"/>
                </a:lnTo>
                <a:lnTo>
                  <a:pt x="1842135" y="948309"/>
                </a:lnTo>
                <a:lnTo>
                  <a:pt x="1842135" y="957453"/>
                </a:lnTo>
                <a:lnTo>
                  <a:pt x="1845564" y="957453"/>
                </a:lnTo>
                <a:lnTo>
                  <a:pt x="1845564" y="957453"/>
                </a:lnTo>
                <a:lnTo>
                  <a:pt x="1879727" y="957453"/>
                </a:lnTo>
                <a:lnTo>
                  <a:pt x="1883156" y="957453"/>
                </a:lnTo>
                <a:lnTo>
                  <a:pt x="1893316" y="957453"/>
                </a:lnTo>
                <a:lnTo>
                  <a:pt x="1896745" y="957453"/>
                </a:lnTo>
                <a:lnTo>
                  <a:pt x="1913889" y="957453"/>
                </a:lnTo>
                <a:lnTo>
                  <a:pt x="1917319" y="957453"/>
                </a:lnTo>
                <a:lnTo>
                  <a:pt x="1917319" y="966597"/>
                </a:lnTo>
                <a:lnTo>
                  <a:pt x="1927479" y="966597"/>
                </a:lnTo>
                <a:lnTo>
                  <a:pt x="1927479" y="975868"/>
                </a:lnTo>
                <a:lnTo>
                  <a:pt x="1937766" y="975868"/>
                </a:lnTo>
                <a:lnTo>
                  <a:pt x="1961769" y="975868"/>
                </a:lnTo>
                <a:lnTo>
                  <a:pt x="1965070" y="975868"/>
                </a:lnTo>
                <a:lnTo>
                  <a:pt x="1971929" y="975868"/>
                </a:lnTo>
                <a:lnTo>
                  <a:pt x="1975358" y="975868"/>
                </a:lnTo>
                <a:lnTo>
                  <a:pt x="1975358" y="985138"/>
                </a:lnTo>
                <a:lnTo>
                  <a:pt x="1985645" y="985138"/>
                </a:lnTo>
                <a:lnTo>
                  <a:pt x="1985645" y="994410"/>
                </a:lnTo>
                <a:lnTo>
                  <a:pt x="1989074" y="994410"/>
                </a:lnTo>
                <a:lnTo>
                  <a:pt x="1989074" y="1003681"/>
                </a:lnTo>
                <a:lnTo>
                  <a:pt x="2002663" y="1003681"/>
                </a:lnTo>
                <a:lnTo>
                  <a:pt x="2002663" y="1013079"/>
                </a:lnTo>
                <a:lnTo>
                  <a:pt x="2023237" y="1013079"/>
                </a:lnTo>
                <a:lnTo>
                  <a:pt x="2030095" y="1013079"/>
                </a:lnTo>
                <a:lnTo>
                  <a:pt x="2040255" y="1013079"/>
                </a:lnTo>
                <a:lnTo>
                  <a:pt x="2040255" y="1022350"/>
                </a:lnTo>
                <a:lnTo>
                  <a:pt x="2060829" y="1022350"/>
                </a:lnTo>
                <a:lnTo>
                  <a:pt x="2064258" y="1022350"/>
                </a:lnTo>
                <a:lnTo>
                  <a:pt x="2088133" y="1022350"/>
                </a:lnTo>
                <a:lnTo>
                  <a:pt x="2088133" y="1031747"/>
                </a:lnTo>
                <a:lnTo>
                  <a:pt x="2094992" y="1031747"/>
                </a:lnTo>
                <a:lnTo>
                  <a:pt x="2098421" y="1031747"/>
                </a:lnTo>
                <a:lnTo>
                  <a:pt x="2101850" y="1031747"/>
                </a:lnTo>
                <a:lnTo>
                  <a:pt x="2105279" y="1031747"/>
                </a:lnTo>
                <a:lnTo>
                  <a:pt x="2108708" y="1031747"/>
                </a:lnTo>
                <a:lnTo>
                  <a:pt x="2112137" y="1031747"/>
                </a:lnTo>
                <a:lnTo>
                  <a:pt x="2115439" y="1031747"/>
                </a:lnTo>
                <a:lnTo>
                  <a:pt x="2132584" y="1031747"/>
                </a:lnTo>
                <a:lnTo>
                  <a:pt x="2136013" y="1031747"/>
                </a:lnTo>
                <a:lnTo>
                  <a:pt x="2136013" y="1041272"/>
                </a:lnTo>
                <a:lnTo>
                  <a:pt x="2146300" y="1041272"/>
                </a:lnTo>
                <a:lnTo>
                  <a:pt x="2149729" y="1041272"/>
                </a:lnTo>
                <a:lnTo>
                  <a:pt x="2153158" y="1041272"/>
                </a:lnTo>
                <a:lnTo>
                  <a:pt x="2156460" y="1041272"/>
                </a:lnTo>
                <a:lnTo>
                  <a:pt x="2159889" y="1041272"/>
                </a:lnTo>
                <a:lnTo>
                  <a:pt x="2159889" y="1051052"/>
                </a:lnTo>
                <a:lnTo>
                  <a:pt x="2166747" y="1051052"/>
                </a:lnTo>
                <a:lnTo>
                  <a:pt x="2166747" y="1060704"/>
                </a:lnTo>
                <a:lnTo>
                  <a:pt x="2173605" y="1060704"/>
                </a:lnTo>
                <a:lnTo>
                  <a:pt x="2177034" y="1060704"/>
                </a:lnTo>
                <a:lnTo>
                  <a:pt x="2204339" y="1060704"/>
                </a:lnTo>
                <a:lnTo>
                  <a:pt x="2214626" y="1060704"/>
                </a:lnTo>
                <a:lnTo>
                  <a:pt x="2218055" y="1060704"/>
                </a:lnTo>
                <a:lnTo>
                  <a:pt x="2221484" y="1060704"/>
                </a:lnTo>
                <a:lnTo>
                  <a:pt x="2224913" y="1060704"/>
                </a:lnTo>
                <a:lnTo>
                  <a:pt x="2241931" y="1060704"/>
                </a:lnTo>
                <a:lnTo>
                  <a:pt x="2241931" y="1070610"/>
                </a:lnTo>
                <a:lnTo>
                  <a:pt x="2245360" y="1070610"/>
                </a:lnTo>
                <a:lnTo>
                  <a:pt x="2248789" y="1070610"/>
                </a:lnTo>
                <a:lnTo>
                  <a:pt x="2248789" y="1080516"/>
                </a:lnTo>
                <a:lnTo>
                  <a:pt x="2252218" y="1080516"/>
                </a:lnTo>
                <a:lnTo>
                  <a:pt x="2269236" y="1080516"/>
                </a:lnTo>
                <a:lnTo>
                  <a:pt x="2269236" y="1090422"/>
                </a:lnTo>
                <a:lnTo>
                  <a:pt x="2279523" y="1090422"/>
                </a:lnTo>
                <a:lnTo>
                  <a:pt x="2279523" y="1110234"/>
                </a:lnTo>
                <a:lnTo>
                  <a:pt x="2317115" y="1110234"/>
                </a:lnTo>
                <a:lnTo>
                  <a:pt x="2327402" y="1110234"/>
                </a:lnTo>
                <a:lnTo>
                  <a:pt x="2330831" y="1110234"/>
                </a:lnTo>
                <a:lnTo>
                  <a:pt x="2337689" y="1110234"/>
                </a:lnTo>
                <a:lnTo>
                  <a:pt x="2337689" y="1120267"/>
                </a:lnTo>
                <a:lnTo>
                  <a:pt x="2364994" y="1120267"/>
                </a:lnTo>
                <a:lnTo>
                  <a:pt x="2368423" y="1120267"/>
                </a:lnTo>
                <a:lnTo>
                  <a:pt x="2368423" y="1130300"/>
                </a:lnTo>
                <a:lnTo>
                  <a:pt x="2378710" y="1130300"/>
                </a:lnTo>
                <a:lnTo>
                  <a:pt x="2378710" y="1140333"/>
                </a:lnTo>
                <a:lnTo>
                  <a:pt x="2385441" y="1140333"/>
                </a:lnTo>
                <a:lnTo>
                  <a:pt x="2395728" y="1140333"/>
                </a:lnTo>
                <a:lnTo>
                  <a:pt x="2416302" y="1140333"/>
                </a:lnTo>
                <a:lnTo>
                  <a:pt x="2416302" y="1150493"/>
                </a:lnTo>
                <a:lnTo>
                  <a:pt x="2419731" y="1150493"/>
                </a:lnTo>
                <a:lnTo>
                  <a:pt x="2423033" y="1150493"/>
                </a:lnTo>
                <a:lnTo>
                  <a:pt x="2423033" y="1160526"/>
                </a:lnTo>
                <a:lnTo>
                  <a:pt x="2426462" y="1160526"/>
                </a:lnTo>
                <a:lnTo>
                  <a:pt x="2429891" y="1160526"/>
                </a:lnTo>
                <a:lnTo>
                  <a:pt x="2429891" y="1170813"/>
                </a:lnTo>
                <a:lnTo>
                  <a:pt x="2436749" y="1170813"/>
                </a:lnTo>
                <a:lnTo>
                  <a:pt x="2440178" y="1170813"/>
                </a:lnTo>
                <a:lnTo>
                  <a:pt x="2453894" y="1170813"/>
                </a:lnTo>
                <a:lnTo>
                  <a:pt x="2470912" y="1170813"/>
                </a:lnTo>
                <a:lnTo>
                  <a:pt x="2470912" y="1181100"/>
                </a:lnTo>
                <a:lnTo>
                  <a:pt x="2474341" y="1181100"/>
                </a:lnTo>
                <a:lnTo>
                  <a:pt x="2484628" y="1181100"/>
                </a:lnTo>
                <a:lnTo>
                  <a:pt x="2488057" y="1181100"/>
                </a:lnTo>
                <a:lnTo>
                  <a:pt x="2491486" y="1181100"/>
                </a:lnTo>
                <a:lnTo>
                  <a:pt x="2508504" y="1181100"/>
                </a:lnTo>
                <a:lnTo>
                  <a:pt x="2518791" y="1181100"/>
                </a:lnTo>
                <a:lnTo>
                  <a:pt x="2518791" y="1191514"/>
                </a:lnTo>
                <a:lnTo>
                  <a:pt x="2529078" y="1191514"/>
                </a:lnTo>
                <a:lnTo>
                  <a:pt x="2532507" y="1191514"/>
                </a:lnTo>
                <a:lnTo>
                  <a:pt x="2535809" y="1191514"/>
                </a:lnTo>
                <a:lnTo>
                  <a:pt x="2539238" y="1191514"/>
                </a:lnTo>
                <a:lnTo>
                  <a:pt x="2542667" y="1191514"/>
                </a:lnTo>
                <a:lnTo>
                  <a:pt x="2549525" y="1191514"/>
                </a:lnTo>
                <a:lnTo>
                  <a:pt x="2552954" y="1191514"/>
                </a:lnTo>
                <a:lnTo>
                  <a:pt x="2570099" y="1191514"/>
                </a:lnTo>
                <a:lnTo>
                  <a:pt x="2576830" y="1191514"/>
                </a:lnTo>
                <a:lnTo>
                  <a:pt x="2580259" y="1191514"/>
                </a:lnTo>
                <a:lnTo>
                  <a:pt x="2604262" y="1191514"/>
                </a:lnTo>
                <a:lnTo>
                  <a:pt x="2604262" y="1202182"/>
                </a:lnTo>
                <a:lnTo>
                  <a:pt x="2611120" y="1202182"/>
                </a:lnTo>
                <a:lnTo>
                  <a:pt x="2621280" y="1202182"/>
                </a:lnTo>
                <a:lnTo>
                  <a:pt x="2621280" y="1212850"/>
                </a:lnTo>
                <a:lnTo>
                  <a:pt x="2628138" y="1212850"/>
                </a:lnTo>
                <a:lnTo>
                  <a:pt x="2631567" y="1212850"/>
                </a:lnTo>
                <a:lnTo>
                  <a:pt x="2641854" y="1212850"/>
                </a:lnTo>
                <a:lnTo>
                  <a:pt x="2648712" y="1212850"/>
                </a:lnTo>
                <a:lnTo>
                  <a:pt x="2648712" y="1223645"/>
                </a:lnTo>
                <a:lnTo>
                  <a:pt x="2652014" y="1223645"/>
                </a:lnTo>
                <a:lnTo>
                  <a:pt x="2665730" y="1223645"/>
                </a:lnTo>
                <a:lnTo>
                  <a:pt x="2665730" y="1234440"/>
                </a:lnTo>
                <a:lnTo>
                  <a:pt x="2676017" y="1234440"/>
                </a:lnTo>
                <a:lnTo>
                  <a:pt x="2676017" y="1245108"/>
                </a:lnTo>
                <a:lnTo>
                  <a:pt x="2679446" y="1245108"/>
                </a:lnTo>
                <a:lnTo>
                  <a:pt x="2696464" y="1245108"/>
                </a:lnTo>
                <a:lnTo>
                  <a:pt x="2706751" y="1245108"/>
                </a:lnTo>
                <a:lnTo>
                  <a:pt x="2706751" y="1256030"/>
                </a:lnTo>
                <a:lnTo>
                  <a:pt x="2713609" y="1256030"/>
                </a:lnTo>
                <a:lnTo>
                  <a:pt x="2717038" y="1256030"/>
                </a:lnTo>
                <a:lnTo>
                  <a:pt x="2727198" y="1256030"/>
                </a:lnTo>
                <a:lnTo>
                  <a:pt x="2727198" y="1266952"/>
                </a:lnTo>
                <a:lnTo>
                  <a:pt x="2730627" y="1266952"/>
                </a:lnTo>
                <a:lnTo>
                  <a:pt x="2730627" y="1277747"/>
                </a:lnTo>
                <a:lnTo>
                  <a:pt x="2799080" y="1277747"/>
                </a:lnTo>
                <a:lnTo>
                  <a:pt x="2802509" y="1277747"/>
                </a:lnTo>
                <a:lnTo>
                  <a:pt x="2819527" y="1277747"/>
                </a:lnTo>
                <a:lnTo>
                  <a:pt x="2829814" y="1277747"/>
                </a:lnTo>
                <a:lnTo>
                  <a:pt x="2840101" y="1277747"/>
                </a:lnTo>
                <a:lnTo>
                  <a:pt x="2840101" y="1288796"/>
                </a:lnTo>
                <a:lnTo>
                  <a:pt x="2874264" y="1288796"/>
                </a:lnTo>
                <a:lnTo>
                  <a:pt x="2874264" y="1299718"/>
                </a:lnTo>
                <a:lnTo>
                  <a:pt x="2891282" y="1299718"/>
                </a:lnTo>
                <a:lnTo>
                  <a:pt x="2898140" y="1299718"/>
                </a:lnTo>
                <a:lnTo>
                  <a:pt x="2898140" y="1310767"/>
                </a:lnTo>
                <a:lnTo>
                  <a:pt x="2901569" y="1310767"/>
                </a:lnTo>
                <a:lnTo>
                  <a:pt x="2901569" y="1321689"/>
                </a:lnTo>
                <a:lnTo>
                  <a:pt x="2908427" y="1321689"/>
                </a:lnTo>
                <a:lnTo>
                  <a:pt x="2908427" y="1332738"/>
                </a:lnTo>
                <a:lnTo>
                  <a:pt x="2915285" y="1332738"/>
                </a:lnTo>
                <a:lnTo>
                  <a:pt x="2918587" y="1332738"/>
                </a:lnTo>
                <a:lnTo>
                  <a:pt x="2922016" y="1332738"/>
                </a:lnTo>
                <a:lnTo>
                  <a:pt x="2922016" y="1343787"/>
                </a:lnTo>
                <a:lnTo>
                  <a:pt x="2928874" y="1343787"/>
                </a:lnTo>
                <a:lnTo>
                  <a:pt x="2928874" y="1354836"/>
                </a:lnTo>
                <a:lnTo>
                  <a:pt x="2935732" y="1354836"/>
                </a:lnTo>
                <a:lnTo>
                  <a:pt x="2939161" y="1354836"/>
                </a:lnTo>
                <a:lnTo>
                  <a:pt x="2963037" y="1354836"/>
                </a:lnTo>
                <a:lnTo>
                  <a:pt x="2963037" y="1365885"/>
                </a:lnTo>
                <a:lnTo>
                  <a:pt x="2969895" y="1365885"/>
                </a:lnTo>
                <a:lnTo>
                  <a:pt x="2976753" y="1365885"/>
                </a:lnTo>
                <a:lnTo>
                  <a:pt x="2976753" y="1376934"/>
                </a:lnTo>
                <a:lnTo>
                  <a:pt x="2983611" y="1376934"/>
                </a:lnTo>
                <a:lnTo>
                  <a:pt x="2987040" y="1376934"/>
                </a:lnTo>
                <a:lnTo>
                  <a:pt x="2997200" y="1376934"/>
                </a:lnTo>
                <a:lnTo>
                  <a:pt x="3010916" y="1376934"/>
                </a:lnTo>
                <a:lnTo>
                  <a:pt x="3028061" y="1376934"/>
                </a:lnTo>
                <a:lnTo>
                  <a:pt x="3031490" y="1376934"/>
                </a:lnTo>
                <a:lnTo>
                  <a:pt x="3034792" y="1376934"/>
                </a:lnTo>
                <a:lnTo>
                  <a:pt x="3038221" y="1376934"/>
                </a:lnTo>
                <a:lnTo>
                  <a:pt x="3041650" y="1376934"/>
                </a:lnTo>
                <a:lnTo>
                  <a:pt x="3045079" y="1376934"/>
                </a:lnTo>
                <a:lnTo>
                  <a:pt x="3045079" y="1388491"/>
                </a:lnTo>
                <a:lnTo>
                  <a:pt x="3055366" y="1388491"/>
                </a:lnTo>
                <a:lnTo>
                  <a:pt x="3055366" y="1400175"/>
                </a:lnTo>
                <a:lnTo>
                  <a:pt x="3058795" y="1400175"/>
                </a:lnTo>
                <a:lnTo>
                  <a:pt x="3062224" y="1400175"/>
                </a:lnTo>
                <a:lnTo>
                  <a:pt x="3069082" y="1400175"/>
                </a:lnTo>
                <a:lnTo>
                  <a:pt x="3086100" y="1400175"/>
                </a:lnTo>
                <a:lnTo>
                  <a:pt x="3089529" y="1400175"/>
                </a:lnTo>
                <a:lnTo>
                  <a:pt x="3099816" y="1400175"/>
                </a:lnTo>
                <a:lnTo>
                  <a:pt x="3099816" y="1411986"/>
                </a:lnTo>
                <a:lnTo>
                  <a:pt x="3109976" y="1411986"/>
                </a:lnTo>
                <a:lnTo>
                  <a:pt x="3116834" y="1411986"/>
                </a:lnTo>
                <a:lnTo>
                  <a:pt x="3120263" y="1411986"/>
                </a:lnTo>
                <a:lnTo>
                  <a:pt x="3137408" y="1411986"/>
                </a:lnTo>
                <a:lnTo>
                  <a:pt x="3140837" y="1411986"/>
                </a:lnTo>
                <a:lnTo>
                  <a:pt x="3198876" y="1411986"/>
                </a:lnTo>
                <a:lnTo>
                  <a:pt x="3198876" y="1424051"/>
                </a:lnTo>
                <a:lnTo>
                  <a:pt x="3246755" y="1424051"/>
                </a:lnTo>
                <a:lnTo>
                  <a:pt x="3246755" y="1436116"/>
                </a:lnTo>
                <a:lnTo>
                  <a:pt x="3318510" y="1436116"/>
                </a:lnTo>
                <a:lnTo>
                  <a:pt x="3318510" y="1448181"/>
                </a:lnTo>
                <a:lnTo>
                  <a:pt x="3332226" y="1448181"/>
                </a:lnTo>
                <a:lnTo>
                  <a:pt x="3332226" y="1460119"/>
                </a:lnTo>
                <a:lnTo>
                  <a:pt x="3345815" y="1460119"/>
                </a:lnTo>
                <a:lnTo>
                  <a:pt x="3431286" y="1460119"/>
                </a:lnTo>
                <a:lnTo>
                  <a:pt x="3431286" y="1472184"/>
                </a:lnTo>
                <a:lnTo>
                  <a:pt x="3451860" y="1472184"/>
                </a:lnTo>
                <a:lnTo>
                  <a:pt x="3451860" y="1484249"/>
                </a:lnTo>
                <a:lnTo>
                  <a:pt x="3486023" y="1484249"/>
                </a:lnTo>
                <a:lnTo>
                  <a:pt x="3486023" y="1496314"/>
                </a:lnTo>
                <a:lnTo>
                  <a:pt x="3489452" y="1496314"/>
                </a:lnTo>
                <a:lnTo>
                  <a:pt x="3489452" y="1508379"/>
                </a:lnTo>
                <a:lnTo>
                  <a:pt x="3503041" y="1508379"/>
                </a:lnTo>
                <a:lnTo>
                  <a:pt x="3509899" y="1508379"/>
                </a:lnTo>
                <a:lnTo>
                  <a:pt x="3516757" y="1508379"/>
                </a:lnTo>
                <a:lnTo>
                  <a:pt x="3516757" y="1520571"/>
                </a:lnTo>
                <a:lnTo>
                  <a:pt x="3527044" y="1520571"/>
                </a:lnTo>
                <a:lnTo>
                  <a:pt x="3530346" y="1520571"/>
                </a:lnTo>
                <a:lnTo>
                  <a:pt x="3533775" y="1520571"/>
                </a:lnTo>
                <a:lnTo>
                  <a:pt x="3544062" y="1520571"/>
                </a:lnTo>
                <a:lnTo>
                  <a:pt x="3547491" y="1520571"/>
                </a:lnTo>
                <a:lnTo>
                  <a:pt x="3550920" y="1520571"/>
                </a:lnTo>
                <a:lnTo>
                  <a:pt x="3554349" y="1520571"/>
                </a:lnTo>
                <a:lnTo>
                  <a:pt x="3557778" y="1520571"/>
                </a:lnTo>
                <a:lnTo>
                  <a:pt x="3564636" y="1520571"/>
                </a:lnTo>
                <a:lnTo>
                  <a:pt x="3564636" y="1533398"/>
                </a:lnTo>
                <a:lnTo>
                  <a:pt x="3567938" y="1533398"/>
                </a:lnTo>
                <a:lnTo>
                  <a:pt x="3571366" y="1533398"/>
                </a:lnTo>
                <a:lnTo>
                  <a:pt x="3574796" y="1533398"/>
                </a:lnTo>
                <a:lnTo>
                  <a:pt x="3581654" y="1533398"/>
                </a:lnTo>
                <a:lnTo>
                  <a:pt x="3581654" y="1546479"/>
                </a:lnTo>
                <a:lnTo>
                  <a:pt x="3585083" y="1546479"/>
                </a:lnTo>
                <a:lnTo>
                  <a:pt x="3588512" y="1546479"/>
                </a:lnTo>
                <a:lnTo>
                  <a:pt x="3598799" y="1546479"/>
                </a:lnTo>
                <a:lnTo>
                  <a:pt x="3602228" y="1546479"/>
                </a:lnTo>
                <a:lnTo>
                  <a:pt x="3608959" y="1546479"/>
                </a:lnTo>
                <a:lnTo>
                  <a:pt x="3612388" y="1546479"/>
                </a:lnTo>
                <a:lnTo>
                  <a:pt x="3619246" y="1546479"/>
                </a:lnTo>
                <a:lnTo>
                  <a:pt x="3629533" y="1546479"/>
                </a:lnTo>
                <a:lnTo>
                  <a:pt x="3632962" y="1546479"/>
                </a:lnTo>
                <a:lnTo>
                  <a:pt x="3636391" y="1546479"/>
                </a:lnTo>
                <a:lnTo>
                  <a:pt x="3639820" y="1546479"/>
                </a:lnTo>
                <a:lnTo>
                  <a:pt x="3646551" y="1546479"/>
                </a:lnTo>
                <a:lnTo>
                  <a:pt x="3649979" y="1546479"/>
                </a:lnTo>
                <a:lnTo>
                  <a:pt x="3660266" y="1546479"/>
                </a:lnTo>
                <a:lnTo>
                  <a:pt x="3663696" y="1546479"/>
                </a:lnTo>
                <a:lnTo>
                  <a:pt x="3663696" y="1561338"/>
                </a:lnTo>
                <a:lnTo>
                  <a:pt x="3667125" y="1561338"/>
                </a:lnTo>
                <a:lnTo>
                  <a:pt x="3673983" y="1561338"/>
                </a:lnTo>
                <a:lnTo>
                  <a:pt x="3673983" y="1576070"/>
                </a:lnTo>
                <a:lnTo>
                  <a:pt x="3677412" y="1576070"/>
                </a:lnTo>
                <a:lnTo>
                  <a:pt x="3684142" y="1576070"/>
                </a:lnTo>
                <a:lnTo>
                  <a:pt x="3687572" y="1576070"/>
                </a:lnTo>
                <a:lnTo>
                  <a:pt x="3691001" y="1576070"/>
                </a:lnTo>
                <a:lnTo>
                  <a:pt x="3697859" y="1576070"/>
                </a:lnTo>
                <a:lnTo>
                  <a:pt x="3701288" y="1576070"/>
                </a:lnTo>
                <a:lnTo>
                  <a:pt x="3704716" y="1576070"/>
                </a:lnTo>
                <a:lnTo>
                  <a:pt x="3704716" y="1591437"/>
                </a:lnTo>
                <a:lnTo>
                  <a:pt x="3708146" y="1591437"/>
                </a:lnTo>
                <a:lnTo>
                  <a:pt x="3708146" y="1606931"/>
                </a:lnTo>
                <a:lnTo>
                  <a:pt x="3711575" y="1606931"/>
                </a:lnTo>
                <a:lnTo>
                  <a:pt x="3715004" y="1606931"/>
                </a:lnTo>
                <a:lnTo>
                  <a:pt x="3725164" y="1606931"/>
                </a:lnTo>
                <a:lnTo>
                  <a:pt x="3728592" y="1606931"/>
                </a:lnTo>
                <a:lnTo>
                  <a:pt x="3732022" y="1606931"/>
                </a:lnTo>
                <a:lnTo>
                  <a:pt x="3738879" y="1606931"/>
                </a:lnTo>
                <a:lnTo>
                  <a:pt x="3738879" y="1623187"/>
                </a:lnTo>
                <a:lnTo>
                  <a:pt x="3745738" y="1623187"/>
                </a:lnTo>
                <a:lnTo>
                  <a:pt x="3749166" y="1623187"/>
                </a:lnTo>
                <a:lnTo>
                  <a:pt x="3759327" y="1623187"/>
                </a:lnTo>
                <a:lnTo>
                  <a:pt x="3762755" y="1623187"/>
                </a:lnTo>
                <a:lnTo>
                  <a:pt x="3766185" y="1623187"/>
                </a:lnTo>
                <a:lnTo>
                  <a:pt x="3773042" y="1623187"/>
                </a:lnTo>
                <a:lnTo>
                  <a:pt x="3776472" y="1623187"/>
                </a:lnTo>
                <a:lnTo>
                  <a:pt x="3779901" y="1623187"/>
                </a:lnTo>
                <a:lnTo>
                  <a:pt x="3790188" y="1623187"/>
                </a:lnTo>
                <a:lnTo>
                  <a:pt x="3793616" y="1623187"/>
                </a:lnTo>
                <a:lnTo>
                  <a:pt x="3803777" y="1623187"/>
                </a:lnTo>
                <a:lnTo>
                  <a:pt x="3807205" y="1623187"/>
                </a:lnTo>
                <a:lnTo>
                  <a:pt x="3810635" y="1623187"/>
                </a:lnTo>
                <a:lnTo>
                  <a:pt x="3814064" y="1623187"/>
                </a:lnTo>
                <a:lnTo>
                  <a:pt x="3834511" y="1623187"/>
                </a:lnTo>
                <a:lnTo>
                  <a:pt x="3851655" y="1623187"/>
                </a:lnTo>
                <a:lnTo>
                  <a:pt x="3858514" y="1623187"/>
                </a:lnTo>
                <a:lnTo>
                  <a:pt x="3858514" y="1641729"/>
                </a:lnTo>
                <a:lnTo>
                  <a:pt x="3882390" y="1641729"/>
                </a:lnTo>
                <a:lnTo>
                  <a:pt x="3885819" y="1641729"/>
                </a:lnTo>
                <a:lnTo>
                  <a:pt x="3889248" y="1641729"/>
                </a:lnTo>
                <a:lnTo>
                  <a:pt x="3892677" y="1641729"/>
                </a:lnTo>
                <a:lnTo>
                  <a:pt x="3899535" y="1641729"/>
                </a:lnTo>
                <a:lnTo>
                  <a:pt x="3902964" y="1641729"/>
                </a:lnTo>
                <a:lnTo>
                  <a:pt x="3906392" y="1641729"/>
                </a:lnTo>
                <a:lnTo>
                  <a:pt x="3913124" y="1641729"/>
                </a:lnTo>
                <a:lnTo>
                  <a:pt x="3916553" y="1641729"/>
                </a:lnTo>
                <a:lnTo>
                  <a:pt x="3926840" y="1641729"/>
                </a:lnTo>
                <a:lnTo>
                  <a:pt x="3930269" y="1641729"/>
                </a:lnTo>
                <a:lnTo>
                  <a:pt x="3947414" y="1641729"/>
                </a:lnTo>
                <a:lnTo>
                  <a:pt x="3950716" y="1641729"/>
                </a:lnTo>
                <a:lnTo>
                  <a:pt x="3954145" y="1641729"/>
                </a:lnTo>
                <a:lnTo>
                  <a:pt x="3961003" y="1641729"/>
                </a:lnTo>
                <a:lnTo>
                  <a:pt x="3961003" y="1661795"/>
                </a:lnTo>
                <a:lnTo>
                  <a:pt x="3967861" y="1661795"/>
                </a:lnTo>
                <a:lnTo>
                  <a:pt x="3974719" y="1661795"/>
                </a:lnTo>
                <a:lnTo>
                  <a:pt x="3978148" y="1661795"/>
                </a:lnTo>
                <a:lnTo>
                  <a:pt x="3985005" y="1661795"/>
                </a:lnTo>
                <a:lnTo>
                  <a:pt x="3988308" y="1661795"/>
                </a:lnTo>
                <a:lnTo>
                  <a:pt x="3991737" y="1661795"/>
                </a:lnTo>
                <a:lnTo>
                  <a:pt x="3995166" y="1661795"/>
                </a:lnTo>
                <a:lnTo>
                  <a:pt x="4012311" y="1661795"/>
                </a:lnTo>
                <a:lnTo>
                  <a:pt x="4012311" y="1682623"/>
                </a:lnTo>
                <a:lnTo>
                  <a:pt x="4019169" y="1682623"/>
                </a:lnTo>
                <a:lnTo>
                  <a:pt x="4022598" y="1682623"/>
                </a:lnTo>
                <a:lnTo>
                  <a:pt x="4025900" y="1682623"/>
                </a:lnTo>
                <a:lnTo>
                  <a:pt x="4029329" y="1682623"/>
                </a:lnTo>
                <a:lnTo>
                  <a:pt x="4036187" y="1682623"/>
                </a:lnTo>
                <a:lnTo>
                  <a:pt x="4039616" y="1682623"/>
                </a:lnTo>
                <a:lnTo>
                  <a:pt x="4060190" y="1682623"/>
                </a:lnTo>
                <a:lnTo>
                  <a:pt x="4080637" y="1682623"/>
                </a:lnTo>
                <a:lnTo>
                  <a:pt x="4080637" y="1704339"/>
                </a:lnTo>
                <a:lnTo>
                  <a:pt x="4087495" y="1704339"/>
                </a:lnTo>
                <a:lnTo>
                  <a:pt x="4097782" y="1704339"/>
                </a:lnTo>
                <a:lnTo>
                  <a:pt x="4097782" y="1726311"/>
                </a:lnTo>
                <a:lnTo>
                  <a:pt x="4101084" y="1726311"/>
                </a:lnTo>
                <a:lnTo>
                  <a:pt x="4104513" y="1726311"/>
                </a:lnTo>
                <a:lnTo>
                  <a:pt x="4107941" y="1726311"/>
                </a:lnTo>
                <a:lnTo>
                  <a:pt x="4114800" y="1726311"/>
                </a:lnTo>
                <a:lnTo>
                  <a:pt x="4118229" y="1726311"/>
                </a:lnTo>
                <a:lnTo>
                  <a:pt x="4121658" y="1726311"/>
                </a:lnTo>
                <a:lnTo>
                  <a:pt x="4125087" y="1726311"/>
                </a:lnTo>
                <a:lnTo>
                  <a:pt x="4135374" y="1726311"/>
                </a:lnTo>
                <a:lnTo>
                  <a:pt x="4138803" y="1726311"/>
                </a:lnTo>
                <a:lnTo>
                  <a:pt x="4142104" y="1726311"/>
                </a:lnTo>
                <a:lnTo>
                  <a:pt x="4148963" y="1726311"/>
                </a:lnTo>
                <a:lnTo>
                  <a:pt x="4152391" y="1726311"/>
                </a:lnTo>
                <a:lnTo>
                  <a:pt x="4152391" y="1749679"/>
                </a:lnTo>
                <a:lnTo>
                  <a:pt x="4169537" y="1749679"/>
                </a:lnTo>
                <a:lnTo>
                  <a:pt x="4172966" y="1749679"/>
                </a:lnTo>
                <a:lnTo>
                  <a:pt x="4176395" y="1749679"/>
                </a:lnTo>
                <a:lnTo>
                  <a:pt x="4186554" y="1749679"/>
                </a:lnTo>
                <a:lnTo>
                  <a:pt x="4189984" y="1749679"/>
                </a:lnTo>
                <a:lnTo>
                  <a:pt x="4193413" y="1749679"/>
                </a:lnTo>
                <a:lnTo>
                  <a:pt x="4213987" y="1749679"/>
                </a:lnTo>
                <a:lnTo>
                  <a:pt x="4227576" y="1749679"/>
                </a:lnTo>
                <a:lnTo>
                  <a:pt x="4231005" y="1749679"/>
                </a:lnTo>
                <a:lnTo>
                  <a:pt x="4234434" y="1749679"/>
                </a:lnTo>
                <a:lnTo>
                  <a:pt x="4241292" y="1749679"/>
                </a:lnTo>
                <a:lnTo>
                  <a:pt x="4248150" y="1749679"/>
                </a:lnTo>
                <a:lnTo>
                  <a:pt x="4248150" y="1774952"/>
                </a:lnTo>
                <a:lnTo>
                  <a:pt x="4261739" y="1774952"/>
                </a:lnTo>
                <a:lnTo>
                  <a:pt x="4265168" y="1774952"/>
                </a:lnTo>
                <a:lnTo>
                  <a:pt x="4282313" y="1774952"/>
                </a:lnTo>
                <a:lnTo>
                  <a:pt x="4289171" y="1774952"/>
                </a:lnTo>
                <a:lnTo>
                  <a:pt x="4289171" y="1800860"/>
                </a:lnTo>
                <a:lnTo>
                  <a:pt x="4295902" y="1800860"/>
                </a:lnTo>
                <a:lnTo>
                  <a:pt x="4299331" y="1800860"/>
                </a:lnTo>
                <a:lnTo>
                  <a:pt x="4306189" y="1800860"/>
                </a:lnTo>
                <a:lnTo>
                  <a:pt x="4313047" y="1800860"/>
                </a:lnTo>
                <a:lnTo>
                  <a:pt x="4326763" y="1800860"/>
                </a:lnTo>
                <a:lnTo>
                  <a:pt x="4330192" y="1800860"/>
                </a:lnTo>
                <a:lnTo>
                  <a:pt x="4333494" y="1800860"/>
                </a:lnTo>
                <a:lnTo>
                  <a:pt x="4336923" y="1800860"/>
                </a:lnTo>
                <a:lnTo>
                  <a:pt x="4343781" y="1800860"/>
                </a:lnTo>
                <a:lnTo>
                  <a:pt x="4343781" y="1829689"/>
                </a:lnTo>
                <a:lnTo>
                  <a:pt x="4350639" y="1829689"/>
                </a:lnTo>
                <a:lnTo>
                  <a:pt x="4354068" y="1829689"/>
                </a:lnTo>
                <a:lnTo>
                  <a:pt x="4357497" y="1829689"/>
                </a:lnTo>
                <a:lnTo>
                  <a:pt x="4374515" y="1829689"/>
                </a:lnTo>
                <a:lnTo>
                  <a:pt x="4381373" y="1829689"/>
                </a:lnTo>
                <a:lnTo>
                  <a:pt x="4388231" y="1829689"/>
                </a:lnTo>
                <a:lnTo>
                  <a:pt x="4391660" y="1829689"/>
                </a:lnTo>
                <a:lnTo>
                  <a:pt x="4398518" y="1829689"/>
                </a:lnTo>
                <a:lnTo>
                  <a:pt x="4412107" y="1829689"/>
                </a:lnTo>
                <a:lnTo>
                  <a:pt x="4418965" y="1829689"/>
                </a:lnTo>
                <a:lnTo>
                  <a:pt x="4425823" y="1829689"/>
                </a:lnTo>
                <a:lnTo>
                  <a:pt x="4429252" y="1829689"/>
                </a:lnTo>
                <a:lnTo>
                  <a:pt x="4439539" y="1829689"/>
                </a:lnTo>
                <a:lnTo>
                  <a:pt x="4459986" y="1829689"/>
                </a:lnTo>
                <a:lnTo>
                  <a:pt x="4466844" y="1829689"/>
                </a:lnTo>
                <a:lnTo>
                  <a:pt x="4470273" y="1829689"/>
                </a:lnTo>
                <a:lnTo>
                  <a:pt x="4477131" y="1829689"/>
                </a:lnTo>
                <a:lnTo>
                  <a:pt x="4483862" y="1829689"/>
                </a:lnTo>
                <a:lnTo>
                  <a:pt x="4487291" y="1829689"/>
                </a:lnTo>
                <a:lnTo>
                  <a:pt x="4490720" y="1829689"/>
                </a:lnTo>
                <a:lnTo>
                  <a:pt x="4494149" y="1829689"/>
                </a:lnTo>
                <a:lnTo>
                  <a:pt x="4497578" y="1829689"/>
                </a:lnTo>
                <a:lnTo>
                  <a:pt x="4511294" y="1829689"/>
                </a:lnTo>
                <a:lnTo>
                  <a:pt x="4535170" y="1829689"/>
                </a:lnTo>
                <a:lnTo>
                  <a:pt x="4548886" y="1829689"/>
                </a:lnTo>
                <a:lnTo>
                  <a:pt x="4552315" y="1829689"/>
                </a:lnTo>
                <a:lnTo>
                  <a:pt x="4559173" y="1829689"/>
                </a:lnTo>
                <a:lnTo>
                  <a:pt x="4562475" y="1829689"/>
                </a:lnTo>
                <a:lnTo>
                  <a:pt x="4579620" y="1829689"/>
                </a:lnTo>
                <a:lnTo>
                  <a:pt x="4583049" y="1829689"/>
                </a:lnTo>
                <a:lnTo>
                  <a:pt x="4593336" y="1829689"/>
                </a:lnTo>
                <a:lnTo>
                  <a:pt x="4593336" y="1868932"/>
                </a:lnTo>
                <a:lnTo>
                  <a:pt x="4610354" y="1868932"/>
                </a:lnTo>
                <a:lnTo>
                  <a:pt x="4617212" y="1868932"/>
                </a:lnTo>
                <a:lnTo>
                  <a:pt x="4620641" y="1868932"/>
                </a:lnTo>
                <a:lnTo>
                  <a:pt x="4624070" y="1868932"/>
                </a:lnTo>
                <a:lnTo>
                  <a:pt x="4627499" y="1868932"/>
                </a:lnTo>
                <a:lnTo>
                  <a:pt x="4630928" y="1868932"/>
                </a:lnTo>
                <a:lnTo>
                  <a:pt x="4634357" y="1868932"/>
                </a:lnTo>
                <a:lnTo>
                  <a:pt x="4647946" y="1868932"/>
                </a:lnTo>
                <a:lnTo>
                  <a:pt x="4651375" y="1868932"/>
                </a:lnTo>
                <a:lnTo>
                  <a:pt x="4654804" y="1868932"/>
                </a:lnTo>
                <a:lnTo>
                  <a:pt x="4665091" y="1868932"/>
                </a:lnTo>
                <a:lnTo>
                  <a:pt x="4671949" y="1868932"/>
                </a:lnTo>
                <a:lnTo>
                  <a:pt x="4685538" y="1868932"/>
                </a:lnTo>
                <a:lnTo>
                  <a:pt x="4688967" y="1868932"/>
                </a:lnTo>
                <a:lnTo>
                  <a:pt x="4692396" y="1868932"/>
                </a:lnTo>
                <a:lnTo>
                  <a:pt x="4695825" y="1868932"/>
                </a:lnTo>
                <a:lnTo>
                  <a:pt x="4699254" y="1868932"/>
                </a:lnTo>
                <a:lnTo>
                  <a:pt x="4702683" y="1868932"/>
                </a:lnTo>
                <a:lnTo>
                  <a:pt x="4706112" y="1868932"/>
                </a:lnTo>
                <a:lnTo>
                  <a:pt x="4706112" y="1918208"/>
                </a:lnTo>
                <a:lnTo>
                  <a:pt x="4709541" y="1918208"/>
                </a:lnTo>
                <a:lnTo>
                  <a:pt x="4709541" y="1967483"/>
                </a:lnTo>
                <a:lnTo>
                  <a:pt x="4736846" y="1967483"/>
                </a:lnTo>
                <a:lnTo>
                  <a:pt x="4747133" y="1967483"/>
                </a:lnTo>
                <a:lnTo>
                  <a:pt x="4747133" y="2017776"/>
                </a:lnTo>
                <a:lnTo>
                  <a:pt x="4764151" y="2017776"/>
                </a:lnTo>
                <a:lnTo>
                  <a:pt x="4781296" y="2017776"/>
                </a:lnTo>
                <a:lnTo>
                  <a:pt x="4805172" y="2017776"/>
                </a:lnTo>
                <a:lnTo>
                  <a:pt x="4812030" y="2017776"/>
                </a:lnTo>
                <a:lnTo>
                  <a:pt x="4846193" y="2017776"/>
                </a:lnTo>
                <a:lnTo>
                  <a:pt x="4846193" y="2073529"/>
                </a:lnTo>
                <a:lnTo>
                  <a:pt x="4853051" y="2073529"/>
                </a:lnTo>
                <a:lnTo>
                  <a:pt x="4856480" y="2073529"/>
                </a:lnTo>
                <a:lnTo>
                  <a:pt x="4870069" y="2073529"/>
                </a:lnTo>
                <a:lnTo>
                  <a:pt x="4873498" y="2073529"/>
                </a:lnTo>
                <a:lnTo>
                  <a:pt x="4876927" y="2073529"/>
                </a:lnTo>
                <a:lnTo>
                  <a:pt x="4880356" y="2073529"/>
                </a:lnTo>
                <a:lnTo>
                  <a:pt x="4883785" y="2073529"/>
                </a:lnTo>
                <a:lnTo>
                  <a:pt x="4894072" y="2073529"/>
                </a:lnTo>
                <a:lnTo>
                  <a:pt x="4917948" y="2073529"/>
                </a:lnTo>
                <a:lnTo>
                  <a:pt x="5064887" y="2073529"/>
                </a:lnTo>
                <a:lnTo>
                  <a:pt x="5064887" y="2136902"/>
                </a:lnTo>
                <a:lnTo>
                  <a:pt x="5232400" y="2136902"/>
                </a:lnTo>
                <a:lnTo>
                  <a:pt x="5242687" y="2136902"/>
                </a:lnTo>
                <a:lnTo>
                  <a:pt x="5276850" y="2136902"/>
                </a:lnTo>
                <a:lnTo>
                  <a:pt x="5304155" y="2136902"/>
                </a:lnTo>
                <a:lnTo>
                  <a:pt x="5311013" y="2136902"/>
                </a:lnTo>
                <a:lnTo>
                  <a:pt x="5324602" y="2136902"/>
                </a:lnTo>
                <a:lnTo>
                  <a:pt x="5328031" y="2136902"/>
                </a:lnTo>
                <a:lnTo>
                  <a:pt x="5331460" y="2136902"/>
                </a:lnTo>
                <a:lnTo>
                  <a:pt x="5334889" y="2136902"/>
                </a:lnTo>
                <a:lnTo>
                  <a:pt x="5348605" y="2136902"/>
                </a:lnTo>
                <a:lnTo>
                  <a:pt x="5352034" y="2136902"/>
                </a:lnTo>
                <a:lnTo>
                  <a:pt x="5358892" y="2136902"/>
                </a:lnTo>
                <a:lnTo>
                  <a:pt x="5379339" y="2136902"/>
                </a:lnTo>
                <a:lnTo>
                  <a:pt x="5410073" y="2136902"/>
                </a:lnTo>
                <a:lnTo>
                  <a:pt x="5427218" y="2136902"/>
                </a:lnTo>
                <a:lnTo>
                  <a:pt x="5440807" y="2136902"/>
                </a:lnTo>
                <a:lnTo>
                  <a:pt x="5447665" y="2136902"/>
                </a:lnTo>
                <a:lnTo>
                  <a:pt x="5451094" y="2136902"/>
                </a:lnTo>
                <a:lnTo>
                  <a:pt x="5471668" y="2136902"/>
                </a:lnTo>
                <a:lnTo>
                  <a:pt x="5475097" y="2136902"/>
                </a:lnTo>
                <a:lnTo>
                  <a:pt x="5492115" y="2136902"/>
                </a:lnTo>
                <a:lnTo>
                  <a:pt x="5498973" y="2136902"/>
                </a:lnTo>
                <a:lnTo>
                  <a:pt x="5519420" y="2136902"/>
                </a:lnTo>
                <a:lnTo>
                  <a:pt x="5536565" y="2136902"/>
                </a:lnTo>
                <a:lnTo>
                  <a:pt x="5553583" y="2136902"/>
                </a:lnTo>
                <a:lnTo>
                  <a:pt x="5557012" y="2136902"/>
                </a:lnTo>
                <a:lnTo>
                  <a:pt x="5560441" y="2136902"/>
                </a:lnTo>
                <a:lnTo>
                  <a:pt x="5577586" y="2136902"/>
                </a:lnTo>
                <a:lnTo>
                  <a:pt x="5581015" y="2136902"/>
                </a:lnTo>
                <a:lnTo>
                  <a:pt x="5587873" y="2136902"/>
                </a:lnTo>
                <a:lnTo>
                  <a:pt x="5591175" y="2136902"/>
                </a:lnTo>
                <a:lnTo>
                  <a:pt x="5601462" y="2136902"/>
                </a:lnTo>
                <a:lnTo>
                  <a:pt x="5604891" y="2136902"/>
                </a:lnTo>
                <a:lnTo>
                  <a:pt x="5608320" y="2136902"/>
                </a:lnTo>
                <a:lnTo>
                  <a:pt x="5642483" y="2136902"/>
                </a:lnTo>
                <a:lnTo>
                  <a:pt x="5686933" y="2136902"/>
                </a:lnTo>
                <a:lnTo>
                  <a:pt x="5714238" y="2136902"/>
                </a:lnTo>
                <a:lnTo>
                  <a:pt x="5724525" y="2136902"/>
                </a:lnTo>
                <a:lnTo>
                  <a:pt x="5734812" y="2136902"/>
                </a:lnTo>
                <a:lnTo>
                  <a:pt x="5741670" y="2136902"/>
                </a:lnTo>
                <a:lnTo>
                  <a:pt x="5744972" y="2136902"/>
                </a:lnTo>
                <a:lnTo>
                  <a:pt x="5765546" y="2136902"/>
                </a:lnTo>
                <a:lnTo>
                  <a:pt x="5782564" y="2136902"/>
                </a:lnTo>
                <a:lnTo>
                  <a:pt x="5785993" y="2136902"/>
                </a:lnTo>
                <a:lnTo>
                  <a:pt x="5792851" y="2136902"/>
                </a:lnTo>
                <a:lnTo>
                  <a:pt x="5809996" y="2136902"/>
                </a:lnTo>
                <a:lnTo>
                  <a:pt x="5820156" y="2136902"/>
                </a:lnTo>
                <a:lnTo>
                  <a:pt x="5833872" y="2136902"/>
                </a:lnTo>
                <a:lnTo>
                  <a:pt x="5888609" y="2136902"/>
                </a:lnTo>
                <a:lnTo>
                  <a:pt x="5950077" y="2136902"/>
                </a:lnTo>
                <a:lnTo>
                  <a:pt x="5960364" y="2136902"/>
                </a:lnTo>
                <a:lnTo>
                  <a:pt x="5977382" y="2136902"/>
                </a:lnTo>
                <a:lnTo>
                  <a:pt x="5997956" y="2136902"/>
                </a:lnTo>
                <a:lnTo>
                  <a:pt x="6001385" y="2136902"/>
                </a:lnTo>
                <a:lnTo>
                  <a:pt x="6021832" y="2136902"/>
                </a:lnTo>
                <a:lnTo>
                  <a:pt x="6076569" y="2136902"/>
                </a:lnTo>
                <a:lnTo>
                  <a:pt x="6168771" y="2136902"/>
                </a:lnTo>
                <a:lnTo>
                  <a:pt x="6500368" y="2136902"/>
                </a:lnTo>
                <a:lnTo>
                  <a:pt x="6715633" y="2136902"/>
                </a:lnTo>
              </a:path>
            </a:pathLst>
          </a:custGeom>
          <a:ln w="20320">
            <a:solidFill>
              <a:srgbClr val="E41A1C"/>
            </a:solidFill>
          </a:ln>
        </p:spPr>
        <p:txBody>
          <a:bodyPr wrap="square" lIns="0" tIns="0" rIns="0" bIns="0" rtlCol="0"/>
          <a:lstStyle/>
          <a:p>
            <a:endParaRPr sz="1125"/>
          </a:p>
        </p:txBody>
      </p:sp>
      <p:sp>
        <p:nvSpPr>
          <p:cNvPr id="45" name="bg object 17">
            <a:extLst>
              <a:ext uri="{FF2B5EF4-FFF2-40B4-BE49-F238E27FC236}">
                <a16:creationId xmlns:a16="http://schemas.microsoft.com/office/drawing/2014/main" id="{687D0543-B9F9-4D84-896B-5F49D24CD106}"/>
              </a:ext>
            </a:extLst>
          </p:cNvPr>
          <p:cNvSpPr/>
          <p:nvPr/>
        </p:nvSpPr>
        <p:spPr>
          <a:xfrm>
            <a:off x="1037582" y="628226"/>
            <a:ext cx="4114158" cy="1126373"/>
          </a:xfrm>
          <a:custGeom>
            <a:avLst/>
            <a:gdLst/>
            <a:ahLst/>
            <a:cxnLst/>
            <a:rect l="l" t="t" r="r" b="b"/>
            <a:pathLst>
              <a:path w="6582409" h="1802130">
                <a:moveTo>
                  <a:pt x="0" y="0"/>
                </a:moveTo>
                <a:lnTo>
                  <a:pt x="17018" y="0"/>
                </a:lnTo>
                <a:lnTo>
                  <a:pt x="17018" y="11811"/>
                </a:lnTo>
                <a:lnTo>
                  <a:pt x="23876" y="11811"/>
                </a:lnTo>
                <a:lnTo>
                  <a:pt x="23876" y="23622"/>
                </a:lnTo>
                <a:lnTo>
                  <a:pt x="41021" y="23622"/>
                </a:lnTo>
                <a:lnTo>
                  <a:pt x="41021" y="35560"/>
                </a:lnTo>
                <a:lnTo>
                  <a:pt x="68326" y="35560"/>
                </a:lnTo>
                <a:lnTo>
                  <a:pt x="68326" y="47371"/>
                </a:lnTo>
                <a:lnTo>
                  <a:pt x="85471" y="47371"/>
                </a:lnTo>
                <a:lnTo>
                  <a:pt x="85471" y="59182"/>
                </a:lnTo>
                <a:lnTo>
                  <a:pt x="105918" y="59182"/>
                </a:lnTo>
                <a:lnTo>
                  <a:pt x="105918" y="82931"/>
                </a:lnTo>
                <a:lnTo>
                  <a:pt x="112776" y="82931"/>
                </a:lnTo>
                <a:lnTo>
                  <a:pt x="112776" y="94869"/>
                </a:lnTo>
                <a:lnTo>
                  <a:pt x="123063" y="94869"/>
                </a:lnTo>
                <a:lnTo>
                  <a:pt x="123063" y="106680"/>
                </a:lnTo>
                <a:lnTo>
                  <a:pt x="136652" y="106680"/>
                </a:lnTo>
                <a:lnTo>
                  <a:pt x="136652" y="118491"/>
                </a:lnTo>
                <a:lnTo>
                  <a:pt x="150368" y="118491"/>
                </a:lnTo>
                <a:lnTo>
                  <a:pt x="150368" y="130429"/>
                </a:lnTo>
                <a:lnTo>
                  <a:pt x="160655" y="130429"/>
                </a:lnTo>
                <a:lnTo>
                  <a:pt x="160655" y="142240"/>
                </a:lnTo>
                <a:lnTo>
                  <a:pt x="164084" y="142240"/>
                </a:lnTo>
                <a:lnTo>
                  <a:pt x="164084" y="154051"/>
                </a:lnTo>
                <a:lnTo>
                  <a:pt x="205104" y="154051"/>
                </a:lnTo>
                <a:lnTo>
                  <a:pt x="205104" y="165989"/>
                </a:lnTo>
                <a:lnTo>
                  <a:pt x="242697" y="165989"/>
                </a:lnTo>
                <a:lnTo>
                  <a:pt x="242697" y="177800"/>
                </a:lnTo>
                <a:lnTo>
                  <a:pt x="256286" y="177800"/>
                </a:lnTo>
                <a:lnTo>
                  <a:pt x="256286" y="189611"/>
                </a:lnTo>
                <a:lnTo>
                  <a:pt x="273431" y="189611"/>
                </a:lnTo>
                <a:lnTo>
                  <a:pt x="273431" y="201549"/>
                </a:lnTo>
                <a:lnTo>
                  <a:pt x="276860" y="201549"/>
                </a:lnTo>
                <a:lnTo>
                  <a:pt x="276860" y="213360"/>
                </a:lnTo>
                <a:lnTo>
                  <a:pt x="287020" y="213360"/>
                </a:lnTo>
                <a:lnTo>
                  <a:pt x="287020" y="225171"/>
                </a:lnTo>
                <a:lnTo>
                  <a:pt x="328041" y="225171"/>
                </a:lnTo>
                <a:lnTo>
                  <a:pt x="328041" y="237109"/>
                </a:lnTo>
                <a:lnTo>
                  <a:pt x="331470" y="237109"/>
                </a:lnTo>
                <a:lnTo>
                  <a:pt x="331470" y="248920"/>
                </a:lnTo>
                <a:lnTo>
                  <a:pt x="375920" y="248920"/>
                </a:lnTo>
                <a:lnTo>
                  <a:pt x="375920" y="260731"/>
                </a:lnTo>
                <a:lnTo>
                  <a:pt x="382778" y="260731"/>
                </a:lnTo>
                <a:lnTo>
                  <a:pt x="382778" y="272669"/>
                </a:lnTo>
                <a:lnTo>
                  <a:pt x="389636" y="272669"/>
                </a:lnTo>
                <a:lnTo>
                  <a:pt x="389636" y="284480"/>
                </a:lnTo>
                <a:lnTo>
                  <a:pt x="399796" y="284480"/>
                </a:lnTo>
                <a:lnTo>
                  <a:pt x="410083" y="284480"/>
                </a:lnTo>
                <a:lnTo>
                  <a:pt x="410083" y="296291"/>
                </a:lnTo>
                <a:lnTo>
                  <a:pt x="437388" y="296291"/>
                </a:lnTo>
                <a:lnTo>
                  <a:pt x="437388" y="308229"/>
                </a:lnTo>
                <a:lnTo>
                  <a:pt x="444245" y="308229"/>
                </a:lnTo>
                <a:lnTo>
                  <a:pt x="444245" y="320167"/>
                </a:lnTo>
                <a:lnTo>
                  <a:pt x="447675" y="320167"/>
                </a:lnTo>
                <a:lnTo>
                  <a:pt x="454533" y="320167"/>
                </a:lnTo>
                <a:lnTo>
                  <a:pt x="454533" y="331978"/>
                </a:lnTo>
                <a:lnTo>
                  <a:pt x="457962" y="331978"/>
                </a:lnTo>
                <a:lnTo>
                  <a:pt x="481838" y="331978"/>
                </a:lnTo>
                <a:lnTo>
                  <a:pt x="502412" y="331978"/>
                </a:lnTo>
                <a:lnTo>
                  <a:pt x="502412" y="343916"/>
                </a:lnTo>
                <a:lnTo>
                  <a:pt x="505841" y="343916"/>
                </a:lnTo>
                <a:lnTo>
                  <a:pt x="509270" y="343916"/>
                </a:lnTo>
                <a:lnTo>
                  <a:pt x="526288" y="343916"/>
                </a:lnTo>
                <a:lnTo>
                  <a:pt x="529717" y="343916"/>
                </a:lnTo>
                <a:lnTo>
                  <a:pt x="533146" y="343916"/>
                </a:lnTo>
                <a:lnTo>
                  <a:pt x="533146" y="355981"/>
                </a:lnTo>
                <a:lnTo>
                  <a:pt x="536575" y="355981"/>
                </a:lnTo>
                <a:lnTo>
                  <a:pt x="536575" y="368046"/>
                </a:lnTo>
                <a:lnTo>
                  <a:pt x="553593" y="368046"/>
                </a:lnTo>
                <a:lnTo>
                  <a:pt x="560451" y="368046"/>
                </a:lnTo>
                <a:lnTo>
                  <a:pt x="560451" y="380238"/>
                </a:lnTo>
                <a:lnTo>
                  <a:pt x="577596" y="380238"/>
                </a:lnTo>
                <a:lnTo>
                  <a:pt x="577596" y="404495"/>
                </a:lnTo>
                <a:lnTo>
                  <a:pt x="581025" y="404495"/>
                </a:lnTo>
                <a:lnTo>
                  <a:pt x="581025" y="416559"/>
                </a:lnTo>
                <a:lnTo>
                  <a:pt x="594614" y="416559"/>
                </a:lnTo>
                <a:lnTo>
                  <a:pt x="598043" y="416559"/>
                </a:lnTo>
                <a:lnTo>
                  <a:pt x="598043" y="428752"/>
                </a:lnTo>
                <a:lnTo>
                  <a:pt x="601472" y="428752"/>
                </a:lnTo>
                <a:lnTo>
                  <a:pt x="601472" y="440944"/>
                </a:lnTo>
                <a:lnTo>
                  <a:pt x="645922" y="440944"/>
                </a:lnTo>
                <a:lnTo>
                  <a:pt x="645922" y="453136"/>
                </a:lnTo>
                <a:lnTo>
                  <a:pt x="669798" y="453136"/>
                </a:lnTo>
                <a:lnTo>
                  <a:pt x="669798" y="465328"/>
                </a:lnTo>
                <a:lnTo>
                  <a:pt x="707390" y="465328"/>
                </a:lnTo>
                <a:lnTo>
                  <a:pt x="721106" y="465328"/>
                </a:lnTo>
                <a:lnTo>
                  <a:pt x="721106" y="477520"/>
                </a:lnTo>
                <a:lnTo>
                  <a:pt x="738251" y="477520"/>
                </a:lnTo>
                <a:lnTo>
                  <a:pt x="738251" y="489839"/>
                </a:lnTo>
                <a:lnTo>
                  <a:pt x="751840" y="489839"/>
                </a:lnTo>
                <a:lnTo>
                  <a:pt x="758698" y="489839"/>
                </a:lnTo>
                <a:lnTo>
                  <a:pt x="758698" y="502031"/>
                </a:lnTo>
                <a:lnTo>
                  <a:pt x="768985" y="502031"/>
                </a:lnTo>
                <a:lnTo>
                  <a:pt x="786003" y="502031"/>
                </a:lnTo>
                <a:lnTo>
                  <a:pt x="799719" y="502031"/>
                </a:lnTo>
                <a:lnTo>
                  <a:pt x="803148" y="502031"/>
                </a:lnTo>
                <a:lnTo>
                  <a:pt x="806577" y="502031"/>
                </a:lnTo>
                <a:lnTo>
                  <a:pt x="813435" y="502031"/>
                </a:lnTo>
                <a:lnTo>
                  <a:pt x="813435" y="514477"/>
                </a:lnTo>
                <a:lnTo>
                  <a:pt x="816737" y="514477"/>
                </a:lnTo>
                <a:lnTo>
                  <a:pt x="816737" y="526923"/>
                </a:lnTo>
                <a:lnTo>
                  <a:pt x="820166" y="526923"/>
                </a:lnTo>
                <a:lnTo>
                  <a:pt x="820166" y="539369"/>
                </a:lnTo>
                <a:lnTo>
                  <a:pt x="823594" y="539369"/>
                </a:lnTo>
                <a:lnTo>
                  <a:pt x="823594" y="551815"/>
                </a:lnTo>
                <a:lnTo>
                  <a:pt x="827024" y="551815"/>
                </a:lnTo>
                <a:lnTo>
                  <a:pt x="827024" y="589153"/>
                </a:lnTo>
                <a:lnTo>
                  <a:pt x="844169" y="589153"/>
                </a:lnTo>
                <a:lnTo>
                  <a:pt x="851027" y="589153"/>
                </a:lnTo>
                <a:lnTo>
                  <a:pt x="861187" y="589153"/>
                </a:lnTo>
                <a:lnTo>
                  <a:pt x="861187" y="601726"/>
                </a:lnTo>
                <a:lnTo>
                  <a:pt x="864616" y="601726"/>
                </a:lnTo>
                <a:lnTo>
                  <a:pt x="864616" y="614172"/>
                </a:lnTo>
                <a:lnTo>
                  <a:pt x="895350" y="614172"/>
                </a:lnTo>
                <a:lnTo>
                  <a:pt x="909066" y="614172"/>
                </a:lnTo>
                <a:lnTo>
                  <a:pt x="919353" y="614172"/>
                </a:lnTo>
                <a:lnTo>
                  <a:pt x="932941" y="614172"/>
                </a:lnTo>
                <a:lnTo>
                  <a:pt x="932941" y="626745"/>
                </a:lnTo>
                <a:lnTo>
                  <a:pt x="987679" y="626745"/>
                </a:lnTo>
                <a:lnTo>
                  <a:pt x="1004824" y="626745"/>
                </a:lnTo>
                <a:lnTo>
                  <a:pt x="1004824" y="639445"/>
                </a:lnTo>
                <a:lnTo>
                  <a:pt x="1008126" y="639445"/>
                </a:lnTo>
                <a:lnTo>
                  <a:pt x="1014984" y="639445"/>
                </a:lnTo>
                <a:lnTo>
                  <a:pt x="1014984" y="652018"/>
                </a:lnTo>
                <a:lnTo>
                  <a:pt x="1032129" y="652018"/>
                </a:lnTo>
                <a:lnTo>
                  <a:pt x="1042416" y="652018"/>
                </a:lnTo>
                <a:lnTo>
                  <a:pt x="1073150" y="652018"/>
                </a:lnTo>
                <a:lnTo>
                  <a:pt x="1073150" y="664845"/>
                </a:lnTo>
                <a:lnTo>
                  <a:pt x="1097026" y="664845"/>
                </a:lnTo>
                <a:lnTo>
                  <a:pt x="1100455" y="664845"/>
                </a:lnTo>
                <a:lnTo>
                  <a:pt x="1114171" y="664845"/>
                </a:lnTo>
                <a:lnTo>
                  <a:pt x="1114171" y="677672"/>
                </a:lnTo>
                <a:lnTo>
                  <a:pt x="1148334" y="677672"/>
                </a:lnTo>
                <a:lnTo>
                  <a:pt x="1155192" y="677672"/>
                </a:lnTo>
                <a:lnTo>
                  <a:pt x="1175639" y="677672"/>
                </a:lnTo>
                <a:lnTo>
                  <a:pt x="1196213" y="677672"/>
                </a:lnTo>
                <a:lnTo>
                  <a:pt x="1196213" y="690499"/>
                </a:lnTo>
                <a:lnTo>
                  <a:pt x="1226947" y="690499"/>
                </a:lnTo>
                <a:lnTo>
                  <a:pt x="1226947" y="703453"/>
                </a:lnTo>
                <a:lnTo>
                  <a:pt x="1233805" y="703453"/>
                </a:lnTo>
                <a:lnTo>
                  <a:pt x="1233805" y="729361"/>
                </a:lnTo>
                <a:lnTo>
                  <a:pt x="1250823" y="729361"/>
                </a:lnTo>
                <a:lnTo>
                  <a:pt x="1250823" y="742188"/>
                </a:lnTo>
                <a:lnTo>
                  <a:pt x="1257681" y="742188"/>
                </a:lnTo>
                <a:lnTo>
                  <a:pt x="1284986" y="742188"/>
                </a:lnTo>
                <a:lnTo>
                  <a:pt x="1291844" y="742188"/>
                </a:lnTo>
                <a:lnTo>
                  <a:pt x="1305560" y="742188"/>
                </a:lnTo>
                <a:lnTo>
                  <a:pt x="1305560" y="755269"/>
                </a:lnTo>
                <a:lnTo>
                  <a:pt x="1308989" y="755269"/>
                </a:lnTo>
                <a:lnTo>
                  <a:pt x="1308989" y="768223"/>
                </a:lnTo>
                <a:lnTo>
                  <a:pt x="1312418" y="768223"/>
                </a:lnTo>
                <a:lnTo>
                  <a:pt x="1336294" y="768223"/>
                </a:lnTo>
                <a:lnTo>
                  <a:pt x="1343152" y="768223"/>
                </a:lnTo>
                <a:lnTo>
                  <a:pt x="1353312" y="768223"/>
                </a:lnTo>
                <a:lnTo>
                  <a:pt x="1363599" y="768223"/>
                </a:lnTo>
                <a:lnTo>
                  <a:pt x="1363599" y="781558"/>
                </a:lnTo>
                <a:lnTo>
                  <a:pt x="1367028" y="781558"/>
                </a:lnTo>
                <a:lnTo>
                  <a:pt x="1367028" y="794766"/>
                </a:lnTo>
                <a:lnTo>
                  <a:pt x="1370457" y="794766"/>
                </a:lnTo>
                <a:lnTo>
                  <a:pt x="1380744" y="794766"/>
                </a:lnTo>
                <a:lnTo>
                  <a:pt x="1380744" y="808101"/>
                </a:lnTo>
                <a:lnTo>
                  <a:pt x="1397762" y="808101"/>
                </a:lnTo>
                <a:lnTo>
                  <a:pt x="1401191" y="808101"/>
                </a:lnTo>
                <a:lnTo>
                  <a:pt x="1421765" y="808101"/>
                </a:lnTo>
                <a:lnTo>
                  <a:pt x="1435354" y="808101"/>
                </a:lnTo>
                <a:lnTo>
                  <a:pt x="1435354" y="821563"/>
                </a:lnTo>
                <a:lnTo>
                  <a:pt x="1438783" y="821563"/>
                </a:lnTo>
                <a:lnTo>
                  <a:pt x="1442212" y="821563"/>
                </a:lnTo>
                <a:lnTo>
                  <a:pt x="1442212" y="835025"/>
                </a:lnTo>
                <a:lnTo>
                  <a:pt x="1449070" y="835025"/>
                </a:lnTo>
                <a:lnTo>
                  <a:pt x="1452499" y="835025"/>
                </a:lnTo>
                <a:lnTo>
                  <a:pt x="1462786" y="835025"/>
                </a:lnTo>
                <a:lnTo>
                  <a:pt x="1472946" y="835025"/>
                </a:lnTo>
                <a:lnTo>
                  <a:pt x="1479804" y="835025"/>
                </a:lnTo>
                <a:lnTo>
                  <a:pt x="1486662" y="835025"/>
                </a:lnTo>
                <a:lnTo>
                  <a:pt x="1507109" y="835025"/>
                </a:lnTo>
                <a:lnTo>
                  <a:pt x="1510538" y="835025"/>
                </a:lnTo>
                <a:lnTo>
                  <a:pt x="1513967" y="835025"/>
                </a:lnTo>
                <a:lnTo>
                  <a:pt x="1524254" y="835025"/>
                </a:lnTo>
                <a:lnTo>
                  <a:pt x="1527683" y="835025"/>
                </a:lnTo>
                <a:lnTo>
                  <a:pt x="1531112" y="835025"/>
                </a:lnTo>
                <a:lnTo>
                  <a:pt x="1534541" y="835025"/>
                </a:lnTo>
                <a:lnTo>
                  <a:pt x="1565275" y="835025"/>
                </a:lnTo>
                <a:lnTo>
                  <a:pt x="1565275" y="849122"/>
                </a:lnTo>
                <a:lnTo>
                  <a:pt x="1572133" y="849122"/>
                </a:lnTo>
                <a:lnTo>
                  <a:pt x="1575562" y="849122"/>
                </a:lnTo>
                <a:lnTo>
                  <a:pt x="1613154" y="849122"/>
                </a:lnTo>
                <a:lnTo>
                  <a:pt x="1633601" y="849122"/>
                </a:lnTo>
                <a:lnTo>
                  <a:pt x="1650745" y="849122"/>
                </a:lnTo>
                <a:lnTo>
                  <a:pt x="1650745" y="863472"/>
                </a:lnTo>
                <a:lnTo>
                  <a:pt x="1660906" y="863472"/>
                </a:lnTo>
                <a:lnTo>
                  <a:pt x="1664335" y="863472"/>
                </a:lnTo>
                <a:lnTo>
                  <a:pt x="1667764" y="863472"/>
                </a:lnTo>
                <a:lnTo>
                  <a:pt x="1667764" y="878078"/>
                </a:lnTo>
                <a:lnTo>
                  <a:pt x="1688338" y="878078"/>
                </a:lnTo>
                <a:lnTo>
                  <a:pt x="1719072" y="878078"/>
                </a:lnTo>
                <a:lnTo>
                  <a:pt x="1719072" y="892683"/>
                </a:lnTo>
                <a:lnTo>
                  <a:pt x="1729358" y="892683"/>
                </a:lnTo>
                <a:lnTo>
                  <a:pt x="1749806" y="892683"/>
                </a:lnTo>
                <a:lnTo>
                  <a:pt x="1783969" y="892683"/>
                </a:lnTo>
                <a:lnTo>
                  <a:pt x="1787398" y="892683"/>
                </a:lnTo>
                <a:lnTo>
                  <a:pt x="1794256" y="892683"/>
                </a:lnTo>
                <a:lnTo>
                  <a:pt x="1797685" y="892683"/>
                </a:lnTo>
                <a:lnTo>
                  <a:pt x="1797685" y="907541"/>
                </a:lnTo>
                <a:lnTo>
                  <a:pt x="1838706" y="907541"/>
                </a:lnTo>
                <a:lnTo>
                  <a:pt x="1838706" y="922401"/>
                </a:lnTo>
                <a:lnTo>
                  <a:pt x="1866011" y="922401"/>
                </a:lnTo>
                <a:lnTo>
                  <a:pt x="1866011" y="937260"/>
                </a:lnTo>
                <a:lnTo>
                  <a:pt x="1869439" y="937260"/>
                </a:lnTo>
                <a:lnTo>
                  <a:pt x="1869439" y="937260"/>
                </a:lnTo>
                <a:lnTo>
                  <a:pt x="1889887" y="937260"/>
                </a:lnTo>
                <a:lnTo>
                  <a:pt x="1913889" y="937260"/>
                </a:lnTo>
                <a:lnTo>
                  <a:pt x="1924177" y="937260"/>
                </a:lnTo>
                <a:lnTo>
                  <a:pt x="1924177" y="952246"/>
                </a:lnTo>
                <a:lnTo>
                  <a:pt x="1941195" y="952246"/>
                </a:lnTo>
                <a:lnTo>
                  <a:pt x="1951482" y="952246"/>
                </a:lnTo>
                <a:lnTo>
                  <a:pt x="1951482" y="967359"/>
                </a:lnTo>
                <a:lnTo>
                  <a:pt x="1968500" y="967359"/>
                </a:lnTo>
                <a:lnTo>
                  <a:pt x="2019808" y="967359"/>
                </a:lnTo>
                <a:lnTo>
                  <a:pt x="2064258" y="967359"/>
                </a:lnTo>
                <a:lnTo>
                  <a:pt x="2077847" y="967359"/>
                </a:lnTo>
                <a:lnTo>
                  <a:pt x="2101850" y="967359"/>
                </a:lnTo>
                <a:lnTo>
                  <a:pt x="2105279" y="967359"/>
                </a:lnTo>
                <a:lnTo>
                  <a:pt x="2105279" y="982599"/>
                </a:lnTo>
                <a:lnTo>
                  <a:pt x="2108708" y="982599"/>
                </a:lnTo>
                <a:lnTo>
                  <a:pt x="2112137" y="982599"/>
                </a:lnTo>
                <a:lnTo>
                  <a:pt x="2115439" y="982599"/>
                </a:lnTo>
                <a:lnTo>
                  <a:pt x="2118868" y="982599"/>
                </a:lnTo>
                <a:lnTo>
                  <a:pt x="2125726" y="982599"/>
                </a:lnTo>
                <a:lnTo>
                  <a:pt x="2132584" y="982599"/>
                </a:lnTo>
                <a:lnTo>
                  <a:pt x="2146300" y="982599"/>
                </a:lnTo>
                <a:lnTo>
                  <a:pt x="2153158" y="982599"/>
                </a:lnTo>
                <a:lnTo>
                  <a:pt x="2159889" y="982599"/>
                </a:lnTo>
                <a:lnTo>
                  <a:pt x="2166747" y="982599"/>
                </a:lnTo>
                <a:lnTo>
                  <a:pt x="2170176" y="982599"/>
                </a:lnTo>
                <a:lnTo>
                  <a:pt x="2187321" y="982599"/>
                </a:lnTo>
                <a:lnTo>
                  <a:pt x="2187321" y="998474"/>
                </a:lnTo>
                <a:lnTo>
                  <a:pt x="2197481" y="998474"/>
                </a:lnTo>
                <a:lnTo>
                  <a:pt x="2200910" y="998474"/>
                </a:lnTo>
                <a:lnTo>
                  <a:pt x="2200910" y="1014349"/>
                </a:lnTo>
                <a:lnTo>
                  <a:pt x="2207768" y="1014349"/>
                </a:lnTo>
                <a:lnTo>
                  <a:pt x="2207768" y="1030351"/>
                </a:lnTo>
                <a:lnTo>
                  <a:pt x="2218055" y="1030351"/>
                </a:lnTo>
                <a:lnTo>
                  <a:pt x="2248789" y="1030351"/>
                </a:lnTo>
                <a:lnTo>
                  <a:pt x="2248789" y="1046226"/>
                </a:lnTo>
                <a:lnTo>
                  <a:pt x="2255647" y="1046226"/>
                </a:lnTo>
                <a:lnTo>
                  <a:pt x="2255647" y="1062228"/>
                </a:lnTo>
                <a:lnTo>
                  <a:pt x="2262505" y="1062228"/>
                </a:lnTo>
                <a:lnTo>
                  <a:pt x="2276094" y="1062228"/>
                </a:lnTo>
                <a:lnTo>
                  <a:pt x="2296668" y="1062228"/>
                </a:lnTo>
                <a:lnTo>
                  <a:pt x="2296668" y="1078230"/>
                </a:lnTo>
                <a:lnTo>
                  <a:pt x="2327402" y="1078230"/>
                </a:lnTo>
                <a:lnTo>
                  <a:pt x="2330831" y="1078230"/>
                </a:lnTo>
                <a:lnTo>
                  <a:pt x="2358136" y="1078230"/>
                </a:lnTo>
                <a:lnTo>
                  <a:pt x="2361565" y="1078230"/>
                </a:lnTo>
                <a:lnTo>
                  <a:pt x="2364994" y="1078230"/>
                </a:lnTo>
                <a:lnTo>
                  <a:pt x="2364994" y="1094613"/>
                </a:lnTo>
                <a:lnTo>
                  <a:pt x="2382139" y="1094613"/>
                </a:lnTo>
                <a:lnTo>
                  <a:pt x="2385441" y="1094613"/>
                </a:lnTo>
                <a:lnTo>
                  <a:pt x="2388870" y="1094613"/>
                </a:lnTo>
                <a:lnTo>
                  <a:pt x="2399157" y="1094613"/>
                </a:lnTo>
                <a:lnTo>
                  <a:pt x="2426462" y="1094613"/>
                </a:lnTo>
                <a:lnTo>
                  <a:pt x="2440178" y="1094613"/>
                </a:lnTo>
                <a:lnTo>
                  <a:pt x="2440178" y="1111123"/>
                </a:lnTo>
                <a:lnTo>
                  <a:pt x="2447036" y="1111123"/>
                </a:lnTo>
                <a:lnTo>
                  <a:pt x="2464054" y="1111123"/>
                </a:lnTo>
                <a:lnTo>
                  <a:pt x="2467483" y="1111123"/>
                </a:lnTo>
                <a:lnTo>
                  <a:pt x="2467483" y="1128014"/>
                </a:lnTo>
                <a:lnTo>
                  <a:pt x="2470912" y="1128014"/>
                </a:lnTo>
                <a:lnTo>
                  <a:pt x="2474341" y="1128014"/>
                </a:lnTo>
                <a:lnTo>
                  <a:pt x="2491486" y="1128014"/>
                </a:lnTo>
                <a:lnTo>
                  <a:pt x="2522220" y="1128014"/>
                </a:lnTo>
                <a:lnTo>
                  <a:pt x="2525649" y="1128014"/>
                </a:lnTo>
                <a:lnTo>
                  <a:pt x="2529078" y="1128014"/>
                </a:lnTo>
                <a:lnTo>
                  <a:pt x="2535809" y="1128014"/>
                </a:lnTo>
                <a:lnTo>
                  <a:pt x="2542667" y="1128014"/>
                </a:lnTo>
                <a:lnTo>
                  <a:pt x="2552954" y="1128014"/>
                </a:lnTo>
                <a:lnTo>
                  <a:pt x="2556383" y="1128014"/>
                </a:lnTo>
                <a:lnTo>
                  <a:pt x="2559812" y="1128014"/>
                </a:lnTo>
                <a:lnTo>
                  <a:pt x="2570099" y="1128014"/>
                </a:lnTo>
                <a:lnTo>
                  <a:pt x="2570099" y="1145667"/>
                </a:lnTo>
                <a:lnTo>
                  <a:pt x="2580259" y="1145667"/>
                </a:lnTo>
                <a:lnTo>
                  <a:pt x="2631567" y="1145667"/>
                </a:lnTo>
                <a:lnTo>
                  <a:pt x="2648712" y="1145667"/>
                </a:lnTo>
                <a:lnTo>
                  <a:pt x="2652014" y="1145667"/>
                </a:lnTo>
                <a:lnTo>
                  <a:pt x="2662301" y="1145667"/>
                </a:lnTo>
                <a:lnTo>
                  <a:pt x="2662301" y="1163701"/>
                </a:lnTo>
                <a:lnTo>
                  <a:pt x="2672588" y="1163701"/>
                </a:lnTo>
                <a:lnTo>
                  <a:pt x="2696464" y="1163701"/>
                </a:lnTo>
                <a:lnTo>
                  <a:pt x="2703322" y="1163701"/>
                </a:lnTo>
                <a:lnTo>
                  <a:pt x="2720467" y="1163701"/>
                </a:lnTo>
                <a:lnTo>
                  <a:pt x="2723896" y="1163701"/>
                </a:lnTo>
                <a:lnTo>
                  <a:pt x="2734056" y="1163701"/>
                </a:lnTo>
                <a:lnTo>
                  <a:pt x="2768219" y="1163701"/>
                </a:lnTo>
                <a:lnTo>
                  <a:pt x="2768219" y="1182116"/>
                </a:lnTo>
                <a:lnTo>
                  <a:pt x="2802509" y="1182116"/>
                </a:lnTo>
                <a:lnTo>
                  <a:pt x="2802509" y="1200404"/>
                </a:lnTo>
                <a:lnTo>
                  <a:pt x="2911856" y="1200404"/>
                </a:lnTo>
                <a:lnTo>
                  <a:pt x="2911856" y="1218819"/>
                </a:lnTo>
                <a:lnTo>
                  <a:pt x="2956179" y="1218819"/>
                </a:lnTo>
                <a:lnTo>
                  <a:pt x="2963037" y="1218819"/>
                </a:lnTo>
                <a:lnTo>
                  <a:pt x="2966466" y="1218819"/>
                </a:lnTo>
                <a:lnTo>
                  <a:pt x="2966466" y="1237361"/>
                </a:lnTo>
                <a:lnTo>
                  <a:pt x="2969895" y="1237361"/>
                </a:lnTo>
                <a:lnTo>
                  <a:pt x="2980182" y="1237361"/>
                </a:lnTo>
                <a:lnTo>
                  <a:pt x="2990469" y="1237361"/>
                </a:lnTo>
                <a:lnTo>
                  <a:pt x="3007487" y="1237361"/>
                </a:lnTo>
                <a:lnTo>
                  <a:pt x="3010916" y="1237361"/>
                </a:lnTo>
                <a:lnTo>
                  <a:pt x="3014345" y="1237361"/>
                </a:lnTo>
                <a:lnTo>
                  <a:pt x="3014345" y="1256284"/>
                </a:lnTo>
                <a:lnTo>
                  <a:pt x="3024632" y="1256284"/>
                </a:lnTo>
                <a:lnTo>
                  <a:pt x="3034792" y="1256284"/>
                </a:lnTo>
                <a:lnTo>
                  <a:pt x="3038221" y="1256284"/>
                </a:lnTo>
                <a:lnTo>
                  <a:pt x="3045079" y="1256284"/>
                </a:lnTo>
                <a:lnTo>
                  <a:pt x="3062224" y="1256284"/>
                </a:lnTo>
                <a:lnTo>
                  <a:pt x="3065653" y="1256284"/>
                </a:lnTo>
                <a:lnTo>
                  <a:pt x="3082671" y="1256284"/>
                </a:lnTo>
                <a:lnTo>
                  <a:pt x="3089529" y="1256284"/>
                </a:lnTo>
                <a:lnTo>
                  <a:pt x="3096387" y="1256284"/>
                </a:lnTo>
                <a:lnTo>
                  <a:pt x="3113405" y="1256284"/>
                </a:lnTo>
                <a:lnTo>
                  <a:pt x="3120263" y="1256284"/>
                </a:lnTo>
                <a:lnTo>
                  <a:pt x="3140837" y="1256284"/>
                </a:lnTo>
                <a:lnTo>
                  <a:pt x="3284347" y="1256284"/>
                </a:lnTo>
                <a:lnTo>
                  <a:pt x="3284347" y="1275969"/>
                </a:lnTo>
                <a:lnTo>
                  <a:pt x="3301365" y="1275969"/>
                </a:lnTo>
                <a:lnTo>
                  <a:pt x="3301365" y="1295781"/>
                </a:lnTo>
                <a:lnTo>
                  <a:pt x="3386836" y="1295781"/>
                </a:lnTo>
                <a:lnTo>
                  <a:pt x="3386836" y="1315593"/>
                </a:lnTo>
                <a:lnTo>
                  <a:pt x="3400552" y="1315593"/>
                </a:lnTo>
                <a:lnTo>
                  <a:pt x="3400552" y="1335405"/>
                </a:lnTo>
                <a:lnTo>
                  <a:pt x="3410839" y="1335405"/>
                </a:lnTo>
                <a:lnTo>
                  <a:pt x="3410839" y="1374902"/>
                </a:lnTo>
                <a:lnTo>
                  <a:pt x="3496183" y="1374902"/>
                </a:lnTo>
                <a:lnTo>
                  <a:pt x="3503041" y="1374902"/>
                </a:lnTo>
                <a:lnTo>
                  <a:pt x="3509899" y="1374902"/>
                </a:lnTo>
                <a:lnTo>
                  <a:pt x="3509899" y="1394968"/>
                </a:lnTo>
                <a:lnTo>
                  <a:pt x="3513328" y="1394968"/>
                </a:lnTo>
                <a:lnTo>
                  <a:pt x="3520186" y="1394968"/>
                </a:lnTo>
                <a:lnTo>
                  <a:pt x="3527044" y="1394968"/>
                </a:lnTo>
                <a:lnTo>
                  <a:pt x="3530346" y="1394968"/>
                </a:lnTo>
                <a:lnTo>
                  <a:pt x="3550920" y="1394968"/>
                </a:lnTo>
                <a:lnTo>
                  <a:pt x="3554349" y="1394968"/>
                </a:lnTo>
                <a:lnTo>
                  <a:pt x="3564636" y="1394968"/>
                </a:lnTo>
                <a:lnTo>
                  <a:pt x="3574796" y="1394968"/>
                </a:lnTo>
                <a:lnTo>
                  <a:pt x="3578225" y="1394968"/>
                </a:lnTo>
                <a:lnTo>
                  <a:pt x="3585083" y="1394968"/>
                </a:lnTo>
                <a:lnTo>
                  <a:pt x="3595370" y="1394968"/>
                </a:lnTo>
                <a:lnTo>
                  <a:pt x="3602228" y="1394968"/>
                </a:lnTo>
                <a:lnTo>
                  <a:pt x="3605529" y="1394968"/>
                </a:lnTo>
                <a:lnTo>
                  <a:pt x="3605529" y="1416431"/>
                </a:lnTo>
                <a:lnTo>
                  <a:pt x="3619246" y="1416431"/>
                </a:lnTo>
                <a:lnTo>
                  <a:pt x="3636391" y="1416431"/>
                </a:lnTo>
                <a:lnTo>
                  <a:pt x="3643122" y="1416431"/>
                </a:lnTo>
                <a:lnTo>
                  <a:pt x="3649979" y="1416431"/>
                </a:lnTo>
                <a:lnTo>
                  <a:pt x="3656838" y="1416431"/>
                </a:lnTo>
                <a:lnTo>
                  <a:pt x="3667125" y="1416431"/>
                </a:lnTo>
                <a:lnTo>
                  <a:pt x="3670554" y="1416431"/>
                </a:lnTo>
                <a:lnTo>
                  <a:pt x="3673983" y="1416431"/>
                </a:lnTo>
                <a:lnTo>
                  <a:pt x="3680841" y="1416431"/>
                </a:lnTo>
                <a:lnTo>
                  <a:pt x="3684142" y="1416431"/>
                </a:lnTo>
                <a:lnTo>
                  <a:pt x="3687572" y="1416431"/>
                </a:lnTo>
                <a:lnTo>
                  <a:pt x="3691001" y="1416431"/>
                </a:lnTo>
                <a:lnTo>
                  <a:pt x="3697859" y="1416431"/>
                </a:lnTo>
                <a:lnTo>
                  <a:pt x="3701288" y="1416431"/>
                </a:lnTo>
                <a:lnTo>
                  <a:pt x="3704716" y="1416431"/>
                </a:lnTo>
                <a:lnTo>
                  <a:pt x="3704716" y="1439926"/>
                </a:lnTo>
                <a:lnTo>
                  <a:pt x="3708146" y="1439926"/>
                </a:lnTo>
                <a:lnTo>
                  <a:pt x="3715004" y="1439926"/>
                </a:lnTo>
                <a:lnTo>
                  <a:pt x="3721735" y="1439926"/>
                </a:lnTo>
                <a:lnTo>
                  <a:pt x="3725164" y="1439926"/>
                </a:lnTo>
                <a:lnTo>
                  <a:pt x="3728592" y="1439926"/>
                </a:lnTo>
                <a:lnTo>
                  <a:pt x="3732022" y="1439926"/>
                </a:lnTo>
                <a:lnTo>
                  <a:pt x="3735451" y="1439926"/>
                </a:lnTo>
                <a:lnTo>
                  <a:pt x="3742309" y="1439926"/>
                </a:lnTo>
                <a:lnTo>
                  <a:pt x="3749166" y="1439926"/>
                </a:lnTo>
                <a:lnTo>
                  <a:pt x="3759327" y="1439926"/>
                </a:lnTo>
                <a:lnTo>
                  <a:pt x="3759327" y="1464818"/>
                </a:lnTo>
                <a:lnTo>
                  <a:pt x="3766185" y="1464818"/>
                </a:lnTo>
                <a:lnTo>
                  <a:pt x="3769614" y="1464818"/>
                </a:lnTo>
                <a:lnTo>
                  <a:pt x="3779901" y="1464818"/>
                </a:lnTo>
                <a:lnTo>
                  <a:pt x="3786759" y="1464818"/>
                </a:lnTo>
                <a:lnTo>
                  <a:pt x="3793616" y="1464818"/>
                </a:lnTo>
                <a:lnTo>
                  <a:pt x="3807205" y="1464818"/>
                </a:lnTo>
                <a:lnTo>
                  <a:pt x="3810635" y="1464818"/>
                </a:lnTo>
                <a:lnTo>
                  <a:pt x="3841369" y="1464818"/>
                </a:lnTo>
                <a:lnTo>
                  <a:pt x="3841369" y="1491742"/>
                </a:lnTo>
                <a:lnTo>
                  <a:pt x="3844798" y="1491742"/>
                </a:lnTo>
                <a:lnTo>
                  <a:pt x="3858514" y="1491742"/>
                </a:lnTo>
                <a:lnTo>
                  <a:pt x="3875532" y="1491742"/>
                </a:lnTo>
                <a:lnTo>
                  <a:pt x="3885819" y="1491742"/>
                </a:lnTo>
                <a:lnTo>
                  <a:pt x="3899535" y="1491742"/>
                </a:lnTo>
                <a:lnTo>
                  <a:pt x="3906392" y="1491742"/>
                </a:lnTo>
                <a:lnTo>
                  <a:pt x="3916553" y="1491742"/>
                </a:lnTo>
                <a:lnTo>
                  <a:pt x="3930269" y="1491742"/>
                </a:lnTo>
                <a:lnTo>
                  <a:pt x="3940555" y="1491742"/>
                </a:lnTo>
                <a:lnTo>
                  <a:pt x="3943985" y="1491742"/>
                </a:lnTo>
                <a:lnTo>
                  <a:pt x="3943985" y="1520825"/>
                </a:lnTo>
                <a:lnTo>
                  <a:pt x="3957574" y="1520825"/>
                </a:lnTo>
                <a:lnTo>
                  <a:pt x="3957574" y="1549908"/>
                </a:lnTo>
                <a:lnTo>
                  <a:pt x="3964432" y="1549908"/>
                </a:lnTo>
                <a:lnTo>
                  <a:pt x="3964432" y="1579245"/>
                </a:lnTo>
                <a:lnTo>
                  <a:pt x="3967861" y="1579245"/>
                </a:lnTo>
                <a:lnTo>
                  <a:pt x="3971290" y="1579245"/>
                </a:lnTo>
                <a:lnTo>
                  <a:pt x="3971290" y="1608836"/>
                </a:lnTo>
                <a:lnTo>
                  <a:pt x="3978148" y="1608836"/>
                </a:lnTo>
                <a:lnTo>
                  <a:pt x="3995166" y="1608836"/>
                </a:lnTo>
                <a:lnTo>
                  <a:pt x="4005453" y="1608836"/>
                </a:lnTo>
                <a:lnTo>
                  <a:pt x="4012311" y="1608836"/>
                </a:lnTo>
                <a:lnTo>
                  <a:pt x="4022598" y="1608836"/>
                </a:lnTo>
                <a:lnTo>
                  <a:pt x="4066921" y="1608836"/>
                </a:lnTo>
                <a:lnTo>
                  <a:pt x="4066921" y="1639316"/>
                </a:lnTo>
                <a:lnTo>
                  <a:pt x="4070350" y="1639316"/>
                </a:lnTo>
                <a:lnTo>
                  <a:pt x="4097782" y="1639316"/>
                </a:lnTo>
                <a:lnTo>
                  <a:pt x="4101084" y="1639316"/>
                </a:lnTo>
                <a:lnTo>
                  <a:pt x="4104513" y="1639316"/>
                </a:lnTo>
                <a:lnTo>
                  <a:pt x="4121658" y="1639316"/>
                </a:lnTo>
                <a:lnTo>
                  <a:pt x="4138803" y="1639316"/>
                </a:lnTo>
                <a:lnTo>
                  <a:pt x="4145534" y="1639316"/>
                </a:lnTo>
                <a:lnTo>
                  <a:pt x="4155821" y="1639316"/>
                </a:lnTo>
                <a:lnTo>
                  <a:pt x="4159250" y="1639316"/>
                </a:lnTo>
                <a:lnTo>
                  <a:pt x="4162679" y="1639316"/>
                </a:lnTo>
                <a:lnTo>
                  <a:pt x="4166108" y="1639316"/>
                </a:lnTo>
                <a:lnTo>
                  <a:pt x="4169537" y="1639316"/>
                </a:lnTo>
                <a:lnTo>
                  <a:pt x="4169537" y="1672589"/>
                </a:lnTo>
                <a:lnTo>
                  <a:pt x="4176395" y="1672589"/>
                </a:lnTo>
                <a:lnTo>
                  <a:pt x="4186554" y="1672589"/>
                </a:lnTo>
                <a:lnTo>
                  <a:pt x="4189984" y="1672589"/>
                </a:lnTo>
                <a:lnTo>
                  <a:pt x="4196842" y="1672589"/>
                </a:lnTo>
                <a:lnTo>
                  <a:pt x="4213987" y="1672589"/>
                </a:lnTo>
                <a:lnTo>
                  <a:pt x="4217289" y="1672589"/>
                </a:lnTo>
                <a:lnTo>
                  <a:pt x="4220718" y="1672589"/>
                </a:lnTo>
                <a:lnTo>
                  <a:pt x="4227576" y="1672589"/>
                </a:lnTo>
                <a:lnTo>
                  <a:pt x="4227576" y="1709166"/>
                </a:lnTo>
                <a:lnTo>
                  <a:pt x="4234434" y="1709166"/>
                </a:lnTo>
                <a:lnTo>
                  <a:pt x="4241292" y="1709166"/>
                </a:lnTo>
                <a:lnTo>
                  <a:pt x="4251579" y="1709166"/>
                </a:lnTo>
                <a:lnTo>
                  <a:pt x="4261739" y="1709166"/>
                </a:lnTo>
                <a:lnTo>
                  <a:pt x="4265168" y="1709166"/>
                </a:lnTo>
                <a:lnTo>
                  <a:pt x="4268597" y="1709166"/>
                </a:lnTo>
                <a:lnTo>
                  <a:pt x="4285742" y="1709166"/>
                </a:lnTo>
                <a:lnTo>
                  <a:pt x="4289171" y="1709166"/>
                </a:lnTo>
                <a:lnTo>
                  <a:pt x="4302760" y="1709166"/>
                </a:lnTo>
                <a:lnTo>
                  <a:pt x="4309618" y="1709166"/>
                </a:lnTo>
                <a:lnTo>
                  <a:pt x="4319905" y="1709166"/>
                </a:lnTo>
                <a:lnTo>
                  <a:pt x="4333494" y="1709166"/>
                </a:lnTo>
                <a:lnTo>
                  <a:pt x="4343781" y="1709166"/>
                </a:lnTo>
                <a:lnTo>
                  <a:pt x="4347210" y="1709166"/>
                </a:lnTo>
                <a:lnTo>
                  <a:pt x="4354068" y="1709166"/>
                </a:lnTo>
                <a:lnTo>
                  <a:pt x="4357497" y="1709166"/>
                </a:lnTo>
                <a:lnTo>
                  <a:pt x="4377944" y="1709166"/>
                </a:lnTo>
                <a:lnTo>
                  <a:pt x="4398518" y="1709166"/>
                </a:lnTo>
                <a:lnTo>
                  <a:pt x="4418965" y="1709166"/>
                </a:lnTo>
                <a:lnTo>
                  <a:pt x="4425823" y="1709166"/>
                </a:lnTo>
                <a:lnTo>
                  <a:pt x="4432681" y="1709166"/>
                </a:lnTo>
                <a:lnTo>
                  <a:pt x="4439539" y="1709166"/>
                </a:lnTo>
                <a:lnTo>
                  <a:pt x="4442968" y="1709166"/>
                </a:lnTo>
                <a:lnTo>
                  <a:pt x="4459986" y="1709166"/>
                </a:lnTo>
                <a:lnTo>
                  <a:pt x="4466844" y="1709166"/>
                </a:lnTo>
                <a:lnTo>
                  <a:pt x="4497578" y="1709166"/>
                </a:lnTo>
                <a:lnTo>
                  <a:pt x="4524883" y="1709166"/>
                </a:lnTo>
                <a:lnTo>
                  <a:pt x="4528312" y="1709166"/>
                </a:lnTo>
                <a:lnTo>
                  <a:pt x="4538599" y="1709166"/>
                </a:lnTo>
                <a:lnTo>
                  <a:pt x="4552315" y="1709166"/>
                </a:lnTo>
                <a:lnTo>
                  <a:pt x="4562475" y="1709166"/>
                </a:lnTo>
                <a:lnTo>
                  <a:pt x="4600067" y="1709166"/>
                </a:lnTo>
                <a:lnTo>
                  <a:pt x="4617212" y="1709166"/>
                </a:lnTo>
                <a:lnTo>
                  <a:pt x="4620641" y="1709166"/>
                </a:lnTo>
                <a:lnTo>
                  <a:pt x="4637659" y="1709166"/>
                </a:lnTo>
                <a:lnTo>
                  <a:pt x="4644517" y="1709166"/>
                </a:lnTo>
                <a:lnTo>
                  <a:pt x="4654804" y="1709166"/>
                </a:lnTo>
                <a:lnTo>
                  <a:pt x="4658233" y="1709166"/>
                </a:lnTo>
                <a:lnTo>
                  <a:pt x="4668520" y="1709166"/>
                </a:lnTo>
                <a:lnTo>
                  <a:pt x="4671949" y="1709166"/>
                </a:lnTo>
                <a:lnTo>
                  <a:pt x="4675251" y="1709166"/>
                </a:lnTo>
                <a:lnTo>
                  <a:pt x="4678680" y="1709166"/>
                </a:lnTo>
                <a:lnTo>
                  <a:pt x="4692396" y="1709166"/>
                </a:lnTo>
                <a:lnTo>
                  <a:pt x="4702683" y="1709166"/>
                </a:lnTo>
                <a:lnTo>
                  <a:pt x="4709541" y="1709166"/>
                </a:lnTo>
                <a:lnTo>
                  <a:pt x="4719701" y="1709166"/>
                </a:lnTo>
                <a:lnTo>
                  <a:pt x="4743704" y="1709166"/>
                </a:lnTo>
                <a:lnTo>
                  <a:pt x="4750435" y="1709166"/>
                </a:lnTo>
                <a:lnTo>
                  <a:pt x="4753864" y="1709166"/>
                </a:lnTo>
                <a:lnTo>
                  <a:pt x="4757293" y="1709166"/>
                </a:lnTo>
                <a:lnTo>
                  <a:pt x="4767580" y="1709166"/>
                </a:lnTo>
                <a:lnTo>
                  <a:pt x="4791456" y="1709166"/>
                </a:lnTo>
                <a:lnTo>
                  <a:pt x="4794885" y="1709166"/>
                </a:lnTo>
                <a:lnTo>
                  <a:pt x="4812030" y="1709166"/>
                </a:lnTo>
                <a:lnTo>
                  <a:pt x="4818888" y="1709166"/>
                </a:lnTo>
                <a:lnTo>
                  <a:pt x="4832477" y="1709166"/>
                </a:lnTo>
                <a:lnTo>
                  <a:pt x="4904232" y="1709166"/>
                </a:lnTo>
                <a:lnTo>
                  <a:pt x="4907661" y="1709166"/>
                </a:lnTo>
                <a:lnTo>
                  <a:pt x="4935093" y="1709166"/>
                </a:lnTo>
                <a:lnTo>
                  <a:pt x="4965827" y="1709166"/>
                </a:lnTo>
                <a:lnTo>
                  <a:pt x="4996561" y="1709166"/>
                </a:lnTo>
                <a:lnTo>
                  <a:pt x="5239258" y="1709166"/>
                </a:lnTo>
                <a:lnTo>
                  <a:pt x="5280279" y="1709166"/>
                </a:lnTo>
                <a:lnTo>
                  <a:pt x="5304155" y="1709166"/>
                </a:lnTo>
                <a:lnTo>
                  <a:pt x="5324602" y="1709166"/>
                </a:lnTo>
                <a:lnTo>
                  <a:pt x="5334889" y="1709166"/>
                </a:lnTo>
                <a:lnTo>
                  <a:pt x="5334889" y="1801622"/>
                </a:lnTo>
                <a:lnTo>
                  <a:pt x="5355463" y="1801622"/>
                </a:lnTo>
                <a:lnTo>
                  <a:pt x="5358892" y="1801622"/>
                </a:lnTo>
                <a:lnTo>
                  <a:pt x="5382768" y="1801622"/>
                </a:lnTo>
                <a:lnTo>
                  <a:pt x="5403215" y="1801622"/>
                </a:lnTo>
                <a:lnTo>
                  <a:pt x="5406644" y="1801622"/>
                </a:lnTo>
                <a:lnTo>
                  <a:pt x="5427218" y="1801622"/>
                </a:lnTo>
                <a:lnTo>
                  <a:pt x="5444236" y="1801622"/>
                </a:lnTo>
                <a:lnTo>
                  <a:pt x="5454523" y="1801622"/>
                </a:lnTo>
                <a:lnTo>
                  <a:pt x="5468239" y="1801622"/>
                </a:lnTo>
                <a:lnTo>
                  <a:pt x="5505831" y="1801622"/>
                </a:lnTo>
                <a:lnTo>
                  <a:pt x="5515991" y="1801622"/>
                </a:lnTo>
                <a:lnTo>
                  <a:pt x="5519420" y="1801622"/>
                </a:lnTo>
                <a:lnTo>
                  <a:pt x="5526278" y="1801622"/>
                </a:lnTo>
                <a:lnTo>
                  <a:pt x="5536565" y="1801622"/>
                </a:lnTo>
                <a:lnTo>
                  <a:pt x="5543423" y="1801622"/>
                </a:lnTo>
                <a:lnTo>
                  <a:pt x="5553583" y="1801622"/>
                </a:lnTo>
                <a:lnTo>
                  <a:pt x="5557012" y="1801622"/>
                </a:lnTo>
                <a:lnTo>
                  <a:pt x="5587873" y="1801622"/>
                </a:lnTo>
                <a:lnTo>
                  <a:pt x="5598033" y="1801622"/>
                </a:lnTo>
                <a:lnTo>
                  <a:pt x="5604891" y="1801622"/>
                </a:lnTo>
                <a:lnTo>
                  <a:pt x="5608320" y="1801622"/>
                </a:lnTo>
                <a:lnTo>
                  <a:pt x="5611749" y="1801622"/>
                </a:lnTo>
                <a:lnTo>
                  <a:pt x="5622036" y="1801622"/>
                </a:lnTo>
                <a:lnTo>
                  <a:pt x="5642483" y="1801622"/>
                </a:lnTo>
                <a:lnTo>
                  <a:pt x="5645912" y="1801622"/>
                </a:lnTo>
                <a:lnTo>
                  <a:pt x="5683504" y="1801622"/>
                </a:lnTo>
                <a:lnTo>
                  <a:pt x="5693791" y="1801622"/>
                </a:lnTo>
                <a:lnTo>
                  <a:pt x="5704078" y="1801622"/>
                </a:lnTo>
                <a:lnTo>
                  <a:pt x="5707380" y="1801622"/>
                </a:lnTo>
                <a:lnTo>
                  <a:pt x="5741670" y="1801622"/>
                </a:lnTo>
                <a:lnTo>
                  <a:pt x="5748401" y="1801622"/>
                </a:lnTo>
                <a:lnTo>
                  <a:pt x="5785993" y="1801622"/>
                </a:lnTo>
                <a:lnTo>
                  <a:pt x="5837301" y="1801622"/>
                </a:lnTo>
                <a:lnTo>
                  <a:pt x="5844159" y="1801622"/>
                </a:lnTo>
                <a:lnTo>
                  <a:pt x="5888609" y="1801622"/>
                </a:lnTo>
                <a:lnTo>
                  <a:pt x="5892038" y="1801622"/>
                </a:lnTo>
                <a:lnTo>
                  <a:pt x="5946648" y="1801622"/>
                </a:lnTo>
                <a:lnTo>
                  <a:pt x="5950077" y="1801622"/>
                </a:lnTo>
                <a:lnTo>
                  <a:pt x="5953506" y="1801622"/>
                </a:lnTo>
                <a:lnTo>
                  <a:pt x="5960364" y="1801622"/>
                </a:lnTo>
                <a:lnTo>
                  <a:pt x="5973953" y="1801622"/>
                </a:lnTo>
                <a:lnTo>
                  <a:pt x="5977382" y="1801622"/>
                </a:lnTo>
                <a:lnTo>
                  <a:pt x="5994527" y="1801622"/>
                </a:lnTo>
                <a:lnTo>
                  <a:pt x="6004814" y="1801622"/>
                </a:lnTo>
                <a:lnTo>
                  <a:pt x="6144895" y="1801622"/>
                </a:lnTo>
                <a:lnTo>
                  <a:pt x="6582409" y="1801622"/>
                </a:lnTo>
              </a:path>
            </a:pathLst>
          </a:custGeom>
          <a:ln w="20320">
            <a:solidFill>
              <a:srgbClr val="377EB8"/>
            </a:solidFill>
          </a:ln>
        </p:spPr>
        <p:txBody>
          <a:bodyPr wrap="square" lIns="0" tIns="0" rIns="0" bIns="0" rtlCol="0"/>
          <a:lstStyle/>
          <a:p>
            <a:endParaRPr sz="1125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6EFB1567-5BD7-4C4D-90ED-FF4EE7AA07F4}"/>
              </a:ext>
            </a:extLst>
          </p:cNvPr>
          <p:cNvSpPr txBox="1"/>
          <p:nvPr/>
        </p:nvSpPr>
        <p:spPr>
          <a:xfrm>
            <a:off x="0" y="66858"/>
            <a:ext cx="60773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>
                <a:latin typeface="Arial" panose="020B0604020202020204" pitchFamily="34" charset="0"/>
                <a:cs typeface="Arial" panose="020B0604020202020204" pitchFamily="34" charset="0"/>
              </a:rPr>
              <a:t>Additional file 4: Figure S2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Kaplan-Meier curves for primary endpoint according to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Hcy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 level.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7236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73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Xiuhuan</dc:creator>
  <cp:lastModifiedBy>Poornima Thiruvudaiselvi</cp:lastModifiedBy>
  <cp:revision>2</cp:revision>
  <dcterms:created xsi:type="dcterms:W3CDTF">2023-07-25T07:14:53Z</dcterms:created>
  <dcterms:modified xsi:type="dcterms:W3CDTF">2023-12-09T16:50:47Z</dcterms:modified>
</cp:coreProperties>
</file>